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79" r:id="rId2"/>
    <p:sldId id="280" r:id="rId3"/>
    <p:sldId id="276" r:id="rId4"/>
    <p:sldId id="278" r:id="rId5"/>
  </p:sldIdLst>
  <p:sldSz cx="6858000" cy="9144000" type="screen4x3"/>
  <p:notesSz cx="9388475" cy="7102475"/>
  <p:defaultTextStyle>
    <a:defPPr>
      <a:defRPr lang="en-US"/>
    </a:defPPr>
    <a:lvl1pPr marL="0" algn="l" defTabSz="91418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092" algn="l" defTabSz="91418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186" algn="l" defTabSz="91418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279" algn="l" defTabSz="91418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373" algn="l" defTabSz="91418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466" algn="l" defTabSz="91418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558" algn="l" defTabSz="91418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652" algn="l" defTabSz="91418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744" algn="l" defTabSz="914186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210" autoAdjust="0"/>
    <p:restoredTop sz="96763" autoAdjust="0"/>
  </p:normalViewPr>
  <p:slideViewPr>
    <p:cSldViewPr snapToGrid="0">
      <p:cViewPr>
        <p:scale>
          <a:sx n="125" d="100"/>
          <a:sy n="125" d="100"/>
        </p:scale>
        <p:origin x="2274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ccommisk\Box\HTS%20RESPYR%20Analyses\mito%20respiration%20data\pde5%20inhibitor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ownloads\071917%20HTS%20Hit%20Analysis%20RESPYR%20Dicumerol%20DRC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ownloads\072817%20HTS%20Hit%20Analysis%20RESPYR%20Telmisartan%20DRC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AppData\Local\Box\Box%20Edit\Documents\TQGeIcqtL0Wb7b+n4JZZuw==\071917%20HTS%20Hit%20Analysis%20RESPYR%20Dantrolene%20Sodium%20Salt%20DRC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187595652831185"/>
          <c:y val="4.9990369828673234E-2"/>
          <c:w val="0.7204091689433878"/>
          <c:h val="0.72555967847265479"/>
        </c:manualLayout>
      </c:layout>
      <c:scatterChart>
        <c:scatterStyle val="lineMarker"/>
        <c:varyColors val="0"/>
        <c:ser>
          <c:idx val="0"/>
          <c:order val="0"/>
          <c:tx>
            <c:strRef>
              <c:f>' Calculations'!$BQ$3</c:f>
              <c:strCache>
                <c:ptCount val="1"/>
                <c:pt idx="0">
                  <c:v>Vehicle (DMSO)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squar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Q$29:$BQ$50</c:f>
                <c:numCache>
                  <c:formatCode>General</c:formatCode>
                  <c:ptCount val="22"/>
                  <c:pt idx="0">
                    <c:v>1.35802309300927</c:v>
                  </c:pt>
                  <c:pt idx="1">
                    <c:v>0.60921112916311293</c:v>
                  </c:pt>
                  <c:pt idx="2">
                    <c:v>2.1080494256287112</c:v>
                  </c:pt>
                  <c:pt idx="3">
                    <c:v>2.131318175327253</c:v>
                  </c:pt>
                  <c:pt idx="4">
                    <c:v>1.1490122484651819</c:v>
                  </c:pt>
                  <c:pt idx="5">
                    <c:v>1.7486917157829862</c:v>
                  </c:pt>
                  <c:pt idx="6">
                    <c:v>1.0988916880073922</c:v>
                  </c:pt>
                  <c:pt idx="7">
                    <c:v>1.9112073467307786</c:v>
                  </c:pt>
                  <c:pt idx="8">
                    <c:v>1.2250039373237103</c:v>
                  </c:pt>
                  <c:pt idx="9">
                    <c:v>1.1157502442094711</c:v>
                  </c:pt>
                  <c:pt idx="10">
                    <c:v>1.558130335340042</c:v>
                  </c:pt>
                  <c:pt idx="11">
                    <c:v>1.0575269684992772</c:v>
                  </c:pt>
                  <c:pt idx="12">
                    <c:v>2.4197857926415423</c:v>
                  </c:pt>
                  <c:pt idx="13">
                    <c:v>2.4205787569544484</c:v>
                  </c:pt>
                  <c:pt idx="14">
                    <c:v>1.115051723263538</c:v>
                  </c:pt>
                  <c:pt idx="15">
                    <c:v>2.1863295579882784</c:v>
                  </c:pt>
                  <c:pt idx="16">
                    <c:v>0.9417220024801205</c:v>
                  </c:pt>
                  <c:pt idx="17">
                    <c:v>1.0869204160223833</c:v>
                  </c:pt>
                  <c:pt idx="18">
                    <c:v>2.6781741516075726</c:v>
                  </c:pt>
                  <c:pt idx="19">
                    <c:v>0.45016810571953947</c:v>
                  </c:pt>
                  <c:pt idx="20">
                    <c:v>1.3408619016807974</c:v>
                  </c:pt>
                  <c:pt idx="21">
                    <c:v>2.1509917684604805</c:v>
                  </c:pt>
                </c:numCache>
              </c:numRef>
            </c:plus>
            <c:minus>
              <c:numRef>
                <c:f>' Calculations'!$BQ$29:$BQ$50</c:f>
                <c:numCache>
                  <c:formatCode>General</c:formatCode>
                  <c:ptCount val="22"/>
                  <c:pt idx="0">
                    <c:v>1.35802309300927</c:v>
                  </c:pt>
                  <c:pt idx="1">
                    <c:v>0.60921112916311293</c:v>
                  </c:pt>
                  <c:pt idx="2">
                    <c:v>2.1080494256287112</c:v>
                  </c:pt>
                  <c:pt idx="3">
                    <c:v>2.131318175327253</c:v>
                  </c:pt>
                  <c:pt idx="4">
                    <c:v>1.1490122484651819</c:v>
                  </c:pt>
                  <c:pt idx="5">
                    <c:v>1.7486917157829862</c:v>
                  </c:pt>
                  <c:pt idx="6">
                    <c:v>1.0988916880073922</c:v>
                  </c:pt>
                  <c:pt idx="7">
                    <c:v>1.9112073467307786</c:v>
                  </c:pt>
                  <c:pt idx="8">
                    <c:v>1.2250039373237103</c:v>
                  </c:pt>
                  <c:pt idx="9">
                    <c:v>1.1157502442094711</c:v>
                  </c:pt>
                  <c:pt idx="10">
                    <c:v>1.558130335340042</c:v>
                  </c:pt>
                  <c:pt idx="11">
                    <c:v>1.0575269684992772</c:v>
                  </c:pt>
                  <c:pt idx="12">
                    <c:v>2.4197857926415423</c:v>
                  </c:pt>
                  <c:pt idx="13">
                    <c:v>2.4205787569544484</c:v>
                  </c:pt>
                  <c:pt idx="14">
                    <c:v>1.115051723263538</c:v>
                  </c:pt>
                  <c:pt idx="15">
                    <c:v>2.1863295579882784</c:v>
                  </c:pt>
                  <c:pt idx="16">
                    <c:v>0.9417220024801205</c:v>
                  </c:pt>
                  <c:pt idx="17">
                    <c:v>1.0869204160223833</c:v>
                  </c:pt>
                  <c:pt idx="18">
                    <c:v>2.6781741516075726</c:v>
                  </c:pt>
                  <c:pt idx="19">
                    <c:v>0.45016810571953947</c:v>
                  </c:pt>
                  <c:pt idx="20">
                    <c:v>1.3408619016807974</c:v>
                  </c:pt>
                  <c:pt idx="21">
                    <c:v>2.1509917684604805</c:v>
                  </c:pt>
                </c:numCache>
              </c:numRef>
            </c:minus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Q$4:$BQ$25</c:f>
              <c:numCache>
                <c:formatCode>General</c:formatCode>
                <c:ptCount val="22"/>
                <c:pt idx="0">
                  <c:v>100.24725092535145</c:v>
                </c:pt>
                <c:pt idx="1">
                  <c:v>99.087204644616591</c:v>
                </c:pt>
                <c:pt idx="2">
                  <c:v>100</c:v>
                </c:pt>
                <c:pt idx="3">
                  <c:v>98.981218698579013</c:v>
                </c:pt>
                <c:pt idx="4">
                  <c:v>105.54225629702208</c:v>
                </c:pt>
                <c:pt idx="5">
                  <c:v>105.62754567595923</c:v>
                </c:pt>
                <c:pt idx="6">
                  <c:v>105.80306162974735</c:v>
                </c:pt>
                <c:pt idx="7">
                  <c:v>108.31696611339044</c:v>
                </c:pt>
                <c:pt idx="8">
                  <c:v>110.33859766627936</c:v>
                </c:pt>
                <c:pt idx="9">
                  <c:v>112.46437300349257</c:v>
                </c:pt>
                <c:pt idx="10">
                  <c:v>113.93968215248842</c:v>
                </c:pt>
                <c:pt idx="11">
                  <c:v>113.66640240687322</c:v>
                </c:pt>
                <c:pt idx="12">
                  <c:v>115.310437106135</c:v>
                </c:pt>
                <c:pt idx="13">
                  <c:v>113.27429027701544</c:v>
                </c:pt>
                <c:pt idx="14">
                  <c:v>117.56103268510911</c:v>
                </c:pt>
                <c:pt idx="15">
                  <c:v>113.04069376097272</c:v>
                </c:pt>
                <c:pt idx="16">
                  <c:v>115.82420315484327</c:v>
                </c:pt>
                <c:pt idx="17">
                  <c:v>116.19963173504308</c:v>
                </c:pt>
                <c:pt idx="18">
                  <c:v>116.77938482872267</c:v>
                </c:pt>
                <c:pt idx="19">
                  <c:v>115.34833018762578</c:v>
                </c:pt>
                <c:pt idx="20">
                  <c:v>115.7344480668699</c:v>
                </c:pt>
                <c:pt idx="21">
                  <c:v>112.190870468230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A43-464D-B885-E6D91F1B7FC7}"/>
            </c:ext>
          </c:extLst>
        </c:ser>
        <c:ser>
          <c:idx val="1"/>
          <c:order val="1"/>
          <c:tx>
            <c:strRef>
              <c:f>' Calculations'!$BR$3</c:f>
              <c:strCache>
                <c:ptCount val="1"/>
                <c:pt idx="0">
                  <c:v>5 uM UK5099</c:v>
                </c:pt>
              </c:strCache>
            </c:strRef>
          </c:tx>
          <c:spPr>
            <a:ln w="9525">
              <a:solidFill>
                <a:srgbClr val="00B0F0"/>
              </a:solidFill>
            </a:ln>
          </c:spPr>
          <c:marker>
            <c:symbol val="circle"/>
            <c:size val="4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R$29:$BR$50</c:f>
                <c:numCache>
                  <c:formatCode>General</c:formatCode>
                  <c:ptCount val="22"/>
                  <c:pt idx="0">
                    <c:v>0.77346990506448587</c:v>
                  </c:pt>
                  <c:pt idx="1">
                    <c:v>0.75973279182719367</c:v>
                  </c:pt>
                  <c:pt idx="2">
                    <c:v>0.82042035024876381</c:v>
                  </c:pt>
                  <c:pt idx="3">
                    <c:v>0.22460874434929551</c:v>
                  </c:pt>
                  <c:pt idx="4">
                    <c:v>0.93239245845836671</c:v>
                  </c:pt>
                  <c:pt idx="5">
                    <c:v>0.75679044746907198</c:v>
                  </c:pt>
                  <c:pt idx="6">
                    <c:v>1.4164614769313233</c:v>
                  </c:pt>
                  <c:pt idx="7">
                    <c:v>0.96929174922480954</c:v>
                  </c:pt>
                  <c:pt idx="8">
                    <c:v>1.224825593411192</c:v>
                  </c:pt>
                  <c:pt idx="9">
                    <c:v>0.99928965433274641</c:v>
                  </c:pt>
                  <c:pt idx="10">
                    <c:v>0.75623453273850016</c:v>
                  </c:pt>
                  <c:pt idx="11">
                    <c:v>0.73489016678814034</c:v>
                  </c:pt>
                  <c:pt idx="12">
                    <c:v>1.3881245192067548</c:v>
                  </c:pt>
                  <c:pt idx="13">
                    <c:v>1.6097970036344653</c:v>
                  </c:pt>
                  <c:pt idx="14">
                    <c:v>1.5108964765391526</c:v>
                  </c:pt>
                  <c:pt idx="15">
                    <c:v>0.70552490988298511</c:v>
                  </c:pt>
                  <c:pt idx="16">
                    <c:v>1.9743765298216802</c:v>
                  </c:pt>
                  <c:pt idx="17">
                    <c:v>1.1865398065361752</c:v>
                  </c:pt>
                  <c:pt idx="18">
                    <c:v>0.92026911730515482</c:v>
                  </c:pt>
                  <c:pt idx="19">
                    <c:v>1.4636376767784032</c:v>
                  </c:pt>
                  <c:pt idx="20">
                    <c:v>0.88603071307211256</c:v>
                  </c:pt>
                  <c:pt idx="21">
                    <c:v>1.6148635545962666</c:v>
                  </c:pt>
                </c:numCache>
              </c:numRef>
            </c:plus>
            <c:minus>
              <c:numRef>
                <c:f>' Calculations'!$BR$29:$BR$50</c:f>
                <c:numCache>
                  <c:formatCode>General</c:formatCode>
                  <c:ptCount val="22"/>
                  <c:pt idx="0">
                    <c:v>0.77346990506448587</c:v>
                  </c:pt>
                  <c:pt idx="1">
                    <c:v>0.75973279182719367</c:v>
                  </c:pt>
                  <c:pt idx="2">
                    <c:v>0.82042035024876381</c:v>
                  </c:pt>
                  <c:pt idx="3">
                    <c:v>0.22460874434929551</c:v>
                  </c:pt>
                  <c:pt idx="4">
                    <c:v>0.93239245845836671</c:v>
                  </c:pt>
                  <c:pt idx="5">
                    <c:v>0.75679044746907198</c:v>
                  </c:pt>
                  <c:pt idx="6">
                    <c:v>1.4164614769313233</c:v>
                  </c:pt>
                  <c:pt idx="7">
                    <c:v>0.96929174922480954</c:v>
                  </c:pt>
                  <c:pt idx="8">
                    <c:v>1.224825593411192</c:v>
                  </c:pt>
                  <c:pt idx="9">
                    <c:v>0.99928965433274641</c:v>
                  </c:pt>
                  <c:pt idx="10">
                    <c:v>0.75623453273850016</c:v>
                  </c:pt>
                  <c:pt idx="11">
                    <c:v>0.73489016678814034</c:v>
                  </c:pt>
                  <c:pt idx="12">
                    <c:v>1.3881245192067548</c:v>
                  </c:pt>
                  <c:pt idx="13">
                    <c:v>1.6097970036344653</c:v>
                  </c:pt>
                  <c:pt idx="14">
                    <c:v>1.5108964765391526</c:v>
                  </c:pt>
                  <c:pt idx="15">
                    <c:v>0.70552490988298511</c:v>
                  </c:pt>
                  <c:pt idx="16">
                    <c:v>1.9743765298216802</c:v>
                  </c:pt>
                  <c:pt idx="17">
                    <c:v>1.1865398065361752</c:v>
                  </c:pt>
                  <c:pt idx="18">
                    <c:v>0.92026911730515482</c:v>
                  </c:pt>
                  <c:pt idx="19">
                    <c:v>1.4636376767784032</c:v>
                  </c:pt>
                  <c:pt idx="20">
                    <c:v>0.88603071307211256</c:v>
                  </c:pt>
                  <c:pt idx="21">
                    <c:v>1.6148635545962666</c:v>
                  </c:pt>
                </c:numCache>
              </c:numRef>
            </c:minus>
            <c:spPr>
              <a:ln>
                <a:solidFill>
                  <a:srgbClr val="00B0F0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R$4:$BR$25</c:f>
              <c:numCache>
                <c:formatCode>General</c:formatCode>
                <c:ptCount val="22"/>
                <c:pt idx="0">
                  <c:v>101.6503955908717</c:v>
                </c:pt>
                <c:pt idx="1">
                  <c:v>100.51473162470322</c:v>
                </c:pt>
                <c:pt idx="2">
                  <c:v>100</c:v>
                </c:pt>
                <c:pt idx="3">
                  <c:v>149.84019566358958</c:v>
                </c:pt>
                <c:pt idx="4">
                  <c:v>150.13623413105012</c:v>
                </c:pt>
                <c:pt idx="5">
                  <c:v>149.46606997932005</c:v>
                </c:pt>
                <c:pt idx="6">
                  <c:v>155.14982288586199</c:v>
                </c:pt>
                <c:pt idx="7">
                  <c:v>155.79137770247621</c:v>
                </c:pt>
                <c:pt idx="8">
                  <c:v>160.2690391233983</c:v>
                </c:pt>
                <c:pt idx="9">
                  <c:v>158.14225335274577</c:v>
                </c:pt>
                <c:pt idx="10">
                  <c:v>162.51857797715232</c:v>
                </c:pt>
                <c:pt idx="11">
                  <c:v>165.07742517489942</c:v>
                </c:pt>
                <c:pt idx="12">
                  <c:v>163.97058462039712</c:v>
                </c:pt>
                <c:pt idx="13">
                  <c:v>165.44120603973664</c:v>
                </c:pt>
                <c:pt idx="14">
                  <c:v>171.19999028969281</c:v>
                </c:pt>
                <c:pt idx="15">
                  <c:v>164.91558183407162</c:v>
                </c:pt>
                <c:pt idx="16">
                  <c:v>168.4846336257954</c:v>
                </c:pt>
                <c:pt idx="17">
                  <c:v>166.76194653838493</c:v>
                </c:pt>
                <c:pt idx="18">
                  <c:v>168.67152300419409</c:v>
                </c:pt>
                <c:pt idx="19">
                  <c:v>167.48077868861967</c:v>
                </c:pt>
                <c:pt idx="20">
                  <c:v>174.4425261602259</c:v>
                </c:pt>
                <c:pt idx="21">
                  <c:v>174.1128027757735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A43-464D-B885-E6D91F1B7FC7}"/>
            </c:ext>
          </c:extLst>
        </c:ser>
        <c:ser>
          <c:idx val="2"/>
          <c:order val="2"/>
          <c:tx>
            <c:strRef>
              <c:f>' Calculations'!$BS$3</c:f>
              <c:strCache>
                <c:ptCount val="1"/>
                <c:pt idx="0">
                  <c:v>10 uM Zaprinast</c:v>
                </c:pt>
              </c:strCache>
            </c:strRef>
          </c:tx>
          <c:spPr>
            <a:ln w="9525">
              <a:solidFill>
                <a:srgbClr val="00B050"/>
              </a:solidFill>
            </a:ln>
          </c:spPr>
          <c:marker>
            <c:symbol val="triangle"/>
            <c:size val="4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S$29:$BS$50</c:f>
                <c:numCache>
                  <c:formatCode>General</c:formatCode>
                  <c:ptCount val="22"/>
                  <c:pt idx="0">
                    <c:v>1.0376659082715736</c:v>
                  </c:pt>
                  <c:pt idx="1">
                    <c:v>1.6273649906128125</c:v>
                  </c:pt>
                  <c:pt idx="2">
                    <c:v>1.4746324257357857</c:v>
                  </c:pt>
                  <c:pt idx="3">
                    <c:v>0.74347145494586142</c:v>
                  </c:pt>
                  <c:pt idx="4">
                    <c:v>1.0184663066832305</c:v>
                  </c:pt>
                  <c:pt idx="5">
                    <c:v>0.9145855522794103</c:v>
                  </c:pt>
                  <c:pt idx="6">
                    <c:v>0.7735043008173037</c:v>
                  </c:pt>
                  <c:pt idx="7">
                    <c:v>0.80741689118528515</c:v>
                  </c:pt>
                  <c:pt idx="8">
                    <c:v>1.0610049812791678</c:v>
                  </c:pt>
                  <c:pt idx="9">
                    <c:v>0.95558553271345459</c:v>
                  </c:pt>
                  <c:pt idx="10">
                    <c:v>0.72497185675999154</c:v>
                  </c:pt>
                  <c:pt idx="11">
                    <c:v>0.63440979772866779</c:v>
                  </c:pt>
                  <c:pt idx="12">
                    <c:v>0.96591001297834533</c:v>
                  </c:pt>
                  <c:pt idx="13">
                    <c:v>1.547075072346688</c:v>
                  </c:pt>
                  <c:pt idx="14">
                    <c:v>1.2497196620452269</c:v>
                  </c:pt>
                  <c:pt idx="15">
                    <c:v>0.68189855336788707</c:v>
                  </c:pt>
                  <c:pt idx="16">
                    <c:v>1.3006468965643951</c:v>
                  </c:pt>
                  <c:pt idx="17">
                    <c:v>1.3715605735257614</c:v>
                  </c:pt>
                  <c:pt idx="18">
                    <c:v>1.3818066907493265</c:v>
                  </c:pt>
                  <c:pt idx="19">
                    <c:v>0.6000503554252018</c:v>
                  </c:pt>
                  <c:pt idx="20">
                    <c:v>1.1780512671966059</c:v>
                  </c:pt>
                  <c:pt idx="21">
                    <c:v>0.9299776887665796</c:v>
                  </c:pt>
                </c:numCache>
              </c:numRef>
            </c:plus>
            <c:minus>
              <c:numRef>
                <c:f>' Calculations'!$BS$29:$BS$50</c:f>
                <c:numCache>
                  <c:formatCode>General</c:formatCode>
                  <c:ptCount val="22"/>
                  <c:pt idx="0">
                    <c:v>1.0376659082715736</c:v>
                  </c:pt>
                  <c:pt idx="1">
                    <c:v>1.6273649906128125</c:v>
                  </c:pt>
                  <c:pt idx="2">
                    <c:v>1.4746324257357857</c:v>
                  </c:pt>
                  <c:pt idx="3">
                    <c:v>0.74347145494586142</c:v>
                  </c:pt>
                  <c:pt idx="4">
                    <c:v>1.0184663066832305</c:v>
                  </c:pt>
                  <c:pt idx="5">
                    <c:v>0.9145855522794103</c:v>
                  </c:pt>
                  <c:pt idx="6">
                    <c:v>0.7735043008173037</c:v>
                  </c:pt>
                  <c:pt idx="7">
                    <c:v>0.80741689118528515</c:v>
                  </c:pt>
                  <c:pt idx="8">
                    <c:v>1.0610049812791678</c:v>
                  </c:pt>
                  <c:pt idx="9">
                    <c:v>0.95558553271345459</c:v>
                  </c:pt>
                  <c:pt idx="10">
                    <c:v>0.72497185675999154</c:v>
                  </c:pt>
                  <c:pt idx="11">
                    <c:v>0.63440979772866779</c:v>
                  </c:pt>
                  <c:pt idx="12">
                    <c:v>0.96591001297834533</c:v>
                  </c:pt>
                  <c:pt idx="13">
                    <c:v>1.547075072346688</c:v>
                  </c:pt>
                  <c:pt idx="14">
                    <c:v>1.2497196620452269</c:v>
                  </c:pt>
                  <c:pt idx="15">
                    <c:v>0.68189855336788707</c:v>
                  </c:pt>
                  <c:pt idx="16">
                    <c:v>1.3006468965643951</c:v>
                  </c:pt>
                  <c:pt idx="17">
                    <c:v>1.3715605735257614</c:v>
                  </c:pt>
                  <c:pt idx="18">
                    <c:v>1.3818066907493265</c:v>
                  </c:pt>
                  <c:pt idx="19">
                    <c:v>0.6000503554252018</c:v>
                  </c:pt>
                  <c:pt idx="20">
                    <c:v>1.1780512671966059</c:v>
                  </c:pt>
                  <c:pt idx="21">
                    <c:v>0.9299776887665796</c:v>
                  </c:pt>
                </c:numCache>
              </c:numRef>
            </c:minus>
            <c:spPr>
              <a:ln>
                <a:solidFill>
                  <a:srgbClr val="00B050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S$4:$BS$25</c:f>
              <c:numCache>
                <c:formatCode>General</c:formatCode>
                <c:ptCount val="22"/>
                <c:pt idx="0">
                  <c:v>101.44204930895744</c:v>
                </c:pt>
                <c:pt idx="1">
                  <c:v>100.63363259386797</c:v>
                </c:pt>
                <c:pt idx="2">
                  <c:v>100</c:v>
                </c:pt>
                <c:pt idx="3">
                  <c:v>147.14059901210359</c:v>
                </c:pt>
                <c:pt idx="4">
                  <c:v>144.70762379685686</c:v>
                </c:pt>
                <c:pt idx="5">
                  <c:v>146.50887792572874</c:v>
                </c:pt>
                <c:pt idx="6">
                  <c:v>148.2215595536301</c:v>
                </c:pt>
                <c:pt idx="7">
                  <c:v>151.84409697179262</c:v>
                </c:pt>
                <c:pt idx="8">
                  <c:v>154.60663631838048</c:v>
                </c:pt>
                <c:pt idx="9">
                  <c:v>154.55725214861314</c:v>
                </c:pt>
                <c:pt idx="10">
                  <c:v>156.86686221933832</c:v>
                </c:pt>
                <c:pt idx="11">
                  <c:v>160.68552355663192</c:v>
                </c:pt>
                <c:pt idx="12">
                  <c:v>158.63876592321955</c:v>
                </c:pt>
                <c:pt idx="13">
                  <c:v>162.59167311936957</c:v>
                </c:pt>
                <c:pt idx="14">
                  <c:v>167.29600892948801</c:v>
                </c:pt>
                <c:pt idx="15">
                  <c:v>167.41100842514072</c:v>
                </c:pt>
                <c:pt idx="16">
                  <c:v>162.23671880048818</c:v>
                </c:pt>
                <c:pt idx="17">
                  <c:v>165.34378103748065</c:v>
                </c:pt>
                <c:pt idx="18">
                  <c:v>168.22149365445088</c:v>
                </c:pt>
                <c:pt idx="19">
                  <c:v>163.72047914971034</c:v>
                </c:pt>
                <c:pt idx="20">
                  <c:v>169.71732307191928</c:v>
                </c:pt>
                <c:pt idx="21">
                  <c:v>171.378236528921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A43-464D-B885-E6D91F1B7FC7}"/>
            </c:ext>
          </c:extLst>
        </c:ser>
        <c:ser>
          <c:idx val="3"/>
          <c:order val="3"/>
          <c:tx>
            <c:strRef>
              <c:f>' Calculations'!$BT$3</c:f>
              <c:strCache>
                <c:ptCount val="1"/>
                <c:pt idx="0">
                  <c:v>10 uM Sildenafil</c:v>
                </c:pt>
              </c:strCache>
            </c:strRef>
          </c:tx>
          <c:spPr>
            <a:ln w="9525">
              <a:solidFill>
                <a:schemeClr val="accent6">
                  <a:lumMod val="75000"/>
                </a:schemeClr>
              </a:solidFill>
            </a:ln>
          </c:spPr>
          <c:marker>
            <c:symbol val="square"/>
            <c:size val="4"/>
            <c:spPr>
              <a:solidFill>
                <a:schemeClr val="accent6">
                  <a:lumMod val="75000"/>
                </a:schemeClr>
              </a:solidFill>
              <a:ln w="9525">
                <a:solidFill>
                  <a:schemeClr val="accent6">
                    <a:lumMod val="7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T$29:$BT$50</c:f>
                <c:numCache>
                  <c:formatCode>General</c:formatCode>
                  <c:ptCount val="22"/>
                  <c:pt idx="0">
                    <c:v>1.0081129669266669</c:v>
                  </c:pt>
                  <c:pt idx="1">
                    <c:v>0.61832287980570655</c:v>
                  </c:pt>
                  <c:pt idx="2">
                    <c:v>0.88889556848862106</c:v>
                  </c:pt>
                  <c:pt idx="3">
                    <c:v>1.4349279328854512</c:v>
                  </c:pt>
                  <c:pt idx="4">
                    <c:v>1.8006316675606839</c:v>
                  </c:pt>
                  <c:pt idx="5">
                    <c:v>1.5410481002855896</c:v>
                  </c:pt>
                  <c:pt idx="6">
                    <c:v>0.89143897141469652</c:v>
                  </c:pt>
                  <c:pt idx="7">
                    <c:v>1.1992794729921363</c:v>
                  </c:pt>
                  <c:pt idx="8">
                    <c:v>0.7856992250324244</c:v>
                  </c:pt>
                  <c:pt idx="9">
                    <c:v>9.8998652669587295E-2</c:v>
                  </c:pt>
                  <c:pt idx="10">
                    <c:v>1.6266020290019039</c:v>
                  </c:pt>
                  <c:pt idx="11">
                    <c:v>0.91312146706091069</c:v>
                  </c:pt>
                  <c:pt idx="12">
                    <c:v>1.5116943238525136</c:v>
                  </c:pt>
                  <c:pt idx="13">
                    <c:v>2.2160958098965753</c:v>
                  </c:pt>
                  <c:pt idx="14">
                    <c:v>1.9695263387923649</c:v>
                  </c:pt>
                  <c:pt idx="15">
                    <c:v>2.1088052336734098</c:v>
                  </c:pt>
                  <c:pt idx="16">
                    <c:v>1.2411655677678965</c:v>
                  </c:pt>
                  <c:pt idx="17">
                    <c:v>0.65499112060370035</c:v>
                  </c:pt>
                  <c:pt idx="18">
                    <c:v>1.3588857284916438</c:v>
                  </c:pt>
                  <c:pt idx="19">
                    <c:v>2.3784835327291995</c:v>
                  </c:pt>
                  <c:pt idx="20">
                    <c:v>1.2170179700238095</c:v>
                  </c:pt>
                  <c:pt idx="21">
                    <c:v>3.0713371872259381</c:v>
                  </c:pt>
                </c:numCache>
              </c:numRef>
            </c:plus>
            <c:minus>
              <c:numRef>
                <c:f>' Calculations'!$BT$29:$BT$50</c:f>
                <c:numCache>
                  <c:formatCode>General</c:formatCode>
                  <c:ptCount val="22"/>
                  <c:pt idx="0">
                    <c:v>1.0081129669266669</c:v>
                  </c:pt>
                  <c:pt idx="1">
                    <c:v>0.61832287980570655</c:v>
                  </c:pt>
                  <c:pt idx="2">
                    <c:v>0.88889556848862106</c:v>
                  </c:pt>
                  <c:pt idx="3">
                    <c:v>1.4349279328854512</c:v>
                  </c:pt>
                  <c:pt idx="4">
                    <c:v>1.8006316675606839</c:v>
                  </c:pt>
                  <c:pt idx="5">
                    <c:v>1.5410481002855896</c:v>
                  </c:pt>
                  <c:pt idx="6">
                    <c:v>0.89143897141469652</c:v>
                  </c:pt>
                  <c:pt idx="7">
                    <c:v>1.1992794729921363</c:v>
                  </c:pt>
                  <c:pt idx="8">
                    <c:v>0.7856992250324244</c:v>
                  </c:pt>
                  <c:pt idx="9">
                    <c:v>9.8998652669587295E-2</c:v>
                  </c:pt>
                  <c:pt idx="10">
                    <c:v>1.6266020290019039</c:v>
                  </c:pt>
                  <c:pt idx="11">
                    <c:v>0.91312146706091069</c:v>
                  </c:pt>
                  <c:pt idx="12">
                    <c:v>1.5116943238525136</c:v>
                  </c:pt>
                  <c:pt idx="13">
                    <c:v>2.2160958098965753</c:v>
                  </c:pt>
                  <c:pt idx="14">
                    <c:v>1.9695263387923649</c:v>
                  </c:pt>
                  <c:pt idx="15">
                    <c:v>2.1088052336734098</c:v>
                  </c:pt>
                  <c:pt idx="16">
                    <c:v>1.2411655677678965</c:v>
                  </c:pt>
                  <c:pt idx="17">
                    <c:v>0.65499112060370035</c:v>
                  </c:pt>
                  <c:pt idx="18">
                    <c:v>1.3588857284916438</c:v>
                  </c:pt>
                  <c:pt idx="19">
                    <c:v>2.3784835327291995</c:v>
                  </c:pt>
                  <c:pt idx="20">
                    <c:v>1.2170179700238095</c:v>
                  </c:pt>
                  <c:pt idx="21">
                    <c:v>3.0713371872259381</c:v>
                  </c:pt>
                </c:numCache>
              </c:numRef>
            </c:minus>
            <c:spPr>
              <a:ln>
                <a:solidFill>
                  <a:schemeClr val="accent6">
                    <a:lumMod val="75000"/>
                  </a:schemeClr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T$4:$BT$25</c:f>
              <c:numCache>
                <c:formatCode>General</c:formatCode>
                <c:ptCount val="22"/>
                <c:pt idx="0">
                  <c:v>102.95622914320424</c:v>
                </c:pt>
                <c:pt idx="1">
                  <c:v>98.055571362048937</c:v>
                </c:pt>
                <c:pt idx="2">
                  <c:v>100</c:v>
                </c:pt>
                <c:pt idx="3">
                  <c:v>100.60176809348282</c:v>
                </c:pt>
                <c:pt idx="4">
                  <c:v>101.3599881400006</c:v>
                </c:pt>
                <c:pt idx="5">
                  <c:v>105.94641787661108</c:v>
                </c:pt>
                <c:pt idx="6">
                  <c:v>105.97416340658251</c:v>
                </c:pt>
                <c:pt idx="7">
                  <c:v>107.93568504281797</c:v>
                </c:pt>
                <c:pt idx="8">
                  <c:v>109.24765658015505</c:v>
                </c:pt>
                <c:pt idx="9">
                  <c:v>110.2514867867624</c:v>
                </c:pt>
                <c:pt idx="10">
                  <c:v>111.63252330739219</c:v>
                </c:pt>
                <c:pt idx="11">
                  <c:v>113.00153504525532</c:v>
                </c:pt>
                <c:pt idx="12">
                  <c:v>113.8002373959111</c:v>
                </c:pt>
                <c:pt idx="13">
                  <c:v>115.38222961148701</c:v>
                </c:pt>
                <c:pt idx="14">
                  <c:v>112.94258027514108</c:v>
                </c:pt>
                <c:pt idx="15">
                  <c:v>116.27626516683469</c:v>
                </c:pt>
                <c:pt idx="16">
                  <c:v>117.16258933263262</c:v>
                </c:pt>
                <c:pt idx="17">
                  <c:v>123.30941314415556</c:v>
                </c:pt>
                <c:pt idx="18">
                  <c:v>118.99431821387314</c:v>
                </c:pt>
                <c:pt idx="19">
                  <c:v>117.99733681414868</c:v>
                </c:pt>
                <c:pt idx="20">
                  <c:v>119.68218306330731</c:v>
                </c:pt>
                <c:pt idx="21">
                  <c:v>127.053076844498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A43-464D-B885-E6D91F1B7FC7}"/>
            </c:ext>
          </c:extLst>
        </c:ser>
        <c:ser>
          <c:idx val="4"/>
          <c:order val="4"/>
          <c:tx>
            <c:strRef>
              <c:f>' Calculations'!$BU$3</c:f>
              <c:strCache>
                <c:ptCount val="1"/>
                <c:pt idx="0">
                  <c:v>10 uM Tadalafil</c:v>
                </c:pt>
              </c:strCache>
            </c:strRef>
          </c:tx>
          <c:spPr>
            <a:ln w="9525">
              <a:solidFill>
                <a:srgbClr val="7030A0"/>
              </a:solidFill>
            </a:ln>
          </c:spPr>
          <c:marker>
            <c:symbol val="circle"/>
            <c:size val="4"/>
            <c:spPr>
              <a:solidFill>
                <a:srgbClr val="7030A0"/>
              </a:solidFill>
              <a:ln>
                <a:solidFill>
                  <a:srgbClr val="7030A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U$29:$BU$50</c:f>
                <c:numCache>
                  <c:formatCode>General</c:formatCode>
                  <c:ptCount val="22"/>
                  <c:pt idx="0">
                    <c:v>1.2094659355451631</c:v>
                  </c:pt>
                  <c:pt idx="1">
                    <c:v>1.1931932153641052</c:v>
                  </c:pt>
                  <c:pt idx="2">
                    <c:v>1.2882988317511892</c:v>
                  </c:pt>
                  <c:pt idx="3">
                    <c:v>1.6326395772656643</c:v>
                  </c:pt>
                  <c:pt idx="4">
                    <c:v>1.138500664078651</c:v>
                  </c:pt>
                  <c:pt idx="5">
                    <c:v>1.4211824530980677</c:v>
                  </c:pt>
                  <c:pt idx="6">
                    <c:v>1.3296460484481509</c:v>
                  </c:pt>
                  <c:pt idx="7">
                    <c:v>1.48544899204027</c:v>
                  </c:pt>
                  <c:pt idx="8">
                    <c:v>1.2108207728001574</c:v>
                  </c:pt>
                  <c:pt idx="9">
                    <c:v>1.0455655505198351</c:v>
                  </c:pt>
                  <c:pt idx="10">
                    <c:v>1.2450525481739976</c:v>
                  </c:pt>
                  <c:pt idx="11">
                    <c:v>1.4834184484680744</c:v>
                  </c:pt>
                  <c:pt idx="12">
                    <c:v>2.0039169709108613</c:v>
                  </c:pt>
                  <c:pt idx="13">
                    <c:v>0.79118610275355361</c:v>
                  </c:pt>
                  <c:pt idx="14">
                    <c:v>2.0522416766891474</c:v>
                  </c:pt>
                  <c:pt idx="15">
                    <c:v>0.80707777489580357</c:v>
                  </c:pt>
                  <c:pt idx="16">
                    <c:v>2.1944335290408867</c:v>
                  </c:pt>
                  <c:pt idx="17">
                    <c:v>0.91177992071714353</c:v>
                  </c:pt>
                  <c:pt idx="18">
                    <c:v>1.6903908171303821</c:v>
                  </c:pt>
                  <c:pt idx="19">
                    <c:v>1.0327138197361658</c:v>
                  </c:pt>
                  <c:pt idx="20">
                    <c:v>1.6211334651385567</c:v>
                  </c:pt>
                  <c:pt idx="21">
                    <c:v>1.2350677729496102</c:v>
                  </c:pt>
                </c:numCache>
              </c:numRef>
            </c:plus>
            <c:minus>
              <c:numRef>
                <c:f>' Calculations'!$BU$29:$BU$50</c:f>
                <c:numCache>
                  <c:formatCode>General</c:formatCode>
                  <c:ptCount val="22"/>
                  <c:pt idx="0">
                    <c:v>1.2094659355451631</c:v>
                  </c:pt>
                  <c:pt idx="1">
                    <c:v>1.1931932153641052</c:v>
                  </c:pt>
                  <c:pt idx="2">
                    <c:v>1.2882988317511892</c:v>
                  </c:pt>
                  <c:pt idx="3">
                    <c:v>1.6326395772656643</c:v>
                  </c:pt>
                  <c:pt idx="4">
                    <c:v>1.138500664078651</c:v>
                  </c:pt>
                  <c:pt idx="5">
                    <c:v>1.4211824530980677</c:v>
                  </c:pt>
                  <c:pt idx="6">
                    <c:v>1.3296460484481509</c:v>
                  </c:pt>
                  <c:pt idx="7">
                    <c:v>1.48544899204027</c:v>
                  </c:pt>
                  <c:pt idx="8">
                    <c:v>1.2108207728001574</c:v>
                  </c:pt>
                  <c:pt idx="9">
                    <c:v>1.0455655505198351</c:v>
                  </c:pt>
                  <c:pt idx="10">
                    <c:v>1.2450525481739976</c:v>
                  </c:pt>
                  <c:pt idx="11">
                    <c:v>1.4834184484680744</c:v>
                  </c:pt>
                  <c:pt idx="12">
                    <c:v>2.0039169709108613</c:v>
                  </c:pt>
                  <c:pt idx="13">
                    <c:v>0.79118610275355361</c:v>
                  </c:pt>
                  <c:pt idx="14">
                    <c:v>2.0522416766891474</c:v>
                  </c:pt>
                  <c:pt idx="15">
                    <c:v>0.80707777489580357</c:v>
                  </c:pt>
                  <c:pt idx="16">
                    <c:v>2.1944335290408867</c:v>
                  </c:pt>
                  <c:pt idx="17">
                    <c:v>0.91177992071714353</c:v>
                  </c:pt>
                  <c:pt idx="18">
                    <c:v>1.6903908171303821</c:v>
                  </c:pt>
                  <c:pt idx="19">
                    <c:v>1.0327138197361658</c:v>
                  </c:pt>
                  <c:pt idx="20">
                    <c:v>1.6211334651385567</c:v>
                  </c:pt>
                  <c:pt idx="21">
                    <c:v>1.2350677729496102</c:v>
                  </c:pt>
                </c:numCache>
              </c:numRef>
            </c:minus>
            <c:spPr>
              <a:ln>
                <a:solidFill>
                  <a:srgbClr val="7030A0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U$4:$BU$25</c:f>
              <c:numCache>
                <c:formatCode>General</c:formatCode>
                <c:ptCount val="22"/>
                <c:pt idx="0">
                  <c:v>103.22645823807022</c:v>
                </c:pt>
                <c:pt idx="1">
                  <c:v>99.011614816534802</c:v>
                </c:pt>
                <c:pt idx="2">
                  <c:v>100</c:v>
                </c:pt>
                <c:pt idx="3">
                  <c:v>100.12690811161633</c:v>
                </c:pt>
                <c:pt idx="4">
                  <c:v>103.01681266181274</c:v>
                </c:pt>
                <c:pt idx="5">
                  <c:v>104.93376847886489</c:v>
                </c:pt>
                <c:pt idx="6">
                  <c:v>105.00641080948689</c:v>
                </c:pt>
                <c:pt idx="7">
                  <c:v>109.61299527723996</c:v>
                </c:pt>
                <c:pt idx="8">
                  <c:v>107.69077580438</c:v>
                </c:pt>
                <c:pt idx="9">
                  <c:v>111.89704075343036</c:v>
                </c:pt>
                <c:pt idx="10">
                  <c:v>114.74368474164871</c:v>
                </c:pt>
                <c:pt idx="11">
                  <c:v>111.09099357793862</c:v>
                </c:pt>
                <c:pt idx="12">
                  <c:v>115.9219012018643</c:v>
                </c:pt>
                <c:pt idx="13">
                  <c:v>115.22491039133979</c:v>
                </c:pt>
                <c:pt idx="14">
                  <c:v>116.96123916605379</c:v>
                </c:pt>
                <c:pt idx="15">
                  <c:v>115.5573009623935</c:v>
                </c:pt>
                <c:pt idx="16">
                  <c:v>116.38293364415533</c:v>
                </c:pt>
                <c:pt idx="17">
                  <c:v>119.42359613813065</c:v>
                </c:pt>
                <c:pt idx="18">
                  <c:v>116.25977864223573</c:v>
                </c:pt>
                <c:pt idx="19">
                  <c:v>115.31354012133288</c:v>
                </c:pt>
                <c:pt idx="20">
                  <c:v>119.8028503382728</c:v>
                </c:pt>
                <c:pt idx="21">
                  <c:v>122.63251553372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3A43-464D-B885-E6D91F1B7FC7}"/>
            </c:ext>
          </c:extLst>
        </c:ser>
        <c:ser>
          <c:idx val="5"/>
          <c:order val="5"/>
          <c:tx>
            <c:strRef>
              <c:f>' Calculations'!$BV$3</c:f>
              <c:strCache>
                <c:ptCount val="1"/>
                <c:pt idx="0">
                  <c:v>10 uM Verdenafil</c:v>
                </c:pt>
              </c:strCache>
            </c:strRef>
          </c:tx>
          <c:spPr>
            <a:ln w="9525">
              <a:solidFill>
                <a:srgbClr val="C00000"/>
              </a:solidFill>
            </a:ln>
          </c:spPr>
          <c:marker>
            <c:symbol val="triangle"/>
            <c:size val="4"/>
            <c:spPr>
              <a:solidFill>
                <a:srgbClr val="C00000"/>
              </a:solidFill>
              <a:ln w="9525">
                <a:solidFill>
                  <a:srgbClr val="C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V$29:$BV$50</c:f>
                <c:numCache>
                  <c:formatCode>General</c:formatCode>
                  <c:ptCount val="22"/>
                  <c:pt idx="0">
                    <c:v>1.7149449112464237</c:v>
                  </c:pt>
                  <c:pt idx="1">
                    <c:v>1.3522417799330932</c:v>
                  </c:pt>
                  <c:pt idx="2">
                    <c:v>1.4457840921351</c:v>
                  </c:pt>
                  <c:pt idx="3">
                    <c:v>1.7837663068655993</c:v>
                  </c:pt>
                  <c:pt idx="4">
                    <c:v>1.4572807683346047</c:v>
                  </c:pt>
                  <c:pt idx="5">
                    <c:v>2.2049158551182098</c:v>
                  </c:pt>
                  <c:pt idx="6">
                    <c:v>1.5847098159537776</c:v>
                  </c:pt>
                  <c:pt idx="7">
                    <c:v>1.0768396026061346</c:v>
                  </c:pt>
                  <c:pt idx="8">
                    <c:v>1.5950235149629948</c:v>
                  </c:pt>
                  <c:pt idx="9">
                    <c:v>0.50959271744009493</c:v>
                  </c:pt>
                  <c:pt idx="10">
                    <c:v>0.77005153010049443</c:v>
                  </c:pt>
                  <c:pt idx="11">
                    <c:v>1.422761470664192</c:v>
                  </c:pt>
                  <c:pt idx="12">
                    <c:v>3.0336457274840334</c:v>
                  </c:pt>
                  <c:pt idx="13">
                    <c:v>2.05842480618124</c:v>
                  </c:pt>
                  <c:pt idx="14">
                    <c:v>1.3793068709192062</c:v>
                  </c:pt>
                  <c:pt idx="15">
                    <c:v>1.6347739001416211</c:v>
                  </c:pt>
                  <c:pt idx="16">
                    <c:v>2.3368793182799261</c:v>
                  </c:pt>
                  <c:pt idx="17">
                    <c:v>2.1589568384889311</c:v>
                  </c:pt>
                  <c:pt idx="18">
                    <c:v>1.6822016851989492</c:v>
                  </c:pt>
                  <c:pt idx="19">
                    <c:v>3.2318184166940442</c:v>
                  </c:pt>
                  <c:pt idx="20">
                    <c:v>3.2615558636271635</c:v>
                  </c:pt>
                  <c:pt idx="21">
                    <c:v>3.8135734656470257</c:v>
                  </c:pt>
                </c:numCache>
              </c:numRef>
            </c:plus>
            <c:minus>
              <c:numRef>
                <c:f>' Calculations'!$BV$29:$BV$50</c:f>
                <c:numCache>
                  <c:formatCode>General</c:formatCode>
                  <c:ptCount val="22"/>
                  <c:pt idx="0">
                    <c:v>1.7149449112464237</c:v>
                  </c:pt>
                  <c:pt idx="1">
                    <c:v>1.3522417799330932</c:v>
                  </c:pt>
                  <c:pt idx="2">
                    <c:v>1.4457840921351</c:v>
                  </c:pt>
                  <c:pt idx="3">
                    <c:v>1.7837663068655993</c:v>
                  </c:pt>
                  <c:pt idx="4">
                    <c:v>1.4572807683346047</c:v>
                  </c:pt>
                  <c:pt idx="5">
                    <c:v>2.2049158551182098</c:v>
                  </c:pt>
                  <c:pt idx="6">
                    <c:v>1.5847098159537776</c:v>
                  </c:pt>
                  <c:pt idx="7">
                    <c:v>1.0768396026061346</c:v>
                  </c:pt>
                  <c:pt idx="8">
                    <c:v>1.5950235149629948</c:v>
                  </c:pt>
                  <c:pt idx="9">
                    <c:v>0.50959271744009493</c:v>
                  </c:pt>
                  <c:pt idx="10">
                    <c:v>0.77005153010049443</c:v>
                  </c:pt>
                  <c:pt idx="11">
                    <c:v>1.422761470664192</c:v>
                  </c:pt>
                  <c:pt idx="12">
                    <c:v>3.0336457274840334</c:v>
                  </c:pt>
                  <c:pt idx="13">
                    <c:v>2.05842480618124</c:v>
                  </c:pt>
                  <c:pt idx="14">
                    <c:v>1.3793068709192062</c:v>
                  </c:pt>
                  <c:pt idx="15">
                    <c:v>1.6347739001416211</c:v>
                  </c:pt>
                  <c:pt idx="16">
                    <c:v>2.3368793182799261</c:v>
                  </c:pt>
                  <c:pt idx="17">
                    <c:v>2.1589568384889311</c:v>
                  </c:pt>
                  <c:pt idx="18">
                    <c:v>1.6822016851989492</c:v>
                  </c:pt>
                  <c:pt idx="19">
                    <c:v>3.2318184166940442</c:v>
                  </c:pt>
                  <c:pt idx="20">
                    <c:v>3.2615558636271635</c:v>
                  </c:pt>
                  <c:pt idx="21">
                    <c:v>3.8135734656470257</c:v>
                  </c:pt>
                </c:numCache>
              </c:numRef>
            </c:minus>
            <c:spPr>
              <a:ln>
                <a:solidFill>
                  <a:srgbClr val="C00000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V$4:$BV$25</c:f>
              <c:numCache>
                <c:formatCode>General</c:formatCode>
                <c:ptCount val="22"/>
                <c:pt idx="0">
                  <c:v>105.04509032846421</c:v>
                </c:pt>
                <c:pt idx="1">
                  <c:v>98.669452420573847</c:v>
                </c:pt>
                <c:pt idx="2">
                  <c:v>100</c:v>
                </c:pt>
                <c:pt idx="3">
                  <c:v>97.598788517290657</c:v>
                </c:pt>
                <c:pt idx="4">
                  <c:v>102.38531166915314</c:v>
                </c:pt>
                <c:pt idx="5">
                  <c:v>105.71588985637104</c:v>
                </c:pt>
                <c:pt idx="6">
                  <c:v>107.1403471985098</c:v>
                </c:pt>
                <c:pt idx="7">
                  <c:v>107.62044817287372</c:v>
                </c:pt>
                <c:pt idx="8">
                  <c:v>109.12124403453657</c:v>
                </c:pt>
                <c:pt idx="9">
                  <c:v>114.04745202907446</c:v>
                </c:pt>
                <c:pt idx="10">
                  <c:v>112.4159359741957</c:v>
                </c:pt>
                <c:pt idx="11">
                  <c:v>111.13320275042587</c:v>
                </c:pt>
                <c:pt idx="12">
                  <c:v>114.17667127138516</c:v>
                </c:pt>
                <c:pt idx="13">
                  <c:v>110.89746647383785</c:v>
                </c:pt>
                <c:pt idx="14">
                  <c:v>116.54195389438851</c:v>
                </c:pt>
                <c:pt idx="15">
                  <c:v>116.72498491624457</c:v>
                </c:pt>
                <c:pt idx="16">
                  <c:v>115.76006148814473</c:v>
                </c:pt>
                <c:pt idx="17">
                  <c:v>115.30921052823082</c:v>
                </c:pt>
                <c:pt idx="18">
                  <c:v>115.63482695174214</c:v>
                </c:pt>
                <c:pt idx="19">
                  <c:v>116.00889846107378</c:v>
                </c:pt>
                <c:pt idx="20">
                  <c:v>113.09601293205802</c:v>
                </c:pt>
                <c:pt idx="21">
                  <c:v>113.288030508990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3A43-464D-B885-E6D91F1B7F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43956192"/>
        <c:axId val="-843952384"/>
      </c:scatterChart>
      <c:valAx>
        <c:axId val="-843956192"/>
        <c:scaling>
          <c:orientation val="minMax"/>
          <c:max val="3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</c:spPr>
        <c:crossAx val="-843952384"/>
        <c:crosses val="autoZero"/>
        <c:crossBetween val="midCat"/>
      </c:valAx>
      <c:valAx>
        <c:axId val="-843952384"/>
        <c:scaling>
          <c:orientation val="minMax"/>
          <c:max val="175"/>
          <c:min val="9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BRET (% of basa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-84395619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2805308154162341"/>
          <c:y val="0.21963938017809798"/>
          <c:w val="0.53888878803341822"/>
          <c:h val="0.28703680959193767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000" b="1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702792359288424"/>
          <c:y val="5.1342592592592606E-2"/>
          <c:w val="0.77241652085156021"/>
          <c:h val="0.7353546952464276"/>
        </c:manualLayout>
      </c:layout>
      <c:lineChart>
        <c:grouping val="standard"/>
        <c:varyColors val="0"/>
        <c:ser>
          <c:idx val="0"/>
          <c:order val="0"/>
          <c:tx>
            <c:strRef>
              <c:f>Sheet1!$A$10</c:f>
              <c:strCache>
                <c:ptCount val="1"/>
                <c:pt idx="0">
                  <c:v>Sildenafi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14:$F$14</c:f>
                <c:numCache>
                  <c:formatCode>General</c:formatCode>
                  <c:ptCount val="5"/>
                  <c:pt idx="0">
                    <c:v>2.0720124074448312</c:v>
                  </c:pt>
                  <c:pt idx="1">
                    <c:v>1.8961473395435569</c:v>
                  </c:pt>
                  <c:pt idx="2">
                    <c:v>4.1560802979361506</c:v>
                  </c:pt>
                  <c:pt idx="3">
                    <c:v>5.5021198063953598</c:v>
                  </c:pt>
                  <c:pt idx="4">
                    <c:v>6.9804411680970304</c:v>
                  </c:pt>
                </c:numCache>
              </c:numRef>
            </c:plus>
            <c:minus>
              <c:numRef>
                <c:f>Sheet1!$B$14:$F$14</c:f>
                <c:numCache>
                  <c:formatCode>General</c:formatCode>
                  <c:ptCount val="5"/>
                  <c:pt idx="0">
                    <c:v>2.0720124074448312</c:v>
                  </c:pt>
                  <c:pt idx="1">
                    <c:v>1.8961473395435569</c:v>
                  </c:pt>
                  <c:pt idx="2">
                    <c:v>4.1560802979361506</c:v>
                  </c:pt>
                  <c:pt idx="3">
                    <c:v>5.5021198063953598</c:v>
                  </c:pt>
                  <c:pt idx="4">
                    <c:v>6.9804411680970304</c:v>
                  </c:pt>
                </c:numCache>
              </c:numRef>
            </c:minus>
          </c:errBars>
          <c:cat>
            <c:strRef>
              <c:f>Sheet1!$B$9:$F$9</c:f>
              <c:strCache>
                <c:ptCount val="5"/>
                <c:pt idx="0">
                  <c:v>vehicle</c:v>
                </c:pt>
                <c:pt idx="1">
                  <c:v>0.1 µM</c:v>
                </c:pt>
                <c:pt idx="2">
                  <c:v>1 µM</c:v>
                </c:pt>
                <c:pt idx="3">
                  <c:v>10 µM</c:v>
                </c:pt>
                <c:pt idx="4">
                  <c:v>20 µM</c:v>
                </c:pt>
              </c:strCache>
            </c:strRef>
          </c:cat>
          <c:val>
            <c:numRef>
              <c:f>Sheet1!$B$10:$F$10</c:f>
              <c:numCache>
                <c:formatCode>General</c:formatCode>
                <c:ptCount val="5"/>
                <c:pt idx="0">
                  <c:v>100</c:v>
                </c:pt>
                <c:pt idx="1">
                  <c:v>96.922698420102563</c:v>
                </c:pt>
                <c:pt idx="2">
                  <c:v>91.362410705403221</c:v>
                </c:pt>
                <c:pt idx="3">
                  <c:v>84.258216706915348</c:v>
                </c:pt>
                <c:pt idx="4">
                  <c:v>80.21707571986024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60F-45CF-B14E-68744A3C8510}"/>
            </c:ext>
          </c:extLst>
        </c:ser>
        <c:ser>
          <c:idx val="1"/>
          <c:order val="1"/>
          <c:tx>
            <c:strRef>
              <c:f>Sheet1!$A$11</c:f>
              <c:strCache>
                <c:ptCount val="1"/>
                <c:pt idx="0">
                  <c:v>Tadalafi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15:$F$15</c:f>
                <c:numCache>
                  <c:formatCode>General</c:formatCode>
                  <c:ptCount val="5"/>
                  <c:pt idx="0">
                    <c:v>4.9554764177876169</c:v>
                  </c:pt>
                  <c:pt idx="1">
                    <c:v>6.6112028304319779</c:v>
                  </c:pt>
                  <c:pt idx="2">
                    <c:v>5.7843840189199431</c:v>
                  </c:pt>
                  <c:pt idx="3">
                    <c:v>6.724014074031551</c:v>
                  </c:pt>
                  <c:pt idx="4">
                    <c:v>6.957840280493345</c:v>
                  </c:pt>
                </c:numCache>
              </c:numRef>
            </c:plus>
            <c:minus>
              <c:numRef>
                <c:f>Sheet1!$B$15:$F$15</c:f>
                <c:numCache>
                  <c:formatCode>General</c:formatCode>
                  <c:ptCount val="5"/>
                  <c:pt idx="0">
                    <c:v>4.9554764177876169</c:v>
                  </c:pt>
                  <c:pt idx="1">
                    <c:v>6.6112028304319779</c:v>
                  </c:pt>
                  <c:pt idx="2">
                    <c:v>5.7843840189199431</c:v>
                  </c:pt>
                  <c:pt idx="3">
                    <c:v>6.724014074031551</c:v>
                  </c:pt>
                  <c:pt idx="4">
                    <c:v>6.957840280493345</c:v>
                  </c:pt>
                </c:numCache>
              </c:numRef>
            </c:minus>
          </c:errBars>
          <c:cat>
            <c:strRef>
              <c:f>Sheet1!$B$9:$F$9</c:f>
              <c:strCache>
                <c:ptCount val="5"/>
                <c:pt idx="0">
                  <c:v>vehicle</c:v>
                </c:pt>
                <c:pt idx="1">
                  <c:v>0.1 µM</c:v>
                </c:pt>
                <c:pt idx="2">
                  <c:v>1 µM</c:v>
                </c:pt>
                <c:pt idx="3">
                  <c:v>10 µM</c:v>
                </c:pt>
                <c:pt idx="4">
                  <c:v>20 µM</c:v>
                </c:pt>
              </c:strCache>
            </c:strRef>
          </c:cat>
          <c:val>
            <c:numRef>
              <c:f>Sheet1!$B$11:$F$11</c:f>
              <c:numCache>
                <c:formatCode>General</c:formatCode>
                <c:ptCount val="5"/>
                <c:pt idx="0">
                  <c:v>100</c:v>
                </c:pt>
                <c:pt idx="1">
                  <c:v>97.099841993603604</c:v>
                </c:pt>
                <c:pt idx="2">
                  <c:v>89.619813771149182</c:v>
                </c:pt>
                <c:pt idx="3">
                  <c:v>82.767203386580462</c:v>
                </c:pt>
                <c:pt idx="4">
                  <c:v>78.7485060818134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60F-45CF-B14E-68744A3C8510}"/>
            </c:ext>
          </c:extLst>
        </c:ser>
        <c:ser>
          <c:idx val="2"/>
          <c:order val="2"/>
          <c:tx>
            <c:strRef>
              <c:f>Sheet1!$A$12</c:f>
              <c:strCache>
                <c:ptCount val="1"/>
                <c:pt idx="0">
                  <c:v>Vardenafil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B05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B$16:$F$16</c:f>
                <c:numCache>
                  <c:formatCode>General</c:formatCode>
                  <c:ptCount val="5"/>
                  <c:pt idx="0">
                    <c:v>17.581093350534232</c:v>
                  </c:pt>
                  <c:pt idx="1">
                    <c:v>15.576063133548686</c:v>
                  </c:pt>
                  <c:pt idx="2">
                    <c:v>16.060762763669281</c:v>
                  </c:pt>
                  <c:pt idx="3">
                    <c:v>16.296683587665235</c:v>
                  </c:pt>
                  <c:pt idx="4">
                    <c:v>15.430505411413506</c:v>
                  </c:pt>
                </c:numCache>
              </c:numRef>
            </c:plus>
            <c:minus>
              <c:numRef>
                <c:f>Sheet1!$B$16:$F$16</c:f>
                <c:numCache>
                  <c:formatCode>General</c:formatCode>
                  <c:ptCount val="5"/>
                  <c:pt idx="0">
                    <c:v>17.581093350534232</c:v>
                  </c:pt>
                  <c:pt idx="1">
                    <c:v>15.576063133548686</c:v>
                  </c:pt>
                  <c:pt idx="2">
                    <c:v>16.060762763669281</c:v>
                  </c:pt>
                  <c:pt idx="3">
                    <c:v>16.296683587665235</c:v>
                  </c:pt>
                  <c:pt idx="4">
                    <c:v>15.430505411413506</c:v>
                  </c:pt>
                </c:numCache>
              </c:numRef>
            </c:minus>
          </c:errBars>
          <c:cat>
            <c:strRef>
              <c:f>Sheet1!$B$9:$F$9</c:f>
              <c:strCache>
                <c:ptCount val="5"/>
                <c:pt idx="0">
                  <c:v>vehicle</c:v>
                </c:pt>
                <c:pt idx="1">
                  <c:v>0.1 µM</c:v>
                </c:pt>
                <c:pt idx="2">
                  <c:v>1 µM</c:v>
                </c:pt>
                <c:pt idx="3">
                  <c:v>10 µM</c:v>
                </c:pt>
                <c:pt idx="4">
                  <c:v>20 µM</c:v>
                </c:pt>
              </c:strCache>
            </c:strRef>
          </c:cat>
          <c:val>
            <c:numRef>
              <c:f>Sheet1!$B$12:$F$12</c:f>
              <c:numCache>
                <c:formatCode>General</c:formatCode>
                <c:ptCount val="5"/>
                <c:pt idx="0">
                  <c:v>100</c:v>
                </c:pt>
                <c:pt idx="1">
                  <c:v>101.17406483617508</c:v>
                </c:pt>
                <c:pt idx="2">
                  <c:v>99.744695454590811</c:v>
                </c:pt>
                <c:pt idx="3">
                  <c:v>100.29328371364967</c:v>
                </c:pt>
                <c:pt idx="4">
                  <c:v>97.6401262349119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60F-45CF-B14E-68744A3C85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843947488"/>
        <c:axId val="-843957280"/>
      </c:lineChart>
      <c:catAx>
        <c:axId val="-8439474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843957280"/>
        <c:crosses val="autoZero"/>
        <c:auto val="1"/>
        <c:lblAlgn val="ctr"/>
        <c:lblOffset val="100"/>
        <c:noMultiLvlLbl val="0"/>
      </c:catAx>
      <c:valAx>
        <c:axId val="-8439572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ercent vehicl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8439474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2793124817731117"/>
          <c:y val="0.48953982654342126"/>
          <c:w val="0.60478237095363074"/>
          <c:h val="0.30759395564684849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570805072331675"/>
          <c:y val="0.11922278893222824"/>
          <c:w val="0.69818697221581361"/>
          <c:h val="0.78746728172289016"/>
        </c:manualLayout>
      </c:layout>
      <c:scatterChart>
        <c:scatterStyle val="lineMarker"/>
        <c:varyColors val="0"/>
        <c:ser>
          <c:idx val="0"/>
          <c:order val="0"/>
          <c:tx>
            <c:strRef>
              <c:f>' Calculations'!$BQ$3</c:f>
              <c:strCache>
                <c:ptCount val="1"/>
                <c:pt idx="0">
                  <c:v>DMSO</c:v>
                </c:pt>
              </c:strCache>
            </c:strRef>
          </c:tx>
          <c:spPr>
            <a:ln w="9525">
              <a:solidFill>
                <a:srgbClr val="00B0F0"/>
              </a:solidFill>
            </a:ln>
          </c:spPr>
          <c:marker>
            <c:symbol val="square"/>
            <c:size val="4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Q$29:$BQ$50</c:f>
                <c:numCache>
                  <c:formatCode>General</c:formatCode>
                  <c:ptCount val="22"/>
                  <c:pt idx="0">
                    <c:v>2.0702293303456134</c:v>
                  </c:pt>
                  <c:pt idx="1">
                    <c:v>1.0205365248853915</c:v>
                  </c:pt>
                  <c:pt idx="2">
                    <c:v>1.6671149069516504</c:v>
                  </c:pt>
                  <c:pt idx="3">
                    <c:v>0.81674312836924079</c:v>
                  </c:pt>
                  <c:pt idx="4">
                    <c:v>1.5699564962042092</c:v>
                  </c:pt>
                  <c:pt idx="5">
                    <c:v>0.62422267067428683</c:v>
                  </c:pt>
                  <c:pt idx="6">
                    <c:v>1.3195953814092638</c:v>
                  </c:pt>
                  <c:pt idx="7">
                    <c:v>0.75416060826558351</c:v>
                  </c:pt>
                  <c:pt idx="8">
                    <c:v>1.1600627245978166</c:v>
                  </c:pt>
                  <c:pt idx="9">
                    <c:v>0.93906966644031331</c:v>
                  </c:pt>
                  <c:pt idx="10">
                    <c:v>1.2329475004849517</c:v>
                  </c:pt>
                  <c:pt idx="11">
                    <c:v>0.75914263073299759</c:v>
                  </c:pt>
                  <c:pt idx="12">
                    <c:v>0.81423405968035367</c:v>
                  </c:pt>
                  <c:pt idx="13">
                    <c:v>0.6450378524837409</c:v>
                  </c:pt>
                  <c:pt idx="14">
                    <c:v>0.88688929876633971</c:v>
                  </c:pt>
                  <c:pt idx="15">
                    <c:v>0.85921234732975504</c:v>
                  </c:pt>
                  <c:pt idx="16">
                    <c:v>1.9126897129740277</c:v>
                  </c:pt>
                  <c:pt idx="17">
                    <c:v>1.1652357806557747</c:v>
                  </c:pt>
                  <c:pt idx="18">
                    <c:v>0.58200576249262981</c:v>
                  </c:pt>
                  <c:pt idx="19">
                    <c:v>1.7441510276997765</c:v>
                  </c:pt>
                  <c:pt idx="20">
                    <c:v>1.4744834655470578</c:v>
                  </c:pt>
                  <c:pt idx="21">
                    <c:v>1.6394413230276381</c:v>
                  </c:pt>
                </c:numCache>
              </c:numRef>
            </c:plus>
            <c:minus>
              <c:numRef>
                <c:f>' Calculations'!$BQ$29:$BQ$50</c:f>
                <c:numCache>
                  <c:formatCode>General</c:formatCode>
                  <c:ptCount val="22"/>
                  <c:pt idx="0">
                    <c:v>2.0702293303456134</c:v>
                  </c:pt>
                  <c:pt idx="1">
                    <c:v>1.0205365248853915</c:v>
                  </c:pt>
                  <c:pt idx="2">
                    <c:v>1.6671149069516504</c:v>
                  </c:pt>
                  <c:pt idx="3">
                    <c:v>0.81674312836924079</c:v>
                  </c:pt>
                  <c:pt idx="4">
                    <c:v>1.5699564962042092</c:v>
                  </c:pt>
                  <c:pt idx="5">
                    <c:v>0.62422267067428683</c:v>
                  </c:pt>
                  <c:pt idx="6">
                    <c:v>1.3195953814092638</c:v>
                  </c:pt>
                  <c:pt idx="7">
                    <c:v>0.75416060826558351</c:v>
                  </c:pt>
                  <c:pt idx="8">
                    <c:v>1.1600627245978166</c:v>
                  </c:pt>
                  <c:pt idx="9">
                    <c:v>0.93906966644031331</c:v>
                  </c:pt>
                  <c:pt idx="10">
                    <c:v>1.2329475004849517</c:v>
                  </c:pt>
                  <c:pt idx="11">
                    <c:v>0.75914263073299759</c:v>
                  </c:pt>
                  <c:pt idx="12">
                    <c:v>0.81423405968035367</c:v>
                  </c:pt>
                  <c:pt idx="13">
                    <c:v>0.6450378524837409</c:v>
                  </c:pt>
                  <c:pt idx="14">
                    <c:v>0.88688929876633971</c:v>
                  </c:pt>
                  <c:pt idx="15">
                    <c:v>0.85921234732975504</c:v>
                  </c:pt>
                  <c:pt idx="16">
                    <c:v>1.9126897129740277</c:v>
                  </c:pt>
                  <c:pt idx="17">
                    <c:v>1.1652357806557747</c:v>
                  </c:pt>
                  <c:pt idx="18">
                    <c:v>0.58200576249262981</c:v>
                  </c:pt>
                  <c:pt idx="19">
                    <c:v>1.7441510276997765</c:v>
                  </c:pt>
                  <c:pt idx="20">
                    <c:v>1.4744834655470578</c:v>
                  </c:pt>
                  <c:pt idx="21">
                    <c:v>1.6394413230276381</c:v>
                  </c:pt>
                </c:numCache>
              </c:numRef>
            </c:minus>
            <c:spPr>
              <a:ln>
                <a:solidFill>
                  <a:srgbClr val="00B0F0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Q$4:$BQ$25</c:f>
              <c:numCache>
                <c:formatCode>General</c:formatCode>
                <c:ptCount val="22"/>
                <c:pt idx="0">
                  <c:v>105.22966885908851</c:v>
                </c:pt>
                <c:pt idx="1">
                  <c:v>102.21259220242078</c:v>
                </c:pt>
                <c:pt idx="2">
                  <c:v>100</c:v>
                </c:pt>
                <c:pt idx="3">
                  <c:v>105.77801986195345</c:v>
                </c:pt>
                <c:pt idx="4">
                  <c:v>107.33507611466058</c:v>
                </c:pt>
                <c:pt idx="5">
                  <c:v>108.11228067599829</c:v>
                </c:pt>
                <c:pt idx="6">
                  <c:v>110.67308226735106</c:v>
                </c:pt>
                <c:pt idx="7">
                  <c:v>114.11380196725412</c:v>
                </c:pt>
                <c:pt idx="8">
                  <c:v>115.00932686129973</c:v>
                </c:pt>
                <c:pt idx="9">
                  <c:v>116.43201042540699</c:v>
                </c:pt>
                <c:pt idx="10">
                  <c:v>117.91744014231134</c:v>
                </c:pt>
                <c:pt idx="11">
                  <c:v>116.92247322940898</c:v>
                </c:pt>
                <c:pt idx="12">
                  <c:v>119.19380775515029</c:v>
                </c:pt>
                <c:pt idx="13">
                  <c:v>127.1211486962157</c:v>
                </c:pt>
                <c:pt idx="14">
                  <c:v>122.56220862008369</c:v>
                </c:pt>
                <c:pt idx="15">
                  <c:v>124.41545403705172</c:v>
                </c:pt>
                <c:pt idx="16">
                  <c:v>120.46646477523086</c:v>
                </c:pt>
                <c:pt idx="17">
                  <c:v>120.49518466083111</c:v>
                </c:pt>
                <c:pt idx="18">
                  <c:v>122.06447796983042</c:v>
                </c:pt>
                <c:pt idx="19">
                  <c:v>123.85270635588527</c:v>
                </c:pt>
                <c:pt idx="20">
                  <c:v>127.40537502545963</c:v>
                </c:pt>
                <c:pt idx="21">
                  <c:v>122.199344031804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7E5-453E-869C-D91CCD2FCF40}"/>
            </c:ext>
          </c:extLst>
        </c:ser>
        <c:ser>
          <c:idx val="1"/>
          <c:order val="1"/>
          <c:tx>
            <c:strRef>
              <c:f>' Calculations'!$BR$3</c:f>
              <c:strCache>
                <c:ptCount val="1"/>
                <c:pt idx="0">
                  <c:v>5 µM UK5099</c:v>
                </c:pt>
              </c:strCache>
            </c:strRef>
          </c:tx>
          <c:spPr>
            <a:ln w="9525">
              <a:solidFill>
                <a:schemeClr val="accent2">
                  <a:lumMod val="75000"/>
                </a:schemeClr>
              </a:solidFill>
            </a:ln>
          </c:spPr>
          <c:marker>
            <c:symbol val="circle"/>
            <c:size val="4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R$29:$BR$50</c:f>
                <c:numCache>
                  <c:formatCode>General</c:formatCode>
                  <c:ptCount val="22"/>
                  <c:pt idx="0">
                    <c:v>2.4274671260527114</c:v>
                  </c:pt>
                  <c:pt idx="1">
                    <c:v>1.6000781606437136</c:v>
                  </c:pt>
                  <c:pt idx="2">
                    <c:v>1.2758867009107084</c:v>
                  </c:pt>
                  <c:pt idx="3">
                    <c:v>2.2954596620156713</c:v>
                  </c:pt>
                  <c:pt idx="4">
                    <c:v>1.5334879036175186</c:v>
                  </c:pt>
                  <c:pt idx="5">
                    <c:v>1.900385704505458</c:v>
                  </c:pt>
                  <c:pt idx="6">
                    <c:v>1.653957767975633</c:v>
                  </c:pt>
                  <c:pt idx="7">
                    <c:v>1.6445593351314503</c:v>
                  </c:pt>
                  <c:pt idx="8">
                    <c:v>1.3695956967229317</c:v>
                  </c:pt>
                  <c:pt idx="9">
                    <c:v>1.2445828684784743</c:v>
                  </c:pt>
                  <c:pt idx="10">
                    <c:v>1.9973403037537891</c:v>
                  </c:pt>
                  <c:pt idx="11">
                    <c:v>2.0632715960338484</c:v>
                  </c:pt>
                  <c:pt idx="12">
                    <c:v>1.6191641679656346</c:v>
                  </c:pt>
                  <c:pt idx="13">
                    <c:v>1.1576776627283771</c:v>
                  </c:pt>
                  <c:pt idx="14">
                    <c:v>1.4373177183341181</c:v>
                  </c:pt>
                  <c:pt idx="15">
                    <c:v>0.71746272002313716</c:v>
                  </c:pt>
                  <c:pt idx="16">
                    <c:v>1.1055410161255281</c:v>
                  </c:pt>
                  <c:pt idx="17">
                    <c:v>0.92464133979602781</c:v>
                  </c:pt>
                  <c:pt idx="18">
                    <c:v>1.2679655247128838</c:v>
                  </c:pt>
                  <c:pt idx="19">
                    <c:v>0.74121267133187185</c:v>
                  </c:pt>
                  <c:pt idx="20">
                    <c:v>1.8630314506964931</c:v>
                  </c:pt>
                  <c:pt idx="21">
                    <c:v>1.2453383598766057</c:v>
                  </c:pt>
                </c:numCache>
              </c:numRef>
            </c:plus>
            <c:minus>
              <c:numRef>
                <c:f>' Calculations'!$BR$29:$BR$50</c:f>
                <c:numCache>
                  <c:formatCode>General</c:formatCode>
                  <c:ptCount val="22"/>
                  <c:pt idx="0">
                    <c:v>2.4274671260527114</c:v>
                  </c:pt>
                  <c:pt idx="1">
                    <c:v>1.6000781606437136</c:v>
                  </c:pt>
                  <c:pt idx="2">
                    <c:v>1.2758867009107084</c:v>
                  </c:pt>
                  <c:pt idx="3">
                    <c:v>2.2954596620156713</c:v>
                  </c:pt>
                  <c:pt idx="4">
                    <c:v>1.5334879036175186</c:v>
                  </c:pt>
                  <c:pt idx="5">
                    <c:v>1.900385704505458</c:v>
                  </c:pt>
                  <c:pt idx="6">
                    <c:v>1.653957767975633</c:v>
                  </c:pt>
                  <c:pt idx="7">
                    <c:v>1.6445593351314503</c:v>
                  </c:pt>
                  <c:pt idx="8">
                    <c:v>1.3695956967229317</c:v>
                  </c:pt>
                  <c:pt idx="9">
                    <c:v>1.2445828684784743</c:v>
                  </c:pt>
                  <c:pt idx="10">
                    <c:v>1.9973403037537891</c:v>
                  </c:pt>
                  <c:pt idx="11">
                    <c:v>2.0632715960338484</c:v>
                  </c:pt>
                  <c:pt idx="12">
                    <c:v>1.6191641679656346</c:v>
                  </c:pt>
                  <c:pt idx="13">
                    <c:v>1.1576776627283771</c:v>
                  </c:pt>
                  <c:pt idx="14">
                    <c:v>1.4373177183341181</c:v>
                  </c:pt>
                  <c:pt idx="15">
                    <c:v>0.71746272002313716</c:v>
                  </c:pt>
                  <c:pt idx="16">
                    <c:v>1.1055410161255281</c:v>
                  </c:pt>
                  <c:pt idx="17">
                    <c:v>0.92464133979602781</c:v>
                  </c:pt>
                  <c:pt idx="18">
                    <c:v>1.2679655247128838</c:v>
                  </c:pt>
                  <c:pt idx="19">
                    <c:v>0.74121267133187185</c:v>
                  </c:pt>
                  <c:pt idx="20">
                    <c:v>1.8630314506964931</c:v>
                  </c:pt>
                  <c:pt idx="21">
                    <c:v>1.2453383598766057</c:v>
                  </c:pt>
                </c:numCache>
              </c:numRef>
            </c:minus>
            <c:spPr>
              <a:ln>
                <a:solidFill>
                  <a:schemeClr val="accent2">
                    <a:lumMod val="75000"/>
                  </a:schemeClr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R$4:$BR$25</c:f>
              <c:numCache>
                <c:formatCode>General</c:formatCode>
                <c:ptCount val="22"/>
                <c:pt idx="0">
                  <c:v>99.087500197137885</c:v>
                </c:pt>
                <c:pt idx="1">
                  <c:v>99.9541568058781</c:v>
                </c:pt>
                <c:pt idx="2">
                  <c:v>100</c:v>
                </c:pt>
                <c:pt idx="3">
                  <c:v>152.20988931814156</c:v>
                </c:pt>
                <c:pt idx="4">
                  <c:v>147.64498024644371</c:v>
                </c:pt>
                <c:pt idx="5">
                  <c:v>150.72047750596681</c:v>
                </c:pt>
                <c:pt idx="6">
                  <c:v>152.00642117264576</c:v>
                </c:pt>
                <c:pt idx="7">
                  <c:v>154.59666331565086</c:v>
                </c:pt>
                <c:pt idx="8">
                  <c:v>156.04572319795298</c:v>
                </c:pt>
                <c:pt idx="9">
                  <c:v>155.11559693938653</c:v>
                </c:pt>
                <c:pt idx="10">
                  <c:v>160.08220335697359</c:v>
                </c:pt>
                <c:pt idx="11">
                  <c:v>159.69702725348444</c:v>
                </c:pt>
                <c:pt idx="12">
                  <c:v>165.12636065261859</c:v>
                </c:pt>
                <c:pt idx="13">
                  <c:v>164.96517884383263</c:v>
                </c:pt>
                <c:pt idx="14">
                  <c:v>164.36806894069477</c:v>
                </c:pt>
                <c:pt idx="15">
                  <c:v>166.64408717413502</c:v>
                </c:pt>
                <c:pt idx="16">
                  <c:v>169.56157019061385</c:v>
                </c:pt>
                <c:pt idx="17">
                  <c:v>168.39249926032582</c:v>
                </c:pt>
                <c:pt idx="18">
                  <c:v>169.55336781259766</c:v>
                </c:pt>
                <c:pt idx="19">
                  <c:v>169.78465328436076</c:v>
                </c:pt>
                <c:pt idx="20">
                  <c:v>171.59607819937216</c:v>
                </c:pt>
                <c:pt idx="21">
                  <c:v>176.486968505412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7E5-453E-869C-D91CCD2FCF40}"/>
            </c:ext>
          </c:extLst>
        </c:ser>
        <c:ser>
          <c:idx val="2"/>
          <c:order val="2"/>
          <c:tx>
            <c:strRef>
              <c:f>' Calculations'!$BS$3</c:f>
              <c:strCache>
                <c:ptCount val="1"/>
                <c:pt idx="0">
                  <c:v>10 µM Carprofen</c:v>
                </c:pt>
              </c:strCache>
            </c:strRef>
          </c:tx>
          <c:spPr>
            <a:ln w="9525"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S$29:$BS$50</c:f>
                <c:numCache>
                  <c:formatCode>General</c:formatCode>
                  <c:ptCount val="22"/>
                  <c:pt idx="0">
                    <c:v>3.7495709138770925</c:v>
                  </c:pt>
                  <c:pt idx="1">
                    <c:v>2.3178282533080252</c:v>
                  </c:pt>
                  <c:pt idx="2">
                    <c:v>2.0057115389680207</c:v>
                  </c:pt>
                  <c:pt idx="3">
                    <c:v>2.7573437477033997</c:v>
                  </c:pt>
                  <c:pt idx="4">
                    <c:v>2.4656991854687975</c:v>
                  </c:pt>
                  <c:pt idx="5">
                    <c:v>1.8222079230004469</c:v>
                  </c:pt>
                  <c:pt idx="6">
                    <c:v>2.6536035795817958</c:v>
                  </c:pt>
                  <c:pt idx="7">
                    <c:v>1.7089179837987054</c:v>
                  </c:pt>
                  <c:pt idx="8">
                    <c:v>0.74740996129203507</c:v>
                  </c:pt>
                  <c:pt idx="9">
                    <c:v>1.7544907734444399</c:v>
                  </c:pt>
                  <c:pt idx="10">
                    <c:v>1.3105173657162836</c:v>
                  </c:pt>
                  <c:pt idx="11">
                    <c:v>0.78598418014449811</c:v>
                  </c:pt>
                  <c:pt idx="12">
                    <c:v>1.646064386007497</c:v>
                  </c:pt>
                  <c:pt idx="13">
                    <c:v>1.7907981063362906</c:v>
                  </c:pt>
                  <c:pt idx="14">
                    <c:v>0.73776671215444889</c:v>
                  </c:pt>
                  <c:pt idx="15">
                    <c:v>0.65271278004144251</c:v>
                  </c:pt>
                  <c:pt idx="16">
                    <c:v>1.6723820726695908</c:v>
                  </c:pt>
                  <c:pt idx="17">
                    <c:v>1.5839467274237975</c:v>
                  </c:pt>
                  <c:pt idx="18">
                    <c:v>1.3839051959408717</c:v>
                  </c:pt>
                  <c:pt idx="19">
                    <c:v>0.89075437064436691</c:v>
                  </c:pt>
                  <c:pt idx="20">
                    <c:v>1.0658183058970685</c:v>
                  </c:pt>
                  <c:pt idx="21">
                    <c:v>2.0269634843546358</c:v>
                  </c:pt>
                </c:numCache>
              </c:numRef>
            </c:plus>
            <c:minus>
              <c:numRef>
                <c:f>' Calculations'!$BS$29:$BS$50</c:f>
                <c:numCache>
                  <c:formatCode>General</c:formatCode>
                  <c:ptCount val="22"/>
                  <c:pt idx="0">
                    <c:v>3.7495709138770925</c:v>
                  </c:pt>
                  <c:pt idx="1">
                    <c:v>2.3178282533080252</c:v>
                  </c:pt>
                  <c:pt idx="2">
                    <c:v>2.0057115389680207</c:v>
                  </c:pt>
                  <c:pt idx="3">
                    <c:v>2.7573437477033997</c:v>
                  </c:pt>
                  <c:pt idx="4">
                    <c:v>2.4656991854687975</c:v>
                  </c:pt>
                  <c:pt idx="5">
                    <c:v>1.8222079230004469</c:v>
                  </c:pt>
                  <c:pt idx="6">
                    <c:v>2.6536035795817958</c:v>
                  </c:pt>
                  <c:pt idx="7">
                    <c:v>1.7089179837987054</c:v>
                  </c:pt>
                  <c:pt idx="8">
                    <c:v>0.74740996129203507</c:v>
                  </c:pt>
                  <c:pt idx="9">
                    <c:v>1.7544907734444399</c:v>
                  </c:pt>
                  <c:pt idx="10">
                    <c:v>1.3105173657162836</c:v>
                  </c:pt>
                  <c:pt idx="11">
                    <c:v>0.78598418014449811</c:v>
                  </c:pt>
                  <c:pt idx="12">
                    <c:v>1.646064386007497</c:v>
                  </c:pt>
                  <c:pt idx="13">
                    <c:v>1.7907981063362906</c:v>
                  </c:pt>
                  <c:pt idx="14">
                    <c:v>0.73776671215444889</c:v>
                  </c:pt>
                  <c:pt idx="15">
                    <c:v>0.65271278004144251</c:v>
                  </c:pt>
                  <c:pt idx="16">
                    <c:v>1.6723820726695908</c:v>
                  </c:pt>
                  <c:pt idx="17">
                    <c:v>1.5839467274237975</c:v>
                  </c:pt>
                  <c:pt idx="18">
                    <c:v>1.3839051959408717</c:v>
                  </c:pt>
                  <c:pt idx="19">
                    <c:v>0.89075437064436691</c:v>
                  </c:pt>
                  <c:pt idx="20">
                    <c:v>1.0658183058970685</c:v>
                  </c:pt>
                  <c:pt idx="21">
                    <c:v>2.0269634843546358</c:v>
                  </c:pt>
                </c:numCache>
              </c:numRef>
            </c:minus>
            <c:spPr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S$4:$BS$25</c:f>
              <c:numCache>
                <c:formatCode>General</c:formatCode>
                <c:ptCount val="22"/>
                <c:pt idx="0">
                  <c:v>99.689602623520983</c:v>
                </c:pt>
                <c:pt idx="1">
                  <c:v>96.709358443067856</c:v>
                </c:pt>
                <c:pt idx="2">
                  <c:v>100</c:v>
                </c:pt>
                <c:pt idx="3">
                  <c:v>116.75551155449342</c:v>
                </c:pt>
                <c:pt idx="4">
                  <c:v>117.06284044212421</c:v>
                </c:pt>
                <c:pt idx="5">
                  <c:v>118.76510854780899</c:v>
                </c:pt>
                <c:pt idx="6">
                  <c:v>119.80458132545013</c:v>
                </c:pt>
                <c:pt idx="7">
                  <c:v>117.58661258345309</c:v>
                </c:pt>
                <c:pt idx="8">
                  <c:v>116.93045335753953</c:v>
                </c:pt>
                <c:pt idx="9">
                  <c:v>120.96954821593189</c:v>
                </c:pt>
                <c:pt idx="10">
                  <c:v>118.42456182274282</c:v>
                </c:pt>
                <c:pt idx="11">
                  <c:v>117.02507975260991</c:v>
                </c:pt>
                <c:pt idx="12">
                  <c:v>123.93578296828618</c:v>
                </c:pt>
                <c:pt idx="13">
                  <c:v>122.80578786470555</c:v>
                </c:pt>
                <c:pt idx="14">
                  <c:v>122.50986620531523</c:v>
                </c:pt>
                <c:pt idx="15">
                  <c:v>124.32903615718607</c:v>
                </c:pt>
                <c:pt idx="16">
                  <c:v>121.54373759744111</c:v>
                </c:pt>
                <c:pt idx="17">
                  <c:v>122.50820838069309</c:v>
                </c:pt>
                <c:pt idx="18">
                  <c:v>122.57563722341011</c:v>
                </c:pt>
                <c:pt idx="19">
                  <c:v>124.6250128250033</c:v>
                </c:pt>
                <c:pt idx="20">
                  <c:v>125.74346391385951</c:v>
                </c:pt>
                <c:pt idx="21">
                  <c:v>126.136526706764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7E5-453E-869C-D91CCD2FCF40}"/>
            </c:ext>
          </c:extLst>
        </c:ser>
        <c:ser>
          <c:idx val="3"/>
          <c:order val="3"/>
          <c:tx>
            <c:strRef>
              <c:f>' Calculations'!$BT$3</c:f>
              <c:strCache>
                <c:ptCount val="1"/>
                <c:pt idx="0">
                  <c:v>10 µM Telmisartan</c:v>
                </c:pt>
              </c:strCache>
            </c:strRef>
          </c:tx>
          <c:spPr>
            <a:ln w="9525">
              <a:solidFill>
                <a:schemeClr val="accent2">
                  <a:lumMod val="40000"/>
                  <a:lumOff val="60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accent2">
                  <a:lumMod val="40000"/>
                  <a:lumOff val="60000"/>
                </a:schemeClr>
              </a:solidFill>
              <a:ln w="9525">
                <a:solidFill>
                  <a:schemeClr val="accent2">
                    <a:lumMod val="40000"/>
                    <a:lumOff val="6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T$29:$BT$50</c:f>
                <c:numCache>
                  <c:formatCode>General</c:formatCode>
                  <c:ptCount val="22"/>
                  <c:pt idx="0">
                    <c:v>1.4788784458265547</c:v>
                  </c:pt>
                  <c:pt idx="1">
                    <c:v>1.446259666704917</c:v>
                  </c:pt>
                  <c:pt idx="2">
                    <c:v>2.0228036735879895</c:v>
                  </c:pt>
                  <c:pt idx="3">
                    <c:v>1.3926679858147255</c:v>
                  </c:pt>
                  <c:pt idx="4">
                    <c:v>1.9242224852022167</c:v>
                  </c:pt>
                  <c:pt idx="5">
                    <c:v>1.4911989925441718</c:v>
                  </c:pt>
                  <c:pt idx="6">
                    <c:v>1.9339503492814096</c:v>
                  </c:pt>
                  <c:pt idx="7">
                    <c:v>1.0796168097733467</c:v>
                  </c:pt>
                  <c:pt idx="8">
                    <c:v>1.5645236118709729</c:v>
                  </c:pt>
                  <c:pt idx="9">
                    <c:v>1.8534856313095087</c:v>
                  </c:pt>
                  <c:pt idx="10">
                    <c:v>2.0279457125526856</c:v>
                  </c:pt>
                  <c:pt idx="11">
                    <c:v>0.91724717443210857</c:v>
                  </c:pt>
                  <c:pt idx="12">
                    <c:v>1.4612811646438335</c:v>
                  </c:pt>
                  <c:pt idx="13">
                    <c:v>2.0101838260570242</c:v>
                  </c:pt>
                  <c:pt idx="14">
                    <c:v>1.4974683522994219</c:v>
                  </c:pt>
                  <c:pt idx="15">
                    <c:v>1.6829516579897705</c:v>
                  </c:pt>
                  <c:pt idx="16">
                    <c:v>1.6523969826224196</c:v>
                  </c:pt>
                  <c:pt idx="17">
                    <c:v>1.3767444209044384</c:v>
                  </c:pt>
                  <c:pt idx="18">
                    <c:v>1.5318681215122985</c:v>
                  </c:pt>
                  <c:pt idx="19">
                    <c:v>1.623628806396193</c:v>
                  </c:pt>
                  <c:pt idx="20">
                    <c:v>1.0959152261248151</c:v>
                  </c:pt>
                  <c:pt idx="21">
                    <c:v>0.92114085255705325</c:v>
                  </c:pt>
                </c:numCache>
              </c:numRef>
            </c:plus>
            <c:minus>
              <c:numRef>
                <c:f>' Calculations'!$BT$29:$BT$50</c:f>
                <c:numCache>
                  <c:formatCode>General</c:formatCode>
                  <c:ptCount val="22"/>
                  <c:pt idx="0">
                    <c:v>1.4788784458265547</c:v>
                  </c:pt>
                  <c:pt idx="1">
                    <c:v>1.446259666704917</c:v>
                  </c:pt>
                  <c:pt idx="2">
                    <c:v>2.0228036735879895</c:v>
                  </c:pt>
                  <c:pt idx="3">
                    <c:v>1.3926679858147255</c:v>
                  </c:pt>
                  <c:pt idx="4">
                    <c:v>1.9242224852022167</c:v>
                  </c:pt>
                  <c:pt idx="5">
                    <c:v>1.4911989925441718</c:v>
                  </c:pt>
                  <c:pt idx="6">
                    <c:v>1.9339503492814096</c:v>
                  </c:pt>
                  <c:pt idx="7">
                    <c:v>1.0796168097733467</c:v>
                  </c:pt>
                  <c:pt idx="8">
                    <c:v>1.5645236118709729</c:v>
                  </c:pt>
                  <c:pt idx="9">
                    <c:v>1.8534856313095087</c:v>
                  </c:pt>
                  <c:pt idx="10">
                    <c:v>2.0279457125526856</c:v>
                  </c:pt>
                  <c:pt idx="11">
                    <c:v>0.91724717443210857</c:v>
                  </c:pt>
                  <c:pt idx="12">
                    <c:v>1.4612811646438335</c:v>
                  </c:pt>
                  <c:pt idx="13">
                    <c:v>2.0101838260570242</c:v>
                  </c:pt>
                  <c:pt idx="14">
                    <c:v>1.4974683522994219</c:v>
                  </c:pt>
                  <c:pt idx="15">
                    <c:v>1.6829516579897705</c:v>
                  </c:pt>
                  <c:pt idx="16">
                    <c:v>1.6523969826224196</c:v>
                  </c:pt>
                  <c:pt idx="17">
                    <c:v>1.3767444209044384</c:v>
                  </c:pt>
                  <c:pt idx="18">
                    <c:v>1.5318681215122985</c:v>
                  </c:pt>
                  <c:pt idx="19">
                    <c:v>1.623628806396193</c:v>
                  </c:pt>
                  <c:pt idx="20">
                    <c:v>1.0959152261248151</c:v>
                  </c:pt>
                  <c:pt idx="21">
                    <c:v>0.92114085255705325</c:v>
                  </c:pt>
                </c:numCache>
              </c:numRef>
            </c:minus>
            <c:spPr>
              <a:ln>
                <a:solidFill>
                  <a:schemeClr val="accent2">
                    <a:lumMod val="40000"/>
                    <a:lumOff val="60000"/>
                  </a:schemeClr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T$4:$BT$25</c:f>
              <c:numCache>
                <c:formatCode>General</c:formatCode>
                <c:ptCount val="22"/>
                <c:pt idx="0">
                  <c:v>94.107764062546764</c:v>
                </c:pt>
                <c:pt idx="1">
                  <c:v>97.814657729935291</c:v>
                </c:pt>
                <c:pt idx="2">
                  <c:v>100</c:v>
                </c:pt>
                <c:pt idx="3">
                  <c:v>113.04999829471105</c:v>
                </c:pt>
                <c:pt idx="4">
                  <c:v>112.04329912420059</c:v>
                </c:pt>
                <c:pt idx="5">
                  <c:v>113.70025415070859</c:v>
                </c:pt>
                <c:pt idx="6">
                  <c:v>114.72484419166109</c:v>
                </c:pt>
                <c:pt idx="7">
                  <c:v>115.7583186047916</c:v>
                </c:pt>
                <c:pt idx="8">
                  <c:v>114.78751255985647</c:v>
                </c:pt>
                <c:pt idx="9">
                  <c:v>116.26991074303798</c:v>
                </c:pt>
                <c:pt idx="10">
                  <c:v>118.75524309100905</c:v>
                </c:pt>
                <c:pt idx="11">
                  <c:v>123.84215087004546</c:v>
                </c:pt>
                <c:pt idx="12">
                  <c:v>118.71958568749569</c:v>
                </c:pt>
                <c:pt idx="13">
                  <c:v>121.47375187718146</c:v>
                </c:pt>
                <c:pt idx="14">
                  <c:v>122.11551779982712</c:v>
                </c:pt>
                <c:pt idx="15">
                  <c:v>125.56861055412136</c:v>
                </c:pt>
                <c:pt idx="16">
                  <c:v>123.0156862606927</c:v>
                </c:pt>
                <c:pt idx="17">
                  <c:v>124.07880466722897</c:v>
                </c:pt>
                <c:pt idx="18">
                  <c:v>126.08649254555955</c:v>
                </c:pt>
                <c:pt idx="19">
                  <c:v>126.7829795383814</c:v>
                </c:pt>
                <c:pt idx="20">
                  <c:v>132.22693592884883</c:v>
                </c:pt>
                <c:pt idx="21">
                  <c:v>127.805711442282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7E5-453E-869C-D91CCD2FCF40}"/>
            </c:ext>
          </c:extLst>
        </c:ser>
        <c:ser>
          <c:idx val="4"/>
          <c:order val="4"/>
          <c:tx>
            <c:strRef>
              <c:f>' Calculations'!$BU$3</c:f>
              <c:strCache>
                <c:ptCount val="1"/>
                <c:pt idx="0">
                  <c:v>10 µM Zaprinast</c:v>
                </c:pt>
              </c:strCache>
            </c:strRef>
          </c:tx>
          <c:spPr>
            <a:ln w="952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U$29:$BU$50</c:f>
                <c:numCache>
                  <c:formatCode>General</c:formatCode>
                  <c:ptCount val="22"/>
                  <c:pt idx="0">
                    <c:v>3.2297106448130641</c:v>
                  </c:pt>
                  <c:pt idx="1">
                    <c:v>1.9039541009034817</c:v>
                  </c:pt>
                  <c:pt idx="2">
                    <c:v>1.0578504528764843</c:v>
                  </c:pt>
                  <c:pt idx="3">
                    <c:v>1.0142730159005693</c:v>
                  </c:pt>
                  <c:pt idx="4">
                    <c:v>0.63172903642345568</c:v>
                  </c:pt>
                  <c:pt idx="5">
                    <c:v>0.6157398349606491</c:v>
                  </c:pt>
                  <c:pt idx="6">
                    <c:v>0.38707963524563738</c:v>
                  </c:pt>
                  <c:pt idx="7">
                    <c:v>0.43962614887358487</c:v>
                  </c:pt>
                  <c:pt idx="8">
                    <c:v>0.94266533513977913</c:v>
                  </c:pt>
                  <c:pt idx="9">
                    <c:v>0.89322877069821349</c:v>
                  </c:pt>
                  <c:pt idx="10">
                    <c:v>1.0047909826063506</c:v>
                  </c:pt>
                  <c:pt idx="11">
                    <c:v>0.57676998102266486</c:v>
                  </c:pt>
                  <c:pt idx="12">
                    <c:v>0.40421480739843985</c:v>
                  </c:pt>
                  <c:pt idx="13">
                    <c:v>1.1652690525339029</c:v>
                  </c:pt>
                  <c:pt idx="14">
                    <c:v>0.55238784306951305</c:v>
                  </c:pt>
                  <c:pt idx="15">
                    <c:v>0.92636889587177518</c:v>
                  </c:pt>
                  <c:pt idx="16">
                    <c:v>1.1969093827389004</c:v>
                  </c:pt>
                  <c:pt idx="17">
                    <c:v>1.6114478886836057</c:v>
                  </c:pt>
                  <c:pt idx="18">
                    <c:v>0.8016682922806152</c:v>
                  </c:pt>
                  <c:pt idx="19">
                    <c:v>0.84770653567847742</c:v>
                  </c:pt>
                  <c:pt idx="20">
                    <c:v>0.87765298624001498</c:v>
                  </c:pt>
                  <c:pt idx="21">
                    <c:v>1.3639033041008579</c:v>
                  </c:pt>
                </c:numCache>
              </c:numRef>
            </c:plus>
            <c:minus>
              <c:numRef>
                <c:f>' Calculations'!$BU$29:$BU$50</c:f>
                <c:numCache>
                  <c:formatCode>General</c:formatCode>
                  <c:ptCount val="22"/>
                  <c:pt idx="0">
                    <c:v>3.2297106448130641</c:v>
                  </c:pt>
                  <c:pt idx="1">
                    <c:v>1.9039541009034817</c:v>
                  </c:pt>
                  <c:pt idx="2">
                    <c:v>1.0578504528764843</c:v>
                  </c:pt>
                  <c:pt idx="3">
                    <c:v>1.0142730159005693</c:v>
                  </c:pt>
                  <c:pt idx="4">
                    <c:v>0.63172903642345568</c:v>
                  </c:pt>
                  <c:pt idx="5">
                    <c:v>0.6157398349606491</c:v>
                  </c:pt>
                  <c:pt idx="6">
                    <c:v>0.38707963524563738</c:v>
                  </c:pt>
                  <c:pt idx="7">
                    <c:v>0.43962614887358487</c:v>
                  </c:pt>
                  <c:pt idx="8">
                    <c:v>0.94266533513977913</c:v>
                  </c:pt>
                  <c:pt idx="9">
                    <c:v>0.89322877069821349</c:v>
                  </c:pt>
                  <c:pt idx="10">
                    <c:v>1.0047909826063506</c:v>
                  </c:pt>
                  <c:pt idx="11">
                    <c:v>0.57676998102266486</c:v>
                  </c:pt>
                  <c:pt idx="12">
                    <c:v>0.40421480739843985</c:v>
                  </c:pt>
                  <c:pt idx="13">
                    <c:v>1.1652690525339029</c:v>
                  </c:pt>
                  <c:pt idx="14">
                    <c:v>0.55238784306951305</c:v>
                  </c:pt>
                  <c:pt idx="15">
                    <c:v>0.92636889587177518</c:v>
                  </c:pt>
                  <c:pt idx="16">
                    <c:v>1.1969093827389004</c:v>
                  </c:pt>
                  <c:pt idx="17">
                    <c:v>1.6114478886836057</c:v>
                  </c:pt>
                  <c:pt idx="18">
                    <c:v>0.8016682922806152</c:v>
                  </c:pt>
                  <c:pt idx="19">
                    <c:v>0.84770653567847742</c:v>
                  </c:pt>
                  <c:pt idx="20">
                    <c:v>0.87765298624001498</c:v>
                  </c:pt>
                  <c:pt idx="21">
                    <c:v>1.3639033041008579</c:v>
                  </c:pt>
                </c:numCache>
              </c:numRef>
            </c:minus>
            <c:spPr>
              <a:ln>
                <a:solidFill>
                  <a:srgbClr val="00B050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U$4:$BU$25</c:f>
              <c:numCache>
                <c:formatCode>General</c:formatCode>
                <c:ptCount val="22"/>
                <c:pt idx="0">
                  <c:v>98.400653236553396</c:v>
                </c:pt>
                <c:pt idx="1">
                  <c:v>97.54283271862792</c:v>
                </c:pt>
                <c:pt idx="2">
                  <c:v>100</c:v>
                </c:pt>
                <c:pt idx="3">
                  <c:v>145.2561146837503</c:v>
                </c:pt>
                <c:pt idx="4">
                  <c:v>142.74200775763285</c:v>
                </c:pt>
                <c:pt idx="5">
                  <c:v>145.75318755187249</c:v>
                </c:pt>
                <c:pt idx="6">
                  <c:v>149.31045291057916</c:v>
                </c:pt>
                <c:pt idx="7">
                  <c:v>150.00239660722352</c:v>
                </c:pt>
                <c:pt idx="8">
                  <c:v>151.33624712091677</c:v>
                </c:pt>
                <c:pt idx="9">
                  <c:v>155.59777598301457</c:v>
                </c:pt>
                <c:pt idx="10">
                  <c:v>154.29145824586067</c:v>
                </c:pt>
                <c:pt idx="11">
                  <c:v>157.50182406876857</c:v>
                </c:pt>
                <c:pt idx="12">
                  <c:v>159.54056999410565</c:v>
                </c:pt>
                <c:pt idx="13">
                  <c:v>159.77430876359082</c:v>
                </c:pt>
                <c:pt idx="14">
                  <c:v>163.81639721427734</c:v>
                </c:pt>
                <c:pt idx="15">
                  <c:v>169.00629848186156</c:v>
                </c:pt>
                <c:pt idx="16">
                  <c:v>165.84823289064209</c:v>
                </c:pt>
                <c:pt idx="17">
                  <c:v>165.60281981648018</c:v>
                </c:pt>
                <c:pt idx="18">
                  <c:v>170.16746895845222</c:v>
                </c:pt>
                <c:pt idx="19">
                  <c:v>171.15209160930738</c:v>
                </c:pt>
                <c:pt idx="20">
                  <c:v>176.05429553101416</c:v>
                </c:pt>
                <c:pt idx="21">
                  <c:v>172.015995649654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C7E5-453E-869C-D91CCD2FCF40}"/>
            </c:ext>
          </c:extLst>
        </c:ser>
        <c:ser>
          <c:idx val="5"/>
          <c:order val="5"/>
          <c:tx>
            <c:strRef>
              <c:f>' Calculations'!$BV$3</c:f>
              <c:strCache>
                <c:ptCount val="1"/>
                <c:pt idx="0">
                  <c:v>10 µM Dantrolene Sodium Salt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star"/>
            <c:size val="4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V$29:$BV$50</c:f>
                <c:numCache>
                  <c:formatCode>General</c:formatCode>
                  <c:ptCount val="22"/>
                  <c:pt idx="0">
                    <c:v>0.9782283723857732</c:v>
                  </c:pt>
                  <c:pt idx="1">
                    <c:v>1.1605530470033054</c:v>
                  </c:pt>
                  <c:pt idx="2">
                    <c:v>1.7745605685051353</c:v>
                  </c:pt>
                  <c:pt idx="3">
                    <c:v>0.4194037731299789</c:v>
                  </c:pt>
                  <c:pt idx="4">
                    <c:v>0.932455475678302</c:v>
                  </c:pt>
                  <c:pt idx="5">
                    <c:v>1.5094743839891263</c:v>
                  </c:pt>
                  <c:pt idx="6">
                    <c:v>0.90913309504572271</c:v>
                  </c:pt>
                  <c:pt idx="7">
                    <c:v>0.69472507913482628</c:v>
                  </c:pt>
                  <c:pt idx="8">
                    <c:v>0.83990890114807193</c:v>
                  </c:pt>
                  <c:pt idx="9">
                    <c:v>0.64663115057104936</c:v>
                  </c:pt>
                  <c:pt idx="10">
                    <c:v>0.82725519162633576</c:v>
                  </c:pt>
                  <c:pt idx="11">
                    <c:v>0.99235505743525076</c:v>
                  </c:pt>
                  <c:pt idx="12">
                    <c:v>1.3580312375621515</c:v>
                  </c:pt>
                  <c:pt idx="13">
                    <c:v>1.1067754041970415</c:v>
                  </c:pt>
                  <c:pt idx="14">
                    <c:v>0.39789541301016834</c:v>
                  </c:pt>
                  <c:pt idx="15">
                    <c:v>1.7467328456481104</c:v>
                  </c:pt>
                  <c:pt idx="16">
                    <c:v>1.1738993424119561</c:v>
                  </c:pt>
                  <c:pt idx="17">
                    <c:v>0.74422934320114842</c:v>
                  </c:pt>
                  <c:pt idx="18">
                    <c:v>1.1004234177842585</c:v>
                  </c:pt>
                  <c:pt idx="19">
                    <c:v>1.1780030300272286</c:v>
                  </c:pt>
                  <c:pt idx="20">
                    <c:v>1.6195985971823419</c:v>
                  </c:pt>
                  <c:pt idx="21">
                    <c:v>1.5215586154076806</c:v>
                  </c:pt>
                </c:numCache>
              </c:numRef>
            </c:plus>
            <c:minus>
              <c:numRef>
                <c:f>' Calculations'!$BV$29:$BV$50</c:f>
                <c:numCache>
                  <c:formatCode>General</c:formatCode>
                  <c:ptCount val="22"/>
                  <c:pt idx="0">
                    <c:v>0.9782283723857732</c:v>
                  </c:pt>
                  <c:pt idx="1">
                    <c:v>1.1605530470033054</c:v>
                  </c:pt>
                  <c:pt idx="2">
                    <c:v>1.7745605685051353</c:v>
                  </c:pt>
                  <c:pt idx="3">
                    <c:v>0.4194037731299789</c:v>
                  </c:pt>
                  <c:pt idx="4">
                    <c:v>0.932455475678302</c:v>
                  </c:pt>
                  <c:pt idx="5">
                    <c:v>1.5094743839891263</c:v>
                  </c:pt>
                  <c:pt idx="6">
                    <c:v>0.90913309504572271</c:v>
                  </c:pt>
                  <c:pt idx="7">
                    <c:v>0.69472507913482628</c:v>
                  </c:pt>
                  <c:pt idx="8">
                    <c:v>0.83990890114807193</c:v>
                  </c:pt>
                  <c:pt idx="9">
                    <c:v>0.64663115057104936</c:v>
                  </c:pt>
                  <c:pt idx="10">
                    <c:v>0.82725519162633576</c:v>
                  </c:pt>
                  <c:pt idx="11">
                    <c:v>0.99235505743525076</c:v>
                  </c:pt>
                  <c:pt idx="12">
                    <c:v>1.3580312375621515</c:v>
                  </c:pt>
                  <c:pt idx="13">
                    <c:v>1.1067754041970415</c:v>
                  </c:pt>
                  <c:pt idx="14">
                    <c:v>0.39789541301016834</c:v>
                  </c:pt>
                  <c:pt idx="15">
                    <c:v>1.7467328456481104</c:v>
                  </c:pt>
                  <c:pt idx="16">
                    <c:v>1.1738993424119561</c:v>
                  </c:pt>
                  <c:pt idx="17">
                    <c:v>0.74422934320114842</c:v>
                  </c:pt>
                  <c:pt idx="18">
                    <c:v>1.1004234177842585</c:v>
                  </c:pt>
                  <c:pt idx="19">
                    <c:v>1.1780030300272286</c:v>
                  </c:pt>
                  <c:pt idx="20">
                    <c:v>1.6195985971823419</c:v>
                  </c:pt>
                  <c:pt idx="21">
                    <c:v>1.5215586154076806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V$4:$BV$25</c:f>
              <c:numCache>
                <c:formatCode>General</c:formatCode>
                <c:ptCount val="22"/>
                <c:pt idx="0">
                  <c:v>103.20076596028147</c:v>
                </c:pt>
                <c:pt idx="1">
                  <c:v>99.757034070507828</c:v>
                </c:pt>
                <c:pt idx="2">
                  <c:v>100</c:v>
                </c:pt>
                <c:pt idx="3">
                  <c:v>139.81039222647664</c:v>
                </c:pt>
                <c:pt idx="4">
                  <c:v>140.53587741249865</c:v>
                </c:pt>
                <c:pt idx="5">
                  <c:v>136.56242315290473</c:v>
                </c:pt>
                <c:pt idx="6">
                  <c:v>139.77220508528495</c:v>
                </c:pt>
                <c:pt idx="7">
                  <c:v>142.41036114189569</c:v>
                </c:pt>
                <c:pt idx="8">
                  <c:v>145.1397514326581</c:v>
                </c:pt>
                <c:pt idx="9">
                  <c:v>148.63632220477015</c:v>
                </c:pt>
                <c:pt idx="10">
                  <c:v>143.81901121641732</c:v>
                </c:pt>
                <c:pt idx="11">
                  <c:v>149.90431723168012</c:v>
                </c:pt>
                <c:pt idx="12">
                  <c:v>149.67315002991563</c:v>
                </c:pt>
                <c:pt idx="13">
                  <c:v>153.02781716841764</c:v>
                </c:pt>
                <c:pt idx="14">
                  <c:v>155.95838465140673</c:v>
                </c:pt>
                <c:pt idx="15">
                  <c:v>159.28309273763142</c:v>
                </c:pt>
                <c:pt idx="16">
                  <c:v>157.44356635311289</c:v>
                </c:pt>
                <c:pt idx="17">
                  <c:v>161.68964776043623</c:v>
                </c:pt>
                <c:pt idx="18">
                  <c:v>160.7854166924653</c:v>
                </c:pt>
                <c:pt idx="19">
                  <c:v>164.41748648837719</c:v>
                </c:pt>
                <c:pt idx="20">
                  <c:v>160.08488514654837</c:v>
                </c:pt>
                <c:pt idx="21">
                  <c:v>166.053677108874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C7E5-453E-869C-D91CCD2FCF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50892048"/>
        <c:axId val="-850891504"/>
      </c:scatterChart>
      <c:valAx>
        <c:axId val="-8508920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-850891504"/>
        <c:crosses val="autoZero"/>
        <c:crossBetween val="midCat"/>
      </c:valAx>
      <c:valAx>
        <c:axId val="-850891504"/>
        <c:scaling>
          <c:orientation val="minMax"/>
          <c:min val="9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BRET (% of basa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-85089204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70618275879735604"/>
          <c:y val="1.9991635602247967E-2"/>
          <c:w val="0.29133379717028174"/>
          <c:h val="0.86794446511126322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570805072331675"/>
          <c:y val="0.11922278893222824"/>
          <c:w val="0.69818697221581361"/>
          <c:h val="0.78746728172289016"/>
        </c:manualLayout>
      </c:layout>
      <c:scatterChart>
        <c:scatterStyle val="lineMarker"/>
        <c:varyColors val="0"/>
        <c:ser>
          <c:idx val="0"/>
          <c:order val="0"/>
          <c:tx>
            <c:strRef>
              <c:f>' Calculations'!$BQ$3</c:f>
              <c:strCache>
                <c:ptCount val="1"/>
                <c:pt idx="0">
                  <c:v>DMSO</c:v>
                </c:pt>
              </c:strCache>
            </c:strRef>
          </c:tx>
          <c:spPr>
            <a:ln w="9525">
              <a:solidFill>
                <a:srgbClr val="00B0F0"/>
              </a:solidFill>
            </a:ln>
          </c:spPr>
          <c:marker>
            <c:symbol val="square"/>
            <c:size val="4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Q$29:$BQ$50</c:f>
                <c:numCache>
                  <c:formatCode>General</c:formatCode>
                  <c:ptCount val="22"/>
                  <c:pt idx="0">
                    <c:v>0.73699378547875094</c:v>
                  </c:pt>
                  <c:pt idx="1">
                    <c:v>0.55154127717935775</c:v>
                  </c:pt>
                  <c:pt idx="2">
                    <c:v>1.387545109960995</c:v>
                  </c:pt>
                  <c:pt idx="3">
                    <c:v>0.55483103933530387</c:v>
                  </c:pt>
                  <c:pt idx="4">
                    <c:v>1.0083384429279849</c:v>
                  </c:pt>
                  <c:pt idx="5">
                    <c:v>0.45682733227727157</c:v>
                  </c:pt>
                  <c:pt idx="6">
                    <c:v>1.5757155672007757</c:v>
                  </c:pt>
                  <c:pt idx="7">
                    <c:v>0.82115903899433096</c:v>
                  </c:pt>
                  <c:pt idx="8">
                    <c:v>1.2192030534384093</c:v>
                  </c:pt>
                  <c:pt idx="9">
                    <c:v>0.76389457625190382</c:v>
                  </c:pt>
                  <c:pt idx="10">
                    <c:v>0.83648704281234865</c:v>
                  </c:pt>
                  <c:pt idx="11">
                    <c:v>0.95040899911316645</c:v>
                  </c:pt>
                  <c:pt idx="12">
                    <c:v>1.5054632420938865</c:v>
                  </c:pt>
                  <c:pt idx="13">
                    <c:v>1.2116067851925376</c:v>
                  </c:pt>
                  <c:pt idx="14">
                    <c:v>0.69869272154201478</c:v>
                  </c:pt>
                  <c:pt idx="15">
                    <c:v>0.83134385569453073</c:v>
                  </c:pt>
                  <c:pt idx="16">
                    <c:v>1.7446293851317514</c:v>
                  </c:pt>
                  <c:pt idx="17">
                    <c:v>0.89040242588009166</c:v>
                  </c:pt>
                  <c:pt idx="18">
                    <c:v>1.449354766604996</c:v>
                  </c:pt>
                  <c:pt idx="19">
                    <c:v>1.1951149610595801</c:v>
                  </c:pt>
                  <c:pt idx="20">
                    <c:v>0.94504720337742387</c:v>
                  </c:pt>
                </c:numCache>
              </c:numRef>
            </c:plus>
            <c:minus>
              <c:numRef>
                <c:f>' Calculations'!$BQ$29:$BQ$50</c:f>
                <c:numCache>
                  <c:formatCode>General</c:formatCode>
                  <c:ptCount val="22"/>
                  <c:pt idx="0">
                    <c:v>0.73699378547875094</c:v>
                  </c:pt>
                  <c:pt idx="1">
                    <c:v>0.55154127717935775</c:v>
                  </c:pt>
                  <c:pt idx="2">
                    <c:v>1.387545109960995</c:v>
                  </c:pt>
                  <c:pt idx="3">
                    <c:v>0.55483103933530387</c:v>
                  </c:pt>
                  <c:pt idx="4">
                    <c:v>1.0083384429279849</c:v>
                  </c:pt>
                  <c:pt idx="5">
                    <c:v>0.45682733227727157</c:v>
                  </c:pt>
                  <c:pt idx="6">
                    <c:v>1.5757155672007757</c:v>
                  </c:pt>
                  <c:pt idx="7">
                    <c:v>0.82115903899433096</c:v>
                  </c:pt>
                  <c:pt idx="8">
                    <c:v>1.2192030534384093</c:v>
                  </c:pt>
                  <c:pt idx="9">
                    <c:v>0.76389457625190382</c:v>
                  </c:pt>
                  <c:pt idx="10">
                    <c:v>0.83648704281234865</c:v>
                  </c:pt>
                  <c:pt idx="11">
                    <c:v>0.95040899911316645</c:v>
                  </c:pt>
                  <c:pt idx="12">
                    <c:v>1.5054632420938865</c:v>
                  </c:pt>
                  <c:pt idx="13">
                    <c:v>1.2116067851925376</c:v>
                  </c:pt>
                  <c:pt idx="14">
                    <c:v>0.69869272154201478</c:v>
                  </c:pt>
                  <c:pt idx="15">
                    <c:v>0.83134385569453073</c:v>
                  </c:pt>
                  <c:pt idx="16">
                    <c:v>1.7446293851317514</c:v>
                  </c:pt>
                  <c:pt idx="17">
                    <c:v>0.89040242588009166</c:v>
                  </c:pt>
                  <c:pt idx="18">
                    <c:v>1.449354766604996</c:v>
                  </c:pt>
                  <c:pt idx="19">
                    <c:v>1.1951149610595801</c:v>
                  </c:pt>
                  <c:pt idx="20">
                    <c:v>0.94504720337742387</c:v>
                  </c:pt>
                </c:numCache>
              </c:numRef>
            </c:minus>
            <c:spPr>
              <a:ln>
                <a:solidFill>
                  <a:srgbClr val="00B0F0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Q$4:$BQ$25</c:f>
              <c:numCache>
                <c:formatCode>General</c:formatCode>
                <c:ptCount val="22"/>
                <c:pt idx="0">
                  <c:v>101.9537914624033</c:v>
                </c:pt>
                <c:pt idx="1">
                  <c:v>99.545275549954553</c:v>
                </c:pt>
                <c:pt idx="2">
                  <c:v>100</c:v>
                </c:pt>
                <c:pt idx="3">
                  <c:v>104.52712473153734</c:v>
                </c:pt>
                <c:pt idx="4">
                  <c:v>110.27342620653495</c:v>
                </c:pt>
                <c:pt idx="5">
                  <c:v>109.24276537018171</c:v>
                </c:pt>
                <c:pt idx="6">
                  <c:v>112.77881895128805</c:v>
                </c:pt>
                <c:pt idx="7">
                  <c:v>113.19985390415417</c:v>
                </c:pt>
                <c:pt idx="8">
                  <c:v>116.16402734998836</c:v>
                </c:pt>
                <c:pt idx="9">
                  <c:v>115.32473110355372</c:v>
                </c:pt>
                <c:pt idx="10">
                  <c:v>117.24183914989715</c:v>
                </c:pt>
                <c:pt idx="11">
                  <c:v>116.17955675426117</c:v>
                </c:pt>
                <c:pt idx="12">
                  <c:v>121.32914203777921</c:v>
                </c:pt>
                <c:pt idx="13">
                  <c:v>120.28577273340065</c:v>
                </c:pt>
                <c:pt idx="14">
                  <c:v>122.15108171490488</c:v>
                </c:pt>
                <c:pt idx="15">
                  <c:v>123.73073315938304</c:v>
                </c:pt>
                <c:pt idx="16">
                  <c:v>121.46420409566446</c:v>
                </c:pt>
                <c:pt idx="17">
                  <c:v>125.41799138161853</c:v>
                </c:pt>
                <c:pt idx="18">
                  <c:v>124.70883172076543</c:v>
                </c:pt>
                <c:pt idx="19">
                  <c:v>123.07993587175521</c:v>
                </c:pt>
                <c:pt idx="20">
                  <c:v>124.800723615182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953-4629-81CC-078DE78F0CA4}"/>
            </c:ext>
          </c:extLst>
        </c:ser>
        <c:ser>
          <c:idx val="1"/>
          <c:order val="1"/>
          <c:tx>
            <c:strRef>
              <c:f>' Calculations'!$BR$3</c:f>
              <c:strCache>
                <c:ptCount val="1"/>
                <c:pt idx="0">
                  <c:v>5 µM UK5099</c:v>
                </c:pt>
              </c:strCache>
            </c:strRef>
          </c:tx>
          <c:spPr>
            <a:ln w="9525">
              <a:solidFill>
                <a:schemeClr val="accent2">
                  <a:lumMod val="75000"/>
                </a:schemeClr>
              </a:solidFill>
            </a:ln>
          </c:spPr>
          <c:marker>
            <c:symbol val="circle"/>
            <c:size val="4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R$29:$BR$50</c:f>
                <c:numCache>
                  <c:formatCode>General</c:formatCode>
                  <c:ptCount val="22"/>
                  <c:pt idx="0">
                    <c:v>1.1106939800655424</c:v>
                  </c:pt>
                  <c:pt idx="1">
                    <c:v>0.47827565188852089</c:v>
                  </c:pt>
                  <c:pt idx="2">
                    <c:v>0.53108294844837745</c:v>
                  </c:pt>
                  <c:pt idx="3">
                    <c:v>0.51007181166616267</c:v>
                  </c:pt>
                  <c:pt idx="4">
                    <c:v>1.1718251073706061</c:v>
                  </c:pt>
                  <c:pt idx="5">
                    <c:v>0.92517929004951016</c:v>
                  </c:pt>
                  <c:pt idx="6">
                    <c:v>0.77983682214346695</c:v>
                  </c:pt>
                  <c:pt idx="7">
                    <c:v>0.91413467276567073</c:v>
                  </c:pt>
                  <c:pt idx="8">
                    <c:v>0.63748273621293605</c:v>
                  </c:pt>
                  <c:pt idx="9">
                    <c:v>1.310183168440948</c:v>
                  </c:pt>
                  <c:pt idx="10">
                    <c:v>0.63347908568609035</c:v>
                  </c:pt>
                  <c:pt idx="11">
                    <c:v>0.7405762963154755</c:v>
                  </c:pt>
                  <c:pt idx="12">
                    <c:v>1.5786804754060875</c:v>
                  </c:pt>
                  <c:pt idx="13">
                    <c:v>0.7197070461269216</c:v>
                  </c:pt>
                  <c:pt idx="14">
                    <c:v>0.90612939976372087</c:v>
                  </c:pt>
                  <c:pt idx="15">
                    <c:v>1.2053324371340657</c:v>
                  </c:pt>
                  <c:pt idx="16">
                    <c:v>0.56290202308432147</c:v>
                  </c:pt>
                  <c:pt idx="17">
                    <c:v>0.60886418735734382</c:v>
                  </c:pt>
                  <c:pt idx="18">
                    <c:v>1.1021900107897795</c:v>
                  </c:pt>
                  <c:pt idx="19">
                    <c:v>0.78205183400346723</c:v>
                  </c:pt>
                  <c:pt idx="20">
                    <c:v>0.62465249693576397</c:v>
                  </c:pt>
                </c:numCache>
              </c:numRef>
            </c:plus>
            <c:minus>
              <c:numRef>
                <c:f>' Calculations'!$BR$29:$BR$50</c:f>
                <c:numCache>
                  <c:formatCode>General</c:formatCode>
                  <c:ptCount val="22"/>
                  <c:pt idx="0">
                    <c:v>1.1106939800655424</c:v>
                  </c:pt>
                  <c:pt idx="1">
                    <c:v>0.47827565188852089</c:v>
                  </c:pt>
                  <c:pt idx="2">
                    <c:v>0.53108294844837745</c:v>
                  </c:pt>
                  <c:pt idx="3">
                    <c:v>0.51007181166616267</c:v>
                  </c:pt>
                  <c:pt idx="4">
                    <c:v>1.1718251073706061</c:v>
                  </c:pt>
                  <c:pt idx="5">
                    <c:v>0.92517929004951016</c:v>
                  </c:pt>
                  <c:pt idx="6">
                    <c:v>0.77983682214346695</c:v>
                  </c:pt>
                  <c:pt idx="7">
                    <c:v>0.91413467276567073</c:v>
                  </c:pt>
                  <c:pt idx="8">
                    <c:v>0.63748273621293605</c:v>
                  </c:pt>
                  <c:pt idx="9">
                    <c:v>1.310183168440948</c:v>
                  </c:pt>
                  <c:pt idx="10">
                    <c:v>0.63347908568609035</c:v>
                  </c:pt>
                  <c:pt idx="11">
                    <c:v>0.7405762963154755</c:v>
                  </c:pt>
                  <c:pt idx="12">
                    <c:v>1.5786804754060875</c:v>
                  </c:pt>
                  <c:pt idx="13">
                    <c:v>0.7197070461269216</c:v>
                  </c:pt>
                  <c:pt idx="14">
                    <c:v>0.90612939976372087</c:v>
                  </c:pt>
                  <c:pt idx="15">
                    <c:v>1.2053324371340657</c:v>
                  </c:pt>
                  <c:pt idx="16">
                    <c:v>0.56290202308432147</c:v>
                  </c:pt>
                  <c:pt idx="17">
                    <c:v>0.60886418735734382</c:v>
                  </c:pt>
                  <c:pt idx="18">
                    <c:v>1.1021900107897795</c:v>
                  </c:pt>
                  <c:pt idx="19">
                    <c:v>0.78205183400346723</c:v>
                  </c:pt>
                  <c:pt idx="20">
                    <c:v>0.62465249693576397</c:v>
                  </c:pt>
                </c:numCache>
              </c:numRef>
            </c:minus>
            <c:spPr>
              <a:ln>
                <a:solidFill>
                  <a:schemeClr val="accent2">
                    <a:lumMod val="75000"/>
                  </a:schemeClr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R$4:$BR$25</c:f>
              <c:numCache>
                <c:formatCode>General</c:formatCode>
                <c:ptCount val="22"/>
                <c:pt idx="0">
                  <c:v>99.111746276642876</c:v>
                </c:pt>
                <c:pt idx="1">
                  <c:v>98.719838080004251</c:v>
                </c:pt>
                <c:pt idx="2">
                  <c:v>100</c:v>
                </c:pt>
                <c:pt idx="3">
                  <c:v>147.81706674186123</c:v>
                </c:pt>
                <c:pt idx="4">
                  <c:v>149.86646014056913</c:v>
                </c:pt>
                <c:pt idx="5">
                  <c:v>150.65845323812451</c:v>
                </c:pt>
                <c:pt idx="6">
                  <c:v>153.75076654892817</c:v>
                </c:pt>
                <c:pt idx="7">
                  <c:v>156.34528591599798</c:v>
                </c:pt>
                <c:pt idx="8">
                  <c:v>159.77065840151755</c:v>
                </c:pt>
                <c:pt idx="9">
                  <c:v>163.35134294724915</c:v>
                </c:pt>
                <c:pt idx="10">
                  <c:v>164.23218863218091</c:v>
                </c:pt>
                <c:pt idx="11">
                  <c:v>166.14796401878789</c:v>
                </c:pt>
                <c:pt idx="12">
                  <c:v>166.99576848082336</c:v>
                </c:pt>
                <c:pt idx="13">
                  <c:v>169.34855907479874</c:v>
                </c:pt>
                <c:pt idx="14">
                  <c:v>171.0456881120474</c:v>
                </c:pt>
                <c:pt idx="15">
                  <c:v>170.29340652460368</c:v>
                </c:pt>
                <c:pt idx="16">
                  <c:v>174.15152299950537</c:v>
                </c:pt>
                <c:pt idx="17">
                  <c:v>172.45110105950096</c:v>
                </c:pt>
                <c:pt idx="18">
                  <c:v>173.41920013744925</c:v>
                </c:pt>
                <c:pt idx="19">
                  <c:v>177.78037103995925</c:v>
                </c:pt>
                <c:pt idx="20">
                  <c:v>178.1826853053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953-4629-81CC-078DE78F0CA4}"/>
            </c:ext>
          </c:extLst>
        </c:ser>
        <c:ser>
          <c:idx val="2"/>
          <c:order val="2"/>
          <c:tx>
            <c:strRef>
              <c:f>' Calculations'!$BS$3</c:f>
              <c:strCache>
                <c:ptCount val="1"/>
                <c:pt idx="0">
                  <c:v>10 µM Flufenamic Acid</c:v>
                </c:pt>
              </c:strCache>
            </c:strRef>
          </c:tx>
          <c:spPr>
            <a:ln w="9525"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S$29:$BS$50</c:f>
                <c:numCache>
                  <c:formatCode>General</c:formatCode>
                  <c:ptCount val="22"/>
                  <c:pt idx="0">
                    <c:v>1.7859589738779547</c:v>
                  </c:pt>
                  <c:pt idx="1">
                    <c:v>1.2823950439843299</c:v>
                  </c:pt>
                  <c:pt idx="2">
                    <c:v>1.2233560057929047</c:v>
                  </c:pt>
                  <c:pt idx="3">
                    <c:v>1.8159175679137769</c:v>
                  </c:pt>
                  <c:pt idx="4">
                    <c:v>1.110545315833106</c:v>
                  </c:pt>
                  <c:pt idx="5">
                    <c:v>1.1455952382335535</c:v>
                  </c:pt>
                  <c:pt idx="6">
                    <c:v>1.0251461573287399</c:v>
                  </c:pt>
                  <c:pt idx="7">
                    <c:v>0.74258626551077456</c:v>
                  </c:pt>
                  <c:pt idx="8">
                    <c:v>1.3884162270783993</c:v>
                  </c:pt>
                  <c:pt idx="9">
                    <c:v>1.1713293609241329</c:v>
                  </c:pt>
                  <c:pt idx="10">
                    <c:v>0.85547979255252615</c:v>
                  </c:pt>
                  <c:pt idx="11">
                    <c:v>1.330005754106768</c:v>
                  </c:pt>
                  <c:pt idx="12">
                    <c:v>0.69650188527672729</c:v>
                  </c:pt>
                  <c:pt idx="13">
                    <c:v>0.90826626519461984</c:v>
                  </c:pt>
                  <c:pt idx="14">
                    <c:v>1.1096695117641118</c:v>
                  </c:pt>
                  <c:pt idx="15">
                    <c:v>0.47827465920968137</c:v>
                  </c:pt>
                  <c:pt idx="16">
                    <c:v>0.22751973369250147</c:v>
                  </c:pt>
                  <c:pt idx="17">
                    <c:v>1.3162189739112784</c:v>
                  </c:pt>
                  <c:pt idx="18">
                    <c:v>0.82993292955052012</c:v>
                  </c:pt>
                  <c:pt idx="19">
                    <c:v>1.7150670799178165</c:v>
                  </c:pt>
                  <c:pt idx="20">
                    <c:v>1.2357435942674189</c:v>
                  </c:pt>
                </c:numCache>
              </c:numRef>
            </c:plus>
            <c:minus>
              <c:numRef>
                <c:f>' Calculations'!$BS$29:$BS$50</c:f>
                <c:numCache>
                  <c:formatCode>General</c:formatCode>
                  <c:ptCount val="22"/>
                  <c:pt idx="0">
                    <c:v>1.7859589738779547</c:v>
                  </c:pt>
                  <c:pt idx="1">
                    <c:v>1.2823950439843299</c:v>
                  </c:pt>
                  <c:pt idx="2">
                    <c:v>1.2233560057929047</c:v>
                  </c:pt>
                  <c:pt idx="3">
                    <c:v>1.8159175679137769</c:v>
                  </c:pt>
                  <c:pt idx="4">
                    <c:v>1.110545315833106</c:v>
                  </c:pt>
                  <c:pt idx="5">
                    <c:v>1.1455952382335535</c:v>
                  </c:pt>
                  <c:pt idx="6">
                    <c:v>1.0251461573287399</c:v>
                  </c:pt>
                  <c:pt idx="7">
                    <c:v>0.74258626551077456</c:v>
                  </c:pt>
                  <c:pt idx="8">
                    <c:v>1.3884162270783993</c:v>
                  </c:pt>
                  <c:pt idx="9">
                    <c:v>1.1713293609241329</c:v>
                  </c:pt>
                  <c:pt idx="10">
                    <c:v>0.85547979255252615</c:v>
                  </c:pt>
                  <c:pt idx="11">
                    <c:v>1.330005754106768</c:v>
                  </c:pt>
                  <c:pt idx="12">
                    <c:v>0.69650188527672729</c:v>
                  </c:pt>
                  <c:pt idx="13">
                    <c:v>0.90826626519461984</c:v>
                  </c:pt>
                  <c:pt idx="14">
                    <c:v>1.1096695117641118</c:v>
                  </c:pt>
                  <c:pt idx="15">
                    <c:v>0.47827465920968137</c:v>
                  </c:pt>
                  <c:pt idx="16">
                    <c:v>0.22751973369250147</c:v>
                  </c:pt>
                  <c:pt idx="17">
                    <c:v>1.3162189739112784</c:v>
                  </c:pt>
                  <c:pt idx="18">
                    <c:v>0.82993292955052012</c:v>
                  </c:pt>
                  <c:pt idx="19">
                    <c:v>1.7150670799178165</c:v>
                  </c:pt>
                  <c:pt idx="20">
                    <c:v>1.2357435942674189</c:v>
                  </c:pt>
                </c:numCache>
              </c:numRef>
            </c:minus>
            <c:spPr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S$4:$BS$25</c:f>
              <c:numCache>
                <c:formatCode>General</c:formatCode>
                <c:ptCount val="22"/>
                <c:pt idx="0">
                  <c:v>97.476468665117267</c:v>
                </c:pt>
                <c:pt idx="1">
                  <c:v>97.336137158087652</c:v>
                </c:pt>
                <c:pt idx="2">
                  <c:v>100</c:v>
                </c:pt>
                <c:pt idx="3">
                  <c:v>112.48092778842835</c:v>
                </c:pt>
                <c:pt idx="4">
                  <c:v>111.2760739379363</c:v>
                </c:pt>
                <c:pt idx="5">
                  <c:v>112.28434744315538</c:v>
                </c:pt>
                <c:pt idx="6">
                  <c:v>112.0829747214614</c:v>
                </c:pt>
                <c:pt idx="7">
                  <c:v>112.55148499448924</c:v>
                </c:pt>
                <c:pt idx="8">
                  <c:v>113.52176598011341</c:v>
                </c:pt>
                <c:pt idx="9">
                  <c:v>117.01263722231174</c:v>
                </c:pt>
                <c:pt idx="10">
                  <c:v>116.23399473505414</c:v>
                </c:pt>
                <c:pt idx="11">
                  <c:v>117.59292736293983</c:v>
                </c:pt>
                <c:pt idx="12">
                  <c:v>119.9076321073443</c:v>
                </c:pt>
                <c:pt idx="13">
                  <c:v>118.2267850821891</c:v>
                </c:pt>
                <c:pt idx="14">
                  <c:v>118.70234624590121</c:v>
                </c:pt>
                <c:pt idx="15">
                  <c:v>122.6874116386101</c:v>
                </c:pt>
                <c:pt idx="16">
                  <c:v>118.9748685323151</c:v>
                </c:pt>
                <c:pt idx="17">
                  <c:v>119.50899714408858</c:v>
                </c:pt>
                <c:pt idx="18">
                  <c:v>120.87919527319349</c:v>
                </c:pt>
                <c:pt idx="19">
                  <c:v>121.59029662387925</c:v>
                </c:pt>
                <c:pt idx="20">
                  <c:v>122.171574051831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953-4629-81CC-078DE78F0CA4}"/>
            </c:ext>
          </c:extLst>
        </c:ser>
        <c:ser>
          <c:idx val="3"/>
          <c:order val="3"/>
          <c:tx>
            <c:strRef>
              <c:f>' Calculations'!$BT$3</c:f>
              <c:strCache>
                <c:ptCount val="1"/>
                <c:pt idx="0">
                  <c:v>10 µM Acetylsalicylic Acid</c:v>
                </c:pt>
              </c:strCache>
            </c:strRef>
          </c:tx>
          <c:spPr>
            <a:ln w="9525">
              <a:solidFill>
                <a:schemeClr val="accent2">
                  <a:lumMod val="40000"/>
                  <a:lumOff val="60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accent2">
                  <a:lumMod val="40000"/>
                  <a:lumOff val="60000"/>
                </a:schemeClr>
              </a:solidFill>
              <a:ln w="9525">
                <a:solidFill>
                  <a:schemeClr val="accent2">
                    <a:lumMod val="40000"/>
                    <a:lumOff val="6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T$29:$BT$50</c:f>
                <c:numCache>
                  <c:formatCode>General</c:formatCode>
                  <c:ptCount val="22"/>
                  <c:pt idx="0">
                    <c:v>1.7537960975622922</c:v>
                  </c:pt>
                  <c:pt idx="1">
                    <c:v>1.1010967489957162</c:v>
                  </c:pt>
                  <c:pt idx="2">
                    <c:v>1.1270397209194327</c:v>
                  </c:pt>
                  <c:pt idx="3">
                    <c:v>1.346635405883386</c:v>
                  </c:pt>
                  <c:pt idx="4">
                    <c:v>1.5820603307205749</c:v>
                  </c:pt>
                  <c:pt idx="5">
                    <c:v>0.9687236571897162</c:v>
                  </c:pt>
                  <c:pt idx="6">
                    <c:v>1.1042671632266803</c:v>
                  </c:pt>
                  <c:pt idx="7">
                    <c:v>1.248342827628411</c:v>
                  </c:pt>
                  <c:pt idx="8">
                    <c:v>1.5268095519765301</c:v>
                  </c:pt>
                  <c:pt idx="9">
                    <c:v>2.1539168068559942</c:v>
                  </c:pt>
                  <c:pt idx="10">
                    <c:v>0.75875521398309176</c:v>
                  </c:pt>
                  <c:pt idx="11">
                    <c:v>1.3902814390514755</c:v>
                  </c:pt>
                  <c:pt idx="12">
                    <c:v>1.7077165118902073</c:v>
                  </c:pt>
                  <c:pt idx="13">
                    <c:v>1.0239035218322716</c:v>
                  </c:pt>
                  <c:pt idx="14">
                    <c:v>1.3010101884603726</c:v>
                  </c:pt>
                  <c:pt idx="15">
                    <c:v>1.0701357928978168</c:v>
                  </c:pt>
                  <c:pt idx="16">
                    <c:v>0.38077927202857853</c:v>
                  </c:pt>
                  <c:pt idx="17">
                    <c:v>1.6453200375843677</c:v>
                  </c:pt>
                  <c:pt idx="18">
                    <c:v>1.4788635660001306</c:v>
                  </c:pt>
                  <c:pt idx="19">
                    <c:v>0.6594918525453014</c:v>
                  </c:pt>
                  <c:pt idx="20">
                    <c:v>1.7947794392299057</c:v>
                  </c:pt>
                </c:numCache>
              </c:numRef>
            </c:plus>
            <c:minus>
              <c:numRef>
                <c:f>' Calculations'!$BT$29:$BT$50</c:f>
                <c:numCache>
                  <c:formatCode>General</c:formatCode>
                  <c:ptCount val="22"/>
                  <c:pt idx="0">
                    <c:v>1.7537960975622922</c:v>
                  </c:pt>
                  <c:pt idx="1">
                    <c:v>1.1010967489957162</c:v>
                  </c:pt>
                  <c:pt idx="2">
                    <c:v>1.1270397209194327</c:v>
                  </c:pt>
                  <c:pt idx="3">
                    <c:v>1.346635405883386</c:v>
                  </c:pt>
                  <c:pt idx="4">
                    <c:v>1.5820603307205749</c:v>
                  </c:pt>
                  <c:pt idx="5">
                    <c:v>0.9687236571897162</c:v>
                  </c:pt>
                  <c:pt idx="6">
                    <c:v>1.1042671632266803</c:v>
                  </c:pt>
                  <c:pt idx="7">
                    <c:v>1.248342827628411</c:v>
                  </c:pt>
                  <c:pt idx="8">
                    <c:v>1.5268095519765301</c:v>
                  </c:pt>
                  <c:pt idx="9">
                    <c:v>2.1539168068559942</c:v>
                  </c:pt>
                  <c:pt idx="10">
                    <c:v>0.75875521398309176</c:v>
                  </c:pt>
                  <c:pt idx="11">
                    <c:v>1.3902814390514755</c:v>
                  </c:pt>
                  <c:pt idx="12">
                    <c:v>1.7077165118902073</c:v>
                  </c:pt>
                  <c:pt idx="13">
                    <c:v>1.0239035218322716</c:v>
                  </c:pt>
                  <c:pt idx="14">
                    <c:v>1.3010101884603726</c:v>
                  </c:pt>
                  <c:pt idx="15">
                    <c:v>1.0701357928978168</c:v>
                  </c:pt>
                  <c:pt idx="16">
                    <c:v>0.38077927202857853</c:v>
                  </c:pt>
                  <c:pt idx="17">
                    <c:v>1.6453200375843677</c:v>
                  </c:pt>
                  <c:pt idx="18">
                    <c:v>1.4788635660001306</c:v>
                  </c:pt>
                  <c:pt idx="19">
                    <c:v>0.6594918525453014</c:v>
                  </c:pt>
                  <c:pt idx="20">
                    <c:v>1.7947794392299057</c:v>
                  </c:pt>
                </c:numCache>
              </c:numRef>
            </c:minus>
            <c:spPr>
              <a:ln>
                <a:solidFill>
                  <a:schemeClr val="accent2">
                    <a:lumMod val="40000"/>
                    <a:lumOff val="60000"/>
                  </a:schemeClr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T$4:$BT$25</c:f>
              <c:numCache>
                <c:formatCode>General</c:formatCode>
                <c:ptCount val="22"/>
                <c:pt idx="0">
                  <c:v>96.954416579400856</c:v>
                </c:pt>
                <c:pt idx="1">
                  <c:v>96.668381895731628</c:v>
                </c:pt>
                <c:pt idx="2">
                  <c:v>100</c:v>
                </c:pt>
                <c:pt idx="3">
                  <c:v>101.10856849417335</c:v>
                </c:pt>
                <c:pt idx="4">
                  <c:v>105.09594238400072</c:v>
                </c:pt>
                <c:pt idx="5">
                  <c:v>106.66431813219037</c:v>
                </c:pt>
                <c:pt idx="6">
                  <c:v>110.51664728809527</c:v>
                </c:pt>
                <c:pt idx="7">
                  <c:v>112.60305774410382</c:v>
                </c:pt>
                <c:pt idx="8">
                  <c:v>112.96216605180018</c:v>
                </c:pt>
                <c:pt idx="9">
                  <c:v>114.44139552625454</c:v>
                </c:pt>
                <c:pt idx="10">
                  <c:v>119.01430345953581</c:v>
                </c:pt>
                <c:pt idx="11">
                  <c:v>121.92105773882223</c:v>
                </c:pt>
                <c:pt idx="12">
                  <c:v>120.86256778545679</c:v>
                </c:pt>
                <c:pt idx="13">
                  <c:v>120.46119933371659</c:v>
                </c:pt>
                <c:pt idx="14">
                  <c:v>121.36886396576449</c:v>
                </c:pt>
                <c:pt idx="15">
                  <c:v>125.71914448331103</c:v>
                </c:pt>
                <c:pt idx="16">
                  <c:v>123.29223034353734</c:v>
                </c:pt>
                <c:pt idx="17">
                  <c:v>125.86468997232589</c:v>
                </c:pt>
                <c:pt idx="18">
                  <c:v>125.40250461752109</c:v>
                </c:pt>
                <c:pt idx="19">
                  <c:v>127.85883764263608</c:v>
                </c:pt>
                <c:pt idx="20">
                  <c:v>126.1208112854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953-4629-81CC-078DE78F0CA4}"/>
            </c:ext>
          </c:extLst>
        </c:ser>
        <c:ser>
          <c:idx val="4"/>
          <c:order val="4"/>
          <c:tx>
            <c:strRef>
              <c:f>' Calculations'!$BU$3</c:f>
              <c:strCache>
                <c:ptCount val="1"/>
                <c:pt idx="0">
                  <c:v>10 µM Flufenamic Acid</c:v>
                </c:pt>
              </c:strCache>
            </c:strRef>
          </c:tx>
          <c:spPr>
            <a:ln w="952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U$29:$BU$50</c:f>
                <c:numCache>
                  <c:formatCode>General</c:formatCode>
                  <c:ptCount val="22"/>
                  <c:pt idx="0">
                    <c:v>1.143787624477687</c:v>
                  </c:pt>
                  <c:pt idx="1">
                    <c:v>0.58902590065941074</c:v>
                  </c:pt>
                  <c:pt idx="2">
                    <c:v>1.2371879381215423</c:v>
                  </c:pt>
                  <c:pt idx="3">
                    <c:v>1.1459486311850251</c:v>
                  </c:pt>
                  <c:pt idx="4">
                    <c:v>0.94257435832065251</c:v>
                  </c:pt>
                  <c:pt idx="5">
                    <c:v>1.0306909172250147</c:v>
                  </c:pt>
                  <c:pt idx="6">
                    <c:v>1.164960590319509</c:v>
                  </c:pt>
                  <c:pt idx="7">
                    <c:v>0.24219166424845195</c:v>
                  </c:pt>
                  <c:pt idx="8">
                    <c:v>0.44727948743862322</c:v>
                  </c:pt>
                  <c:pt idx="9">
                    <c:v>1.0009247625743871</c:v>
                  </c:pt>
                  <c:pt idx="10">
                    <c:v>1.0381824698070878</c:v>
                  </c:pt>
                  <c:pt idx="11">
                    <c:v>1.2610541879442942</c:v>
                  </c:pt>
                  <c:pt idx="12">
                    <c:v>1.3040748280901227</c:v>
                  </c:pt>
                  <c:pt idx="13">
                    <c:v>0.97226219379763312</c:v>
                  </c:pt>
                  <c:pt idx="14">
                    <c:v>1.4038619119685922</c:v>
                  </c:pt>
                  <c:pt idx="15">
                    <c:v>0.64601074774619094</c:v>
                  </c:pt>
                  <c:pt idx="16">
                    <c:v>1.1506314726791729</c:v>
                  </c:pt>
                  <c:pt idx="17">
                    <c:v>1.4885818551831957</c:v>
                  </c:pt>
                  <c:pt idx="18">
                    <c:v>0.90248575728962466</c:v>
                  </c:pt>
                  <c:pt idx="19">
                    <c:v>1.2551132807788932</c:v>
                  </c:pt>
                  <c:pt idx="20">
                    <c:v>0.48769979029708727</c:v>
                  </c:pt>
                </c:numCache>
              </c:numRef>
            </c:plus>
            <c:minus>
              <c:numRef>
                <c:f>' Calculations'!$BU$29:$BU$50</c:f>
                <c:numCache>
                  <c:formatCode>General</c:formatCode>
                  <c:ptCount val="22"/>
                  <c:pt idx="0">
                    <c:v>1.143787624477687</c:v>
                  </c:pt>
                  <c:pt idx="1">
                    <c:v>0.58902590065941074</c:v>
                  </c:pt>
                  <c:pt idx="2">
                    <c:v>1.2371879381215423</c:v>
                  </c:pt>
                  <c:pt idx="3">
                    <c:v>1.1459486311850251</c:v>
                  </c:pt>
                  <c:pt idx="4">
                    <c:v>0.94257435832065251</c:v>
                  </c:pt>
                  <c:pt idx="5">
                    <c:v>1.0306909172250147</c:v>
                  </c:pt>
                  <c:pt idx="6">
                    <c:v>1.164960590319509</c:v>
                  </c:pt>
                  <c:pt idx="7">
                    <c:v>0.24219166424845195</c:v>
                  </c:pt>
                  <c:pt idx="8">
                    <c:v>0.44727948743862322</c:v>
                  </c:pt>
                  <c:pt idx="9">
                    <c:v>1.0009247625743871</c:v>
                  </c:pt>
                  <c:pt idx="10">
                    <c:v>1.0381824698070878</c:v>
                  </c:pt>
                  <c:pt idx="11">
                    <c:v>1.2610541879442942</c:v>
                  </c:pt>
                  <c:pt idx="12">
                    <c:v>1.3040748280901227</c:v>
                  </c:pt>
                  <c:pt idx="13">
                    <c:v>0.97226219379763312</c:v>
                  </c:pt>
                  <c:pt idx="14">
                    <c:v>1.4038619119685922</c:v>
                  </c:pt>
                  <c:pt idx="15">
                    <c:v>0.64601074774619094</c:v>
                  </c:pt>
                  <c:pt idx="16">
                    <c:v>1.1506314726791729</c:v>
                  </c:pt>
                  <c:pt idx="17">
                    <c:v>1.4885818551831957</c:v>
                  </c:pt>
                  <c:pt idx="18">
                    <c:v>0.90248575728962466</c:v>
                  </c:pt>
                  <c:pt idx="19">
                    <c:v>1.2551132807788932</c:v>
                  </c:pt>
                  <c:pt idx="20">
                    <c:v>0.48769979029708727</c:v>
                  </c:pt>
                </c:numCache>
              </c:numRef>
            </c:minus>
            <c:spPr>
              <a:ln>
                <a:solidFill>
                  <a:srgbClr val="00B050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U$4:$BU$25</c:f>
              <c:numCache>
                <c:formatCode>General</c:formatCode>
                <c:ptCount val="22"/>
                <c:pt idx="0">
                  <c:v>101.86069081212881</c:v>
                </c:pt>
                <c:pt idx="1">
                  <c:v>98.325326701841249</c:v>
                </c:pt>
                <c:pt idx="2">
                  <c:v>100</c:v>
                </c:pt>
                <c:pt idx="3">
                  <c:v>114.49918875197866</c:v>
                </c:pt>
                <c:pt idx="4">
                  <c:v>114.26784999906864</c:v>
                </c:pt>
                <c:pt idx="5">
                  <c:v>115.85982770886818</c:v>
                </c:pt>
                <c:pt idx="6">
                  <c:v>115.50641653852611</c:v>
                </c:pt>
                <c:pt idx="7">
                  <c:v>115.80996219729765</c:v>
                </c:pt>
                <c:pt idx="8">
                  <c:v>118.81765686281265</c:v>
                </c:pt>
                <c:pt idx="9">
                  <c:v>116.63463775582792</c:v>
                </c:pt>
                <c:pt idx="10">
                  <c:v>120.55145018955804</c:v>
                </c:pt>
                <c:pt idx="11">
                  <c:v>121.47299247346088</c:v>
                </c:pt>
                <c:pt idx="12">
                  <c:v>121.4766814671663</c:v>
                </c:pt>
                <c:pt idx="13">
                  <c:v>126.31268339154833</c:v>
                </c:pt>
                <c:pt idx="14">
                  <c:v>121.14230660040694</c:v>
                </c:pt>
                <c:pt idx="15">
                  <c:v>124.90411258587943</c:v>
                </c:pt>
                <c:pt idx="16">
                  <c:v>124.90077096729095</c:v>
                </c:pt>
                <c:pt idx="17">
                  <c:v>123.94321738901968</c:v>
                </c:pt>
                <c:pt idx="18">
                  <c:v>127.0544936970651</c:v>
                </c:pt>
                <c:pt idx="19">
                  <c:v>123.2681741499165</c:v>
                </c:pt>
                <c:pt idx="20">
                  <c:v>126.5169770420618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0953-4629-81CC-078DE78F0CA4}"/>
            </c:ext>
          </c:extLst>
        </c:ser>
        <c:ser>
          <c:idx val="5"/>
          <c:order val="5"/>
          <c:tx>
            <c:strRef>
              <c:f>' Calculations'!$BV$3</c:f>
              <c:strCache>
                <c:ptCount val="1"/>
                <c:pt idx="0">
                  <c:v>10 µM Acetylsalicylic Acid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star"/>
            <c:size val="4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V$29:$BV$50</c:f>
                <c:numCache>
                  <c:formatCode>General</c:formatCode>
                  <c:ptCount val="22"/>
                  <c:pt idx="0">
                    <c:v>2.1085404733954185</c:v>
                  </c:pt>
                  <c:pt idx="1">
                    <c:v>0.71907170536252429</c:v>
                  </c:pt>
                  <c:pt idx="2">
                    <c:v>0.60083965880626755</c:v>
                  </c:pt>
                  <c:pt idx="3">
                    <c:v>1.3652898649985348</c:v>
                  </c:pt>
                  <c:pt idx="4">
                    <c:v>1.1893504715704091</c:v>
                  </c:pt>
                  <c:pt idx="5">
                    <c:v>0.75684831110521011</c:v>
                  </c:pt>
                  <c:pt idx="6">
                    <c:v>1.158811157401503</c:v>
                  </c:pt>
                  <c:pt idx="7">
                    <c:v>0.59403426505345325</c:v>
                  </c:pt>
                  <c:pt idx="8">
                    <c:v>0.24890321801263054</c:v>
                  </c:pt>
                  <c:pt idx="9">
                    <c:v>0.34204677160463892</c:v>
                  </c:pt>
                  <c:pt idx="10">
                    <c:v>0.2280591301118946</c:v>
                  </c:pt>
                  <c:pt idx="11">
                    <c:v>0.55091138748127422</c:v>
                  </c:pt>
                  <c:pt idx="12">
                    <c:v>1.4518235106425184</c:v>
                  </c:pt>
                  <c:pt idx="13">
                    <c:v>0.81208879350855201</c:v>
                  </c:pt>
                  <c:pt idx="14">
                    <c:v>0.67629778589641432</c:v>
                  </c:pt>
                  <c:pt idx="15">
                    <c:v>0.5817604862080632</c:v>
                  </c:pt>
                  <c:pt idx="16">
                    <c:v>0.55873178654935185</c:v>
                  </c:pt>
                  <c:pt idx="17">
                    <c:v>0.4506142831292877</c:v>
                  </c:pt>
                  <c:pt idx="18">
                    <c:v>1.4499956631602309</c:v>
                  </c:pt>
                  <c:pt idx="19">
                    <c:v>1.1790732734195259</c:v>
                  </c:pt>
                  <c:pt idx="20">
                    <c:v>1.3563541573579467</c:v>
                  </c:pt>
                </c:numCache>
              </c:numRef>
            </c:plus>
            <c:minus>
              <c:numRef>
                <c:f>' Calculations'!$BV$29:$BV$50</c:f>
                <c:numCache>
                  <c:formatCode>General</c:formatCode>
                  <c:ptCount val="22"/>
                  <c:pt idx="0">
                    <c:v>2.1085404733954185</c:v>
                  </c:pt>
                  <c:pt idx="1">
                    <c:v>0.71907170536252429</c:v>
                  </c:pt>
                  <c:pt idx="2">
                    <c:v>0.60083965880626755</c:v>
                  </c:pt>
                  <c:pt idx="3">
                    <c:v>1.3652898649985348</c:v>
                  </c:pt>
                  <c:pt idx="4">
                    <c:v>1.1893504715704091</c:v>
                  </c:pt>
                  <c:pt idx="5">
                    <c:v>0.75684831110521011</c:v>
                  </c:pt>
                  <c:pt idx="6">
                    <c:v>1.158811157401503</c:v>
                  </c:pt>
                  <c:pt idx="7">
                    <c:v>0.59403426505345325</c:v>
                  </c:pt>
                  <c:pt idx="8">
                    <c:v>0.24890321801263054</c:v>
                  </c:pt>
                  <c:pt idx="9">
                    <c:v>0.34204677160463892</c:v>
                  </c:pt>
                  <c:pt idx="10">
                    <c:v>0.2280591301118946</c:v>
                  </c:pt>
                  <c:pt idx="11">
                    <c:v>0.55091138748127422</c:v>
                  </c:pt>
                  <c:pt idx="12">
                    <c:v>1.4518235106425184</c:v>
                  </c:pt>
                  <c:pt idx="13">
                    <c:v>0.81208879350855201</c:v>
                  </c:pt>
                  <c:pt idx="14">
                    <c:v>0.67629778589641432</c:v>
                  </c:pt>
                  <c:pt idx="15">
                    <c:v>0.5817604862080632</c:v>
                  </c:pt>
                  <c:pt idx="16">
                    <c:v>0.55873178654935185</c:v>
                  </c:pt>
                  <c:pt idx="17">
                    <c:v>0.4506142831292877</c:v>
                  </c:pt>
                  <c:pt idx="18">
                    <c:v>1.4499956631602309</c:v>
                  </c:pt>
                  <c:pt idx="19">
                    <c:v>1.1790732734195259</c:v>
                  </c:pt>
                  <c:pt idx="20">
                    <c:v>1.3563541573579467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V$4:$BV$25</c:f>
              <c:numCache>
                <c:formatCode>General</c:formatCode>
                <c:ptCount val="22"/>
                <c:pt idx="0">
                  <c:v>100.17949556164183</c:v>
                </c:pt>
                <c:pt idx="1">
                  <c:v>99.466888352106565</c:v>
                </c:pt>
                <c:pt idx="2">
                  <c:v>100</c:v>
                </c:pt>
                <c:pt idx="3">
                  <c:v>103.81784406957735</c:v>
                </c:pt>
                <c:pt idx="4">
                  <c:v>106.52830802762526</c:v>
                </c:pt>
                <c:pt idx="5">
                  <c:v>108.01932987110771</c:v>
                </c:pt>
                <c:pt idx="6">
                  <c:v>108.6214110605209</c:v>
                </c:pt>
                <c:pt idx="7">
                  <c:v>110.12338085587183</c:v>
                </c:pt>
                <c:pt idx="8">
                  <c:v>114.82787339432399</c:v>
                </c:pt>
                <c:pt idx="9">
                  <c:v>114.80170619092948</c:v>
                </c:pt>
                <c:pt idx="10">
                  <c:v>116.66838064334549</c:v>
                </c:pt>
                <c:pt idx="11">
                  <c:v>119.55634703511106</c:v>
                </c:pt>
                <c:pt idx="12">
                  <c:v>119.30212004843904</c:v>
                </c:pt>
                <c:pt idx="13">
                  <c:v>119.95508039747969</c:v>
                </c:pt>
                <c:pt idx="14">
                  <c:v>120.25821029438744</c:v>
                </c:pt>
                <c:pt idx="15">
                  <c:v>122.1053093395949</c:v>
                </c:pt>
                <c:pt idx="16">
                  <c:v>122.76012054153324</c:v>
                </c:pt>
                <c:pt idx="17">
                  <c:v>122.20492391751161</c:v>
                </c:pt>
                <c:pt idx="18">
                  <c:v>120.94014393501158</c:v>
                </c:pt>
                <c:pt idx="19">
                  <c:v>120.22130769099017</c:v>
                </c:pt>
                <c:pt idx="20">
                  <c:v>124.3823700445348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0953-4629-81CC-078DE78F0C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43953472"/>
        <c:axId val="-843958912"/>
      </c:scatterChart>
      <c:valAx>
        <c:axId val="-84395347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-843958912"/>
        <c:crosses val="autoZero"/>
        <c:crossBetween val="midCat"/>
      </c:valAx>
      <c:valAx>
        <c:axId val="-843958912"/>
        <c:scaling>
          <c:orientation val="minMax"/>
          <c:min val="9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BRET (% of basa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-843953472"/>
        <c:crosses val="autoZero"/>
        <c:crossBetween val="midCat"/>
      </c:valAx>
    </c:plotArea>
    <c:legend>
      <c:legendPos val="r"/>
      <c:layout/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570805072331675"/>
          <c:y val="0.11922278893222824"/>
          <c:w val="0.69818697221581361"/>
          <c:h val="0.78746728172289016"/>
        </c:manualLayout>
      </c:layout>
      <c:scatterChart>
        <c:scatterStyle val="lineMarker"/>
        <c:varyColors val="0"/>
        <c:ser>
          <c:idx val="0"/>
          <c:order val="0"/>
          <c:tx>
            <c:strRef>
              <c:f>' Calculations'!$BQ$3</c:f>
              <c:strCache>
                <c:ptCount val="1"/>
                <c:pt idx="0">
                  <c:v>DMSO</c:v>
                </c:pt>
              </c:strCache>
            </c:strRef>
          </c:tx>
          <c:spPr>
            <a:ln w="9525">
              <a:solidFill>
                <a:srgbClr val="00B0F0"/>
              </a:solidFill>
            </a:ln>
          </c:spPr>
          <c:marker>
            <c:symbol val="square"/>
            <c:size val="4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Q$29:$BQ$50</c:f>
                <c:numCache>
                  <c:formatCode>General</c:formatCode>
                  <c:ptCount val="22"/>
                  <c:pt idx="0">
                    <c:v>0.34933227853189613</c:v>
                  </c:pt>
                  <c:pt idx="1">
                    <c:v>0.59005758581590373</c:v>
                  </c:pt>
                  <c:pt idx="2">
                    <c:v>0.92988615276507502</c:v>
                  </c:pt>
                  <c:pt idx="3">
                    <c:v>0.79117237800154072</c:v>
                  </c:pt>
                  <c:pt idx="4">
                    <c:v>0.74530028230608114</c:v>
                  </c:pt>
                  <c:pt idx="5">
                    <c:v>1.3535428091288211</c:v>
                  </c:pt>
                  <c:pt idx="6">
                    <c:v>0.39300667298114367</c:v>
                  </c:pt>
                  <c:pt idx="7">
                    <c:v>0.73932748361414924</c:v>
                  </c:pt>
                  <c:pt idx="8">
                    <c:v>0.56864246061954549</c:v>
                  </c:pt>
                  <c:pt idx="9">
                    <c:v>0.25355937799912709</c:v>
                  </c:pt>
                  <c:pt idx="10">
                    <c:v>1.552253572291677</c:v>
                  </c:pt>
                  <c:pt idx="11">
                    <c:v>0.87771563314933843</c:v>
                  </c:pt>
                  <c:pt idx="12">
                    <c:v>0.21529484913446489</c:v>
                  </c:pt>
                  <c:pt idx="13">
                    <c:v>0.80802414453006455</c:v>
                  </c:pt>
                  <c:pt idx="14">
                    <c:v>1.5818552987108307</c:v>
                  </c:pt>
                  <c:pt idx="15">
                    <c:v>0.96176453451781962</c:v>
                  </c:pt>
                  <c:pt idx="16">
                    <c:v>0.78570675344959207</c:v>
                  </c:pt>
                  <c:pt idx="17">
                    <c:v>0.85087027943134408</c:v>
                  </c:pt>
                  <c:pt idx="18">
                    <c:v>1.4884757340274835</c:v>
                  </c:pt>
                  <c:pt idx="19">
                    <c:v>1.4881466936487913</c:v>
                  </c:pt>
                  <c:pt idx="20">
                    <c:v>1.8041528430908351</c:v>
                  </c:pt>
                  <c:pt idx="21">
                    <c:v>0.52548154672319058</c:v>
                  </c:pt>
                </c:numCache>
              </c:numRef>
            </c:plus>
            <c:minus>
              <c:numRef>
                <c:f>' Calculations'!$BQ$29:$BQ$50</c:f>
                <c:numCache>
                  <c:formatCode>General</c:formatCode>
                  <c:ptCount val="22"/>
                  <c:pt idx="0">
                    <c:v>0.34933227853189613</c:v>
                  </c:pt>
                  <c:pt idx="1">
                    <c:v>0.59005758581590373</c:v>
                  </c:pt>
                  <c:pt idx="2">
                    <c:v>0.92988615276507502</c:v>
                  </c:pt>
                  <c:pt idx="3">
                    <c:v>0.79117237800154072</c:v>
                  </c:pt>
                  <c:pt idx="4">
                    <c:v>0.74530028230608114</c:v>
                  </c:pt>
                  <c:pt idx="5">
                    <c:v>1.3535428091288211</c:v>
                  </c:pt>
                  <c:pt idx="6">
                    <c:v>0.39300667298114367</c:v>
                  </c:pt>
                  <c:pt idx="7">
                    <c:v>0.73932748361414924</c:v>
                  </c:pt>
                  <c:pt idx="8">
                    <c:v>0.56864246061954549</c:v>
                  </c:pt>
                  <c:pt idx="9">
                    <c:v>0.25355937799912709</c:v>
                  </c:pt>
                  <c:pt idx="10">
                    <c:v>1.552253572291677</c:v>
                  </c:pt>
                  <c:pt idx="11">
                    <c:v>0.87771563314933843</c:v>
                  </c:pt>
                  <c:pt idx="12">
                    <c:v>0.21529484913446489</c:v>
                  </c:pt>
                  <c:pt idx="13">
                    <c:v>0.80802414453006455</c:v>
                  </c:pt>
                  <c:pt idx="14">
                    <c:v>1.5818552987108307</c:v>
                  </c:pt>
                  <c:pt idx="15">
                    <c:v>0.96176453451781962</c:v>
                  </c:pt>
                  <c:pt idx="16">
                    <c:v>0.78570675344959207</c:v>
                  </c:pt>
                  <c:pt idx="17">
                    <c:v>0.85087027943134408</c:v>
                  </c:pt>
                  <c:pt idx="18">
                    <c:v>1.4884757340274835</c:v>
                  </c:pt>
                  <c:pt idx="19">
                    <c:v>1.4881466936487913</c:v>
                  </c:pt>
                  <c:pt idx="20">
                    <c:v>1.8041528430908351</c:v>
                  </c:pt>
                  <c:pt idx="21">
                    <c:v>0.52548154672319058</c:v>
                  </c:pt>
                </c:numCache>
              </c:numRef>
            </c:minus>
            <c:spPr>
              <a:ln>
                <a:solidFill>
                  <a:srgbClr val="00B0F0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Q$4:$BQ$25</c:f>
              <c:numCache>
                <c:formatCode>General</c:formatCode>
                <c:ptCount val="22"/>
                <c:pt idx="0">
                  <c:v>96.826192089318326</c:v>
                </c:pt>
                <c:pt idx="1">
                  <c:v>97.490836916332398</c:v>
                </c:pt>
                <c:pt idx="2">
                  <c:v>100</c:v>
                </c:pt>
                <c:pt idx="3">
                  <c:v>101.53022090505401</c:v>
                </c:pt>
                <c:pt idx="4">
                  <c:v>103.48570915930428</c:v>
                </c:pt>
                <c:pt idx="5">
                  <c:v>103.83052199199349</c:v>
                </c:pt>
                <c:pt idx="6">
                  <c:v>106.9262796893366</c:v>
                </c:pt>
                <c:pt idx="7">
                  <c:v>107.98096706032076</c:v>
                </c:pt>
                <c:pt idx="8">
                  <c:v>109.07940224543344</c:v>
                </c:pt>
                <c:pt idx="9">
                  <c:v>108.99786291673091</c:v>
                </c:pt>
                <c:pt idx="10">
                  <c:v>109.31999467054521</c:v>
                </c:pt>
                <c:pt idx="11">
                  <c:v>110.82595124279193</c:v>
                </c:pt>
                <c:pt idx="12">
                  <c:v>114.30053738003234</c:v>
                </c:pt>
                <c:pt idx="13">
                  <c:v>114.07671966514692</c:v>
                </c:pt>
                <c:pt idx="14">
                  <c:v>113.28896629430557</c:v>
                </c:pt>
                <c:pt idx="15">
                  <c:v>116.3230962828566</c:v>
                </c:pt>
                <c:pt idx="16">
                  <c:v>115.19893135369001</c:v>
                </c:pt>
                <c:pt idx="17">
                  <c:v>118.47407643646241</c:v>
                </c:pt>
                <c:pt idx="18">
                  <c:v>118.63782452538526</c:v>
                </c:pt>
                <c:pt idx="19">
                  <c:v>116.98207526752213</c:v>
                </c:pt>
                <c:pt idx="20">
                  <c:v>117.75816848183187</c:v>
                </c:pt>
                <c:pt idx="21">
                  <c:v>114.79482962516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12C-4042-9B74-6D4DF6D31BC9}"/>
            </c:ext>
          </c:extLst>
        </c:ser>
        <c:ser>
          <c:idx val="1"/>
          <c:order val="1"/>
          <c:tx>
            <c:strRef>
              <c:f>' Calculations'!$BR$3</c:f>
              <c:strCache>
                <c:ptCount val="1"/>
                <c:pt idx="0">
                  <c:v>5 µM UK5099</c:v>
                </c:pt>
              </c:strCache>
            </c:strRef>
          </c:tx>
          <c:spPr>
            <a:ln w="9525">
              <a:solidFill>
                <a:schemeClr val="accent2">
                  <a:lumMod val="75000"/>
                </a:schemeClr>
              </a:solidFill>
            </a:ln>
          </c:spPr>
          <c:marker>
            <c:symbol val="circle"/>
            <c:size val="4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R$29:$BR$50</c:f>
                <c:numCache>
                  <c:formatCode>General</c:formatCode>
                  <c:ptCount val="22"/>
                  <c:pt idx="0">
                    <c:v>1.123723319314919</c:v>
                  </c:pt>
                  <c:pt idx="1">
                    <c:v>1.2729904906159952</c:v>
                  </c:pt>
                  <c:pt idx="2">
                    <c:v>0.87667937978896249</c:v>
                  </c:pt>
                  <c:pt idx="3">
                    <c:v>1.0959933434638716</c:v>
                  </c:pt>
                  <c:pt idx="4">
                    <c:v>0.81255500396124392</c:v>
                  </c:pt>
                  <c:pt idx="5">
                    <c:v>0.40428038718063253</c:v>
                  </c:pt>
                  <c:pt idx="6">
                    <c:v>0.73344656233975714</c:v>
                  </c:pt>
                  <c:pt idx="7">
                    <c:v>1.1598890007870299</c:v>
                  </c:pt>
                  <c:pt idx="8">
                    <c:v>0.84900442400705178</c:v>
                  </c:pt>
                  <c:pt idx="9">
                    <c:v>0.98156064638084228</c:v>
                  </c:pt>
                  <c:pt idx="10">
                    <c:v>0.70281539979475294</c:v>
                  </c:pt>
                  <c:pt idx="11">
                    <c:v>0.78024607915721755</c:v>
                  </c:pt>
                  <c:pt idx="12">
                    <c:v>1.01524464469539</c:v>
                  </c:pt>
                  <c:pt idx="13">
                    <c:v>0.97360323238888069</c:v>
                  </c:pt>
                  <c:pt idx="14">
                    <c:v>1.0523053901628743</c:v>
                  </c:pt>
                  <c:pt idx="15">
                    <c:v>0.66254614770052145</c:v>
                  </c:pt>
                  <c:pt idx="16">
                    <c:v>0.46223723575254089</c:v>
                  </c:pt>
                  <c:pt idx="17">
                    <c:v>0.67577754787147903</c:v>
                  </c:pt>
                  <c:pt idx="18">
                    <c:v>0.7497370066284873</c:v>
                  </c:pt>
                  <c:pt idx="19">
                    <c:v>0.84215539298994402</c:v>
                  </c:pt>
                  <c:pt idx="20">
                    <c:v>0.63953676985872665</c:v>
                  </c:pt>
                  <c:pt idx="21">
                    <c:v>1.7821525101025038</c:v>
                  </c:pt>
                </c:numCache>
              </c:numRef>
            </c:plus>
            <c:minus>
              <c:numRef>
                <c:f>' Calculations'!$BR$29:$BR$50</c:f>
                <c:numCache>
                  <c:formatCode>General</c:formatCode>
                  <c:ptCount val="22"/>
                  <c:pt idx="0">
                    <c:v>1.123723319314919</c:v>
                  </c:pt>
                  <c:pt idx="1">
                    <c:v>1.2729904906159952</c:v>
                  </c:pt>
                  <c:pt idx="2">
                    <c:v>0.87667937978896249</c:v>
                  </c:pt>
                  <c:pt idx="3">
                    <c:v>1.0959933434638716</c:v>
                  </c:pt>
                  <c:pt idx="4">
                    <c:v>0.81255500396124392</c:v>
                  </c:pt>
                  <c:pt idx="5">
                    <c:v>0.40428038718063253</c:v>
                  </c:pt>
                  <c:pt idx="6">
                    <c:v>0.73344656233975714</c:v>
                  </c:pt>
                  <c:pt idx="7">
                    <c:v>1.1598890007870299</c:v>
                  </c:pt>
                  <c:pt idx="8">
                    <c:v>0.84900442400705178</c:v>
                  </c:pt>
                  <c:pt idx="9">
                    <c:v>0.98156064638084228</c:v>
                  </c:pt>
                  <c:pt idx="10">
                    <c:v>0.70281539979475294</c:v>
                  </c:pt>
                  <c:pt idx="11">
                    <c:v>0.78024607915721755</c:v>
                  </c:pt>
                  <c:pt idx="12">
                    <c:v>1.01524464469539</c:v>
                  </c:pt>
                  <c:pt idx="13">
                    <c:v>0.97360323238888069</c:v>
                  </c:pt>
                  <c:pt idx="14">
                    <c:v>1.0523053901628743</c:v>
                  </c:pt>
                  <c:pt idx="15">
                    <c:v>0.66254614770052145</c:v>
                  </c:pt>
                  <c:pt idx="16">
                    <c:v>0.46223723575254089</c:v>
                  </c:pt>
                  <c:pt idx="17">
                    <c:v>0.67577754787147903</c:v>
                  </c:pt>
                  <c:pt idx="18">
                    <c:v>0.7497370066284873</c:v>
                  </c:pt>
                  <c:pt idx="19">
                    <c:v>0.84215539298994402</c:v>
                  </c:pt>
                  <c:pt idx="20">
                    <c:v>0.63953676985872665</c:v>
                  </c:pt>
                  <c:pt idx="21">
                    <c:v>1.7821525101025038</c:v>
                  </c:pt>
                </c:numCache>
              </c:numRef>
            </c:minus>
            <c:spPr>
              <a:ln>
                <a:solidFill>
                  <a:schemeClr val="accent2">
                    <a:lumMod val="75000"/>
                  </a:schemeClr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R$4:$BR$25</c:f>
              <c:numCache>
                <c:formatCode>General</c:formatCode>
                <c:ptCount val="22"/>
                <c:pt idx="0">
                  <c:v>95.407335866307037</c:v>
                </c:pt>
                <c:pt idx="1">
                  <c:v>98.72862860139881</c:v>
                </c:pt>
                <c:pt idx="2">
                  <c:v>100</c:v>
                </c:pt>
                <c:pt idx="3">
                  <c:v>140.71113311459777</c:v>
                </c:pt>
                <c:pt idx="4">
                  <c:v>144.38638071310683</c:v>
                </c:pt>
                <c:pt idx="5">
                  <c:v>145.52459284814771</c:v>
                </c:pt>
                <c:pt idx="6">
                  <c:v>147.07725206720917</c:v>
                </c:pt>
                <c:pt idx="7">
                  <c:v>147.76251633701995</c:v>
                </c:pt>
                <c:pt idx="8">
                  <c:v>151.87649214375313</c:v>
                </c:pt>
                <c:pt idx="9">
                  <c:v>151.01869148671645</c:v>
                </c:pt>
                <c:pt idx="10">
                  <c:v>154.1728149066748</c:v>
                </c:pt>
                <c:pt idx="11">
                  <c:v>156.61450840240323</c:v>
                </c:pt>
                <c:pt idx="12">
                  <c:v>156.9877430759463</c:v>
                </c:pt>
                <c:pt idx="13">
                  <c:v>157.69383543065968</c:v>
                </c:pt>
                <c:pt idx="14">
                  <c:v>159.77343024212243</c:v>
                </c:pt>
                <c:pt idx="15">
                  <c:v>161.07507882298773</c:v>
                </c:pt>
                <c:pt idx="16">
                  <c:v>162.16850579817449</c:v>
                </c:pt>
                <c:pt idx="17">
                  <c:v>163.16119508706203</c:v>
                </c:pt>
                <c:pt idx="18">
                  <c:v>162.13229000229526</c:v>
                </c:pt>
                <c:pt idx="19">
                  <c:v>160.79113533591669</c:v>
                </c:pt>
                <c:pt idx="20">
                  <c:v>163.41285477117782</c:v>
                </c:pt>
                <c:pt idx="21">
                  <c:v>163.1410652992784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12C-4042-9B74-6D4DF6D31BC9}"/>
            </c:ext>
          </c:extLst>
        </c:ser>
        <c:ser>
          <c:idx val="2"/>
          <c:order val="2"/>
          <c:tx>
            <c:strRef>
              <c:f>' Calculations'!$BS$3</c:f>
              <c:strCache>
                <c:ptCount val="1"/>
                <c:pt idx="0">
                  <c:v>10 µM Idebenone</c:v>
                </c:pt>
              </c:strCache>
            </c:strRef>
          </c:tx>
          <c:spPr>
            <a:ln w="9525"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S$29:$BS$50</c:f>
                <c:numCache>
                  <c:formatCode>General</c:formatCode>
                  <c:ptCount val="22"/>
                  <c:pt idx="0">
                    <c:v>0.99320120505824261</c:v>
                  </c:pt>
                  <c:pt idx="1">
                    <c:v>0.8488700249993143</c:v>
                  </c:pt>
                  <c:pt idx="2">
                    <c:v>0.28142660188114693</c:v>
                  </c:pt>
                  <c:pt idx="3">
                    <c:v>1.2687258267839348</c:v>
                  </c:pt>
                  <c:pt idx="4">
                    <c:v>0.94514125416355432</c:v>
                  </c:pt>
                  <c:pt idx="5">
                    <c:v>0.38413144654435011</c:v>
                  </c:pt>
                  <c:pt idx="6">
                    <c:v>1.1531335886405985</c:v>
                  </c:pt>
                  <c:pt idx="7">
                    <c:v>1.2482870202667851</c:v>
                  </c:pt>
                  <c:pt idx="8">
                    <c:v>1.0375050375415862</c:v>
                  </c:pt>
                  <c:pt idx="9">
                    <c:v>1.0633808514169327</c:v>
                  </c:pt>
                  <c:pt idx="10">
                    <c:v>1.0010079792873061</c:v>
                  </c:pt>
                  <c:pt idx="11">
                    <c:v>1.0952741973175923</c:v>
                  </c:pt>
                  <c:pt idx="12">
                    <c:v>1.3650427648354588</c:v>
                  </c:pt>
                  <c:pt idx="13">
                    <c:v>1.2252609387603077</c:v>
                  </c:pt>
                  <c:pt idx="14">
                    <c:v>1.1913787305141523</c:v>
                  </c:pt>
                  <c:pt idx="15">
                    <c:v>0.72400804636795091</c:v>
                  </c:pt>
                  <c:pt idx="16">
                    <c:v>0.91478215536876761</c:v>
                  </c:pt>
                  <c:pt idx="17">
                    <c:v>0.48991035802636773</c:v>
                  </c:pt>
                  <c:pt idx="18">
                    <c:v>1.4876952654120388</c:v>
                  </c:pt>
                  <c:pt idx="19">
                    <c:v>1.0334165689748991</c:v>
                  </c:pt>
                  <c:pt idx="20">
                    <c:v>1.2972502895221718</c:v>
                  </c:pt>
                  <c:pt idx="21">
                    <c:v>1.1342729781492062</c:v>
                  </c:pt>
                </c:numCache>
              </c:numRef>
            </c:plus>
            <c:minus>
              <c:numRef>
                <c:f>' Calculations'!$BS$29:$BS$50</c:f>
                <c:numCache>
                  <c:formatCode>General</c:formatCode>
                  <c:ptCount val="22"/>
                  <c:pt idx="0">
                    <c:v>0.99320120505824261</c:v>
                  </c:pt>
                  <c:pt idx="1">
                    <c:v>0.8488700249993143</c:v>
                  </c:pt>
                  <c:pt idx="2">
                    <c:v>0.28142660188114693</c:v>
                  </c:pt>
                  <c:pt idx="3">
                    <c:v>1.2687258267839348</c:v>
                  </c:pt>
                  <c:pt idx="4">
                    <c:v>0.94514125416355432</c:v>
                  </c:pt>
                  <c:pt idx="5">
                    <c:v>0.38413144654435011</c:v>
                  </c:pt>
                  <c:pt idx="6">
                    <c:v>1.1531335886405985</c:v>
                  </c:pt>
                  <c:pt idx="7">
                    <c:v>1.2482870202667851</c:v>
                  </c:pt>
                  <c:pt idx="8">
                    <c:v>1.0375050375415862</c:v>
                  </c:pt>
                  <c:pt idx="9">
                    <c:v>1.0633808514169327</c:v>
                  </c:pt>
                  <c:pt idx="10">
                    <c:v>1.0010079792873061</c:v>
                  </c:pt>
                  <c:pt idx="11">
                    <c:v>1.0952741973175923</c:v>
                  </c:pt>
                  <c:pt idx="12">
                    <c:v>1.3650427648354588</c:v>
                  </c:pt>
                  <c:pt idx="13">
                    <c:v>1.2252609387603077</c:v>
                  </c:pt>
                  <c:pt idx="14">
                    <c:v>1.1913787305141523</c:v>
                  </c:pt>
                  <c:pt idx="15">
                    <c:v>0.72400804636795091</c:v>
                  </c:pt>
                  <c:pt idx="16">
                    <c:v>0.91478215536876761</c:v>
                  </c:pt>
                  <c:pt idx="17">
                    <c:v>0.48991035802636773</c:v>
                  </c:pt>
                  <c:pt idx="18">
                    <c:v>1.4876952654120388</c:v>
                  </c:pt>
                  <c:pt idx="19">
                    <c:v>1.0334165689748991</c:v>
                  </c:pt>
                  <c:pt idx="20">
                    <c:v>1.2972502895221718</c:v>
                  </c:pt>
                  <c:pt idx="21">
                    <c:v>1.1342729781492062</c:v>
                  </c:pt>
                </c:numCache>
              </c:numRef>
            </c:minus>
            <c:spPr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S$4:$BS$25</c:f>
              <c:numCache>
                <c:formatCode>General</c:formatCode>
                <c:ptCount val="22"/>
                <c:pt idx="0">
                  <c:v>99.528091632826488</c:v>
                </c:pt>
                <c:pt idx="1">
                  <c:v>99.20507503421409</c:v>
                </c:pt>
                <c:pt idx="2">
                  <c:v>100</c:v>
                </c:pt>
                <c:pt idx="3">
                  <c:v>107.32417050402599</c:v>
                </c:pt>
                <c:pt idx="4">
                  <c:v>109.99055562192308</c:v>
                </c:pt>
                <c:pt idx="5">
                  <c:v>112.46881366082597</c:v>
                </c:pt>
                <c:pt idx="6">
                  <c:v>112.17026283413838</c:v>
                </c:pt>
                <c:pt idx="7">
                  <c:v>113.47447843259486</c:v>
                </c:pt>
                <c:pt idx="8">
                  <c:v>114.04014110058181</c:v>
                </c:pt>
                <c:pt idx="9">
                  <c:v>113.90535276110573</c:v>
                </c:pt>
                <c:pt idx="10">
                  <c:v>115.8798462863212</c:v>
                </c:pt>
                <c:pt idx="11">
                  <c:v>115.93218351527941</c:v>
                </c:pt>
                <c:pt idx="12">
                  <c:v>117.13125421749177</c:v>
                </c:pt>
                <c:pt idx="13">
                  <c:v>116.12470975881581</c:v>
                </c:pt>
                <c:pt idx="14">
                  <c:v>119.25847029448529</c:v>
                </c:pt>
                <c:pt idx="15">
                  <c:v>118.79905323021633</c:v>
                </c:pt>
                <c:pt idx="16">
                  <c:v>119.21351101936423</c:v>
                </c:pt>
                <c:pt idx="17">
                  <c:v>119.12937636061334</c:v>
                </c:pt>
                <c:pt idx="18">
                  <c:v>120.30973314247626</c:v>
                </c:pt>
                <c:pt idx="19">
                  <c:v>119.9555610842399</c:v>
                </c:pt>
                <c:pt idx="20">
                  <c:v>120.13764662276338</c:v>
                </c:pt>
                <c:pt idx="21">
                  <c:v>120.752162251641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12C-4042-9B74-6D4DF6D31BC9}"/>
            </c:ext>
          </c:extLst>
        </c:ser>
        <c:ser>
          <c:idx val="3"/>
          <c:order val="3"/>
          <c:tx>
            <c:strRef>
              <c:f>' Calculations'!$BT$3</c:f>
              <c:strCache>
                <c:ptCount val="1"/>
                <c:pt idx="0">
                  <c:v>10 µM Diclazuril</c:v>
                </c:pt>
              </c:strCache>
            </c:strRef>
          </c:tx>
          <c:spPr>
            <a:ln w="9525">
              <a:solidFill>
                <a:schemeClr val="accent2">
                  <a:lumMod val="40000"/>
                  <a:lumOff val="60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accent2">
                  <a:lumMod val="40000"/>
                  <a:lumOff val="60000"/>
                </a:schemeClr>
              </a:solidFill>
              <a:ln w="9525">
                <a:solidFill>
                  <a:schemeClr val="accent2">
                    <a:lumMod val="40000"/>
                    <a:lumOff val="6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T$29:$BT$50</c:f>
                <c:numCache>
                  <c:formatCode>General</c:formatCode>
                  <c:ptCount val="22"/>
                  <c:pt idx="0">
                    <c:v>1.2357411437619394</c:v>
                  </c:pt>
                  <c:pt idx="1">
                    <c:v>0.57493608852911771</c:v>
                  </c:pt>
                  <c:pt idx="2">
                    <c:v>0.88485823582879974</c:v>
                  </c:pt>
                  <c:pt idx="3">
                    <c:v>1.8193991832205274</c:v>
                  </c:pt>
                  <c:pt idx="4">
                    <c:v>0.97819173984848784</c:v>
                  </c:pt>
                  <c:pt idx="5">
                    <c:v>1.074434702727211</c:v>
                  </c:pt>
                  <c:pt idx="6">
                    <c:v>0.91695476647900664</c:v>
                  </c:pt>
                  <c:pt idx="7">
                    <c:v>0.7609956357212323</c:v>
                  </c:pt>
                  <c:pt idx="8">
                    <c:v>0.92998873049975761</c:v>
                  </c:pt>
                  <c:pt idx="9">
                    <c:v>0.91598431828210236</c:v>
                  </c:pt>
                  <c:pt idx="10">
                    <c:v>0.7708466522007833</c:v>
                  </c:pt>
                  <c:pt idx="11">
                    <c:v>1.043718442046254</c:v>
                  </c:pt>
                  <c:pt idx="12">
                    <c:v>0.80320248921644866</c:v>
                  </c:pt>
                  <c:pt idx="13">
                    <c:v>1.7305129535127719</c:v>
                  </c:pt>
                  <c:pt idx="14">
                    <c:v>0.96626607397442643</c:v>
                  </c:pt>
                  <c:pt idx="15">
                    <c:v>1.2301407523009102</c:v>
                  </c:pt>
                  <c:pt idx="16">
                    <c:v>1.7420804941189305</c:v>
                  </c:pt>
                  <c:pt idx="17">
                    <c:v>1.065856932666815</c:v>
                  </c:pt>
                  <c:pt idx="18">
                    <c:v>0.92375032156879666</c:v>
                  </c:pt>
                  <c:pt idx="19">
                    <c:v>1.0562916867924079</c:v>
                  </c:pt>
                  <c:pt idx="20">
                    <c:v>1.0096755831675845</c:v>
                  </c:pt>
                  <c:pt idx="21">
                    <c:v>1.3307023192137895</c:v>
                  </c:pt>
                </c:numCache>
              </c:numRef>
            </c:plus>
            <c:minus>
              <c:numRef>
                <c:f>' Calculations'!$BT$29:$BT$50</c:f>
                <c:numCache>
                  <c:formatCode>General</c:formatCode>
                  <c:ptCount val="22"/>
                  <c:pt idx="0">
                    <c:v>1.2357411437619394</c:v>
                  </c:pt>
                  <c:pt idx="1">
                    <c:v>0.57493608852911771</c:v>
                  </c:pt>
                  <c:pt idx="2">
                    <c:v>0.88485823582879974</c:v>
                  </c:pt>
                  <c:pt idx="3">
                    <c:v>1.8193991832205274</c:v>
                  </c:pt>
                  <c:pt idx="4">
                    <c:v>0.97819173984848784</c:v>
                  </c:pt>
                  <c:pt idx="5">
                    <c:v>1.074434702727211</c:v>
                  </c:pt>
                  <c:pt idx="6">
                    <c:v>0.91695476647900664</c:v>
                  </c:pt>
                  <c:pt idx="7">
                    <c:v>0.7609956357212323</c:v>
                  </c:pt>
                  <c:pt idx="8">
                    <c:v>0.92998873049975761</c:v>
                  </c:pt>
                  <c:pt idx="9">
                    <c:v>0.91598431828210236</c:v>
                  </c:pt>
                  <c:pt idx="10">
                    <c:v>0.7708466522007833</c:v>
                  </c:pt>
                  <c:pt idx="11">
                    <c:v>1.043718442046254</c:v>
                  </c:pt>
                  <c:pt idx="12">
                    <c:v>0.80320248921644866</c:v>
                  </c:pt>
                  <c:pt idx="13">
                    <c:v>1.7305129535127719</c:v>
                  </c:pt>
                  <c:pt idx="14">
                    <c:v>0.96626607397442643</c:v>
                  </c:pt>
                  <c:pt idx="15">
                    <c:v>1.2301407523009102</c:v>
                  </c:pt>
                  <c:pt idx="16">
                    <c:v>1.7420804941189305</c:v>
                  </c:pt>
                  <c:pt idx="17">
                    <c:v>1.065856932666815</c:v>
                  </c:pt>
                  <c:pt idx="18">
                    <c:v>0.92375032156879666</c:v>
                  </c:pt>
                  <c:pt idx="19">
                    <c:v>1.0562916867924079</c:v>
                  </c:pt>
                  <c:pt idx="20">
                    <c:v>1.0096755831675845</c:v>
                  </c:pt>
                  <c:pt idx="21">
                    <c:v>1.3307023192137895</c:v>
                  </c:pt>
                </c:numCache>
              </c:numRef>
            </c:minus>
            <c:spPr>
              <a:ln>
                <a:solidFill>
                  <a:schemeClr val="accent2">
                    <a:lumMod val="40000"/>
                    <a:lumOff val="60000"/>
                  </a:schemeClr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T$4:$BT$25</c:f>
              <c:numCache>
                <c:formatCode>General</c:formatCode>
                <c:ptCount val="22"/>
                <c:pt idx="0">
                  <c:v>98.246399245657912</c:v>
                </c:pt>
                <c:pt idx="1">
                  <c:v>96.941476744610739</c:v>
                </c:pt>
                <c:pt idx="2">
                  <c:v>100</c:v>
                </c:pt>
                <c:pt idx="3">
                  <c:v>125.71220740632263</c:v>
                </c:pt>
                <c:pt idx="4">
                  <c:v>127.14273102880304</c:v>
                </c:pt>
                <c:pt idx="5">
                  <c:v>129.98166109905665</c:v>
                </c:pt>
                <c:pt idx="6">
                  <c:v>129.75717462274133</c:v>
                </c:pt>
                <c:pt idx="7">
                  <c:v>133.30988384936609</c:v>
                </c:pt>
                <c:pt idx="8">
                  <c:v>129.50879223471043</c:v>
                </c:pt>
                <c:pt idx="9">
                  <c:v>133.70459873249979</c:v>
                </c:pt>
                <c:pt idx="10">
                  <c:v>133.81512794289304</c:v>
                </c:pt>
                <c:pt idx="11">
                  <c:v>133.78156434504626</c:v>
                </c:pt>
                <c:pt idx="12">
                  <c:v>135.12137316625859</c:v>
                </c:pt>
                <c:pt idx="13">
                  <c:v>135.4376439712606</c:v>
                </c:pt>
                <c:pt idx="14">
                  <c:v>131.78581682516304</c:v>
                </c:pt>
                <c:pt idx="15">
                  <c:v>135.01051773229287</c:v>
                </c:pt>
                <c:pt idx="16">
                  <c:v>133.30658891709453</c:v>
                </c:pt>
                <c:pt idx="17">
                  <c:v>135.0444646494762</c:v>
                </c:pt>
                <c:pt idx="18">
                  <c:v>132.49490496914029</c:v>
                </c:pt>
                <c:pt idx="19">
                  <c:v>134.75138497598473</c:v>
                </c:pt>
                <c:pt idx="20">
                  <c:v>135.10130332416247</c:v>
                </c:pt>
                <c:pt idx="21">
                  <c:v>134.424989219524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12C-4042-9B74-6D4DF6D31BC9}"/>
            </c:ext>
          </c:extLst>
        </c:ser>
        <c:ser>
          <c:idx val="4"/>
          <c:order val="4"/>
          <c:tx>
            <c:strRef>
              <c:f>' Calculations'!$BU$3</c:f>
              <c:strCache>
                <c:ptCount val="1"/>
                <c:pt idx="0">
                  <c:v>10 µM Dicumerol</c:v>
                </c:pt>
              </c:strCache>
            </c:strRef>
          </c:tx>
          <c:spPr>
            <a:ln w="952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U$29:$BU$50</c:f>
                <c:numCache>
                  <c:formatCode>General</c:formatCode>
                  <c:ptCount val="22"/>
                  <c:pt idx="0">
                    <c:v>1.5720906884502881</c:v>
                  </c:pt>
                  <c:pt idx="1">
                    <c:v>1.7316702129781032</c:v>
                  </c:pt>
                  <c:pt idx="2">
                    <c:v>0.57896993734663804</c:v>
                  </c:pt>
                  <c:pt idx="3">
                    <c:v>2.1509015833121068</c:v>
                  </c:pt>
                  <c:pt idx="4">
                    <c:v>0.98928621256645988</c:v>
                  </c:pt>
                  <c:pt idx="5">
                    <c:v>0.95459212306552044</c:v>
                  </c:pt>
                  <c:pt idx="6">
                    <c:v>0.82718075924318635</c:v>
                  </c:pt>
                  <c:pt idx="7">
                    <c:v>1.8165754150260189</c:v>
                  </c:pt>
                  <c:pt idx="8">
                    <c:v>1.9505228537728847</c:v>
                  </c:pt>
                  <c:pt idx="9">
                    <c:v>0.66492966250023811</c:v>
                  </c:pt>
                  <c:pt idx="10">
                    <c:v>0.78796045210304932</c:v>
                  </c:pt>
                  <c:pt idx="11">
                    <c:v>1.221500832282111</c:v>
                  </c:pt>
                  <c:pt idx="12">
                    <c:v>0.86371176463810384</c:v>
                  </c:pt>
                  <c:pt idx="13">
                    <c:v>1.3450844648061411</c:v>
                  </c:pt>
                  <c:pt idx="14">
                    <c:v>1.2548690781611582</c:v>
                  </c:pt>
                  <c:pt idx="15">
                    <c:v>1.0077998508028823</c:v>
                  </c:pt>
                  <c:pt idx="16">
                    <c:v>1.4409406892173069</c:v>
                  </c:pt>
                  <c:pt idx="17">
                    <c:v>1.4892913449873542</c:v>
                  </c:pt>
                  <c:pt idx="18">
                    <c:v>1.7774408506961257</c:v>
                  </c:pt>
                  <c:pt idx="19">
                    <c:v>1.1733681341525093</c:v>
                  </c:pt>
                  <c:pt idx="20">
                    <c:v>1.7160376316903325</c:v>
                  </c:pt>
                  <c:pt idx="21">
                    <c:v>1.0428852309141681</c:v>
                  </c:pt>
                </c:numCache>
              </c:numRef>
            </c:plus>
            <c:minus>
              <c:numRef>
                <c:f>' Calculations'!$BU$29:$BU$50</c:f>
                <c:numCache>
                  <c:formatCode>General</c:formatCode>
                  <c:ptCount val="22"/>
                  <c:pt idx="0">
                    <c:v>1.5720906884502881</c:v>
                  </c:pt>
                  <c:pt idx="1">
                    <c:v>1.7316702129781032</c:v>
                  </c:pt>
                  <c:pt idx="2">
                    <c:v>0.57896993734663804</c:v>
                  </c:pt>
                  <c:pt idx="3">
                    <c:v>2.1509015833121068</c:v>
                  </c:pt>
                  <c:pt idx="4">
                    <c:v>0.98928621256645988</c:v>
                  </c:pt>
                  <c:pt idx="5">
                    <c:v>0.95459212306552044</c:v>
                  </c:pt>
                  <c:pt idx="6">
                    <c:v>0.82718075924318635</c:v>
                  </c:pt>
                  <c:pt idx="7">
                    <c:v>1.8165754150260189</c:v>
                  </c:pt>
                  <c:pt idx="8">
                    <c:v>1.9505228537728847</c:v>
                  </c:pt>
                  <c:pt idx="9">
                    <c:v>0.66492966250023811</c:v>
                  </c:pt>
                  <c:pt idx="10">
                    <c:v>0.78796045210304932</c:v>
                  </c:pt>
                  <c:pt idx="11">
                    <c:v>1.221500832282111</c:v>
                  </c:pt>
                  <c:pt idx="12">
                    <c:v>0.86371176463810384</c:v>
                  </c:pt>
                  <c:pt idx="13">
                    <c:v>1.3450844648061411</c:v>
                  </c:pt>
                  <c:pt idx="14">
                    <c:v>1.2548690781611582</c:v>
                  </c:pt>
                  <c:pt idx="15">
                    <c:v>1.0077998508028823</c:v>
                  </c:pt>
                  <c:pt idx="16">
                    <c:v>1.4409406892173069</c:v>
                  </c:pt>
                  <c:pt idx="17">
                    <c:v>1.4892913449873542</c:v>
                  </c:pt>
                  <c:pt idx="18">
                    <c:v>1.7774408506961257</c:v>
                  </c:pt>
                  <c:pt idx="19">
                    <c:v>1.1733681341525093</c:v>
                  </c:pt>
                  <c:pt idx="20">
                    <c:v>1.7160376316903325</c:v>
                  </c:pt>
                  <c:pt idx="21">
                    <c:v>1.0428852309141681</c:v>
                  </c:pt>
                </c:numCache>
              </c:numRef>
            </c:minus>
            <c:spPr>
              <a:ln>
                <a:solidFill>
                  <a:srgbClr val="00B050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U$4:$BU$25</c:f>
              <c:numCache>
                <c:formatCode>General</c:formatCode>
                <c:ptCount val="22"/>
                <c:pt idx="0">
                  <c:v>96.25760963261591</c:v>
                </c:pt>
                <c:pt idx="1">
                  <c:v>97.591146454264106</c:v>
                </c:pt>
                <c:pt idx="2">
                  <c:v>100</c:v>
                </c:pt>
                <c:pt idx="3">
                  <c:v>130.62282878068231</c:v>
                </c:pt>
                <c:pt idx="4">
                  <c:v>140.00794195715858</c:v>
                </c:pt>
                <c:pt idx="5">
                  <c:v>140.88006486386095</c:v>
                </c:pt>
                <c:pt idx="6">
                  <c:v>141.46410811152242</c:v>
                </c:pt>
                <c:pt idx="7">
                  <c:v>141.92690048295938</c:v>
                </c:pt>
                <c:pt idx="8">
                  <c:v>139.65323745386834</c:v>
                </c:pt>
                <c:pt idx="9">
                  <c:v>137.81156267477422</c:v>
                </c:pt>
                <c:pt idx="10">
                  <c:v>136.21217238411046</c:v>
                </c:pt>
                <c:pt idx="11">
                  <c:v>135.81424493950323</c:v>
                </c:pt>
                <c:pt idx="12">
                  <c:v>135.51427752780774</c:v>
                </c:pt>
                <c:pt idx="13">
                  <c:v>133.64740295510833</c:v>
                </c:pt>
                <c:pt idx="14">
                  <c:v>131.37155829643129</c:v>
                </c:pt>
                <c:pt idx="15">
                  <c:v>133.5846070870513</c:v>
                </c:pt>
                <c:pt idx="16">
                  <c:v>132.5190768736596</c:v>
                </c:pt>
                <c:pt idx="17">
                  <c:v>135.23949990166312</c:v>
                </c:pt>
                <c:pt idx="18">
                  <c:v>136.93142449301726</c:v>
                </c:pt>
                <c:pt idx="19">
                  <c:v>137.25584546956796</c:v>
                </c:pt>
                <c:pt idx="20">
                  <c:v>137.68018958367549</c:v>
                </c:pt>
                <c:pt idx="21">
                  <c:v>135.291379228432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A12C-4042-9B74-6D4DF6D31BC9}"/>
            </c:ext>
          </c:extLst>
        </c:ser>
        <c:ser>
          <c:idx val="5"/>
          <c:order val="5"/>
          <c:tx>
            <c:strRef>
              <c:f>' Calculations'!$BV$3</c:f>
              <c:strCache>
                <c:ptCount val="1"/>
                <c:pt idx="0">
                  <c:v>5 µM UK5099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star"/>
            <c:size val="4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V$29:$BV$50</c:f>
                <c:numCache>
                  <c:formatCode>General</c:formatCode>
                  <c:ptCount val="22"/>
                  <c:pt idx="0">
                    <c:v>0.88630592891231463</c:v>
                  </c:pt>
                  <c:pt idx="1">
                    <c:v>1.1583824771961868</c:v>
                  </c:pt>
                  <c:pt idx="2">
                    <c:v>0.97494602435749433</c:v>
                  </c:pt>
                  <c:pt idx="3">
                    <c:v>1.4327079014156059</c:v>
                  </c:pt>
                  <c:pt idx="4">
                    <c:v>1.1886426482603751</c:v>
                  </c:pt>
                  <c:pt idx="5">
                    <c:v>1.6483372848547992</c:v>
                  </c:pt>
                  <c:pt idx="6">
                    <c:v>1.377700359213913</c:v>
                  </c:pt>
                  <c:pt idx="7">
                    <c:v>1.3083756193489959</c:v>
                  </c:pt>
                  <c:pt idx="8">
                    <c:v>1.0166597829922208</c:v>
                  </c:pt>
                  <c:pt idx="9">
                    <c:v>1.0308920097808907</c:v>
                  </c:pt>
                  <c:pt idx="10">
                    <c:v>0.40254796179074614</c:v>
                  </c:pt>
                  <c:pt idx="11">
                    <c:v>0.51128003995532345</c:v>
                  </c:pt>
                  <c:pt idx="12">
                    <c:v>1.38084453343928</c:v>
                  </c:pt>
                  <c:pt idx="13">
                    <c:v>1.2599492049028915</c:v>
                  </c:pt>
                  <c:pt idx="14">
                    <c:v>1.2905764122760999</c:v>
                  </c:pt>
                  <c:pt idx="15">
                    <c:v>1.438193221608876</c:v>
                  </c:pt>
                  <c:pt idx="16">
                    <c:v>1.8025640787410844</c:v>
                  </c:pt>
                  <c:pt idx="17">
                    <c:v>1.1469969667584266</c:v>
                  </c:pt>
                  <c:pt idx="18">
                    <c:v>1.0631608169427602</c:v>
                  </c:pt>
                  <c:pt idx="19">
                    <c:v>1.5842178613811944</c:v>
                  </c:pt>
                  <c:pt idx="20">
                    <c:v>1.1629023705436254</c:v>
                  </c:pt>
                  <c:pt idx="21">
                    <c:v>0.71023974668048806</c:v>
                  </c:pt>
                </c:numCache>
              </c:numRef>
            </c:plus>
            <c:minus>
              <c:numRef>
                <c:f>' Calculations'!$BV$29:$BV$50</c:f>
                <c:numCache>
                  <c:formatCode>General</c:formatCode>
                  <c:ptCount val="22"/>
                  <c:pt idx="0">
                    <c:v>0.88630592891231463</c:v>
                  </c:pt>
                  <c:pt idx="1">
                    <c:v>1.1583824771961868</c:v>
                  </c:pt>
                  <c:pt idx="2">
                    <c:v>0.97494602435749433</c:v>
                  </c:pt>
                  <c:pt idx="3">
                    <c:v>1.4327079014156059</c:v>
                  </c:pt>
                  <c:pt idx="4">
                    <c:v>1.1886426482603751</c:v>
                  </c:pt>
                  <c:pt idx="5">
                    <c:v>1.6483372848547992</c:v>
                  </c:pt>
                  <c:pt idx="6">
                    <c:v>1.377700359213913</c:v>
                  </c:pt>
                  <c:pt idx="7">
                    <c:v>1.3083756193489959</c:v>
                  </c:pt>
                  <c:pt idx="8">
                    <c:v>1.0166597829922208</c:v>
                  </c:pt>
                  <c:pt idx="9">
                    <c:v>1.0308920097808907</c:v>
                  </c:pt>
                  <c:pt idx="10">
                    <c:v>0.40254796179074614</c:v>
                  </c:pt>
                  <c:pt idx="11">
                    <c:v>0.51128003995532345</c:v>
                  </c:pt>
                  <c:pt idx="12">
                    <c:v>1.38084453343928</c:v>
                  </c:pt>
                  <c:pt idx="13">
                    <c:v>1.2599492049028915</c:v>
                  </c:pt>
                  <c:pt idx="14">
                    <c:v>1.2905764122760999</c:v>
                  </c:pt>
                  <c:pt idx="15">
                    <c:v>1.438193221608876</c:v>
                  </c:pt>
                  <c:pt idx="16">
                    <c:v>1.8025640787410844</c:v>
                  </c:pt>
                  <c:pt idx="17">
                    <c:v>1.1469969667584266</c:v>
                  </c:pt>
                  <c:pt idx="18">
                    <c:v>1.0631608169427602</c:v>
                  </c:pt>
                  <c:pt idx="19">
                    <c:v>1.5842178613811944</c:v>
                  </c:pt>
                  <c:pt idx="20">
                    <c:v>1.1629023705436254</c:v>
                  </c:pt>
                  <c:pt idx="21">
                    <c:v>0.71023974668048806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V$4:$BV$25</c:f>
              <c:numCache>
                <c:formatCode>General</c:formatCode>
                <c:ptCount val="22"/>
                <c:pt idx="0">
                  <c:v>98.492771392300114</c:v>
                </c:pt>
                <c:pt idx="1">
                  <c:v>99.978139831773689</c:v>
                </c:pt>
                <c:pt idx="2">
                  <c:v>100</c:v>
                </c:pt>
                <c:pt idx="3">
                  <c:v>145.19221828209655</c:v>
                </c:pt>
                <c:pt idx="4">
                  <c:v>145.53231269575051</c:v>
                </c:pt>
                <c:pt idx="5">
                  <c:v>146.97534237970601</c:v>
                </c:pt>
                <c:pt idx="6">
                  <c:v>153.71941486829678</c:v>
                </c:pt>
                <c:pt idx="7">
                  <c:v>152.68370208090298</c:v>
                </c:pt>
                <c:pt idx="8">
                  <c:v>153.83813063362538</c:v>
                </c:pt>
                <c:pt idx="9">
                  <c:v>153.92984547132406</c:v>
                </c:pt>
                <c:pt idx="10">
                  <c:v>155.24662403502251</c:v>
                </c:pt>
                <c:pt idx="11">
                  <c:v>157.68192701929345</c:v>
                </c:pt>
                <c:pt idx="12">
                  <c:v>157.988143173151</c:v>
                </c:pt>
                <c:pt idx="13">
                  <c:v>158.24929440777575</c:v>
                </c:pt>
                <c:pt idx="14">
                  <c:v>162.70646660732282</c:v>
                </c:pt>
                <c:pt idx="15">
                  <c:v>162.44846357782944</c:v>
                </c:pt>
                <c:pt idx="16">
                  <c:v>163.36562925534028</c:v>
                </c:pt>
                <c:pt idx="17">
                  <c:v>166.97514503064266</c:v>
                </c:pt>
                <c:pt idx="18">
                  <c:v>166.87411869388075</c:v>
                </c:pt>
                <c:pt idx="19">
                  <c:v>168.28999165481605</c:v>
                </c:pt>
                <c:pt idx="20">
                  <c:v>170.7631552406028</c:v>
                </c:pt>
                <c:pt idx="21">
                  <c:v>167.227826820160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12C-4042-9B74-6D4DF6D31B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915737280"/>
        <c:axId val="-850890416"/>
      </c:scatterChart>
      <c:valAx>
        <c:axId val="-9157372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-850890416"/>
        <c:crosses val="autoZero"/>
        <c:crossBetween val="midCat"/>
      </c:valAx>
      <c:valAx>
        <c:axId val="-850890416"/>
        <c:scaling>
          <c:orientation val="minMax"/>
          <c:min val="9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BRET (% of basa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-915737280"/>
        <c:crosses val="autoZero"/>
        <c:crossBetween val="midCat"/>
      </c:valAx>
    </c:plotArea>
    <c:legend>
      <c:legendPos val="r"/>
      <c:layout/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978020299785217"/>
          <c:y val="0.23682907221133848"/>
          <c:w val="0.67411463280697437"/>
          <c:h val="0.62194752207387405"/>
        </c:manualLayout>
      </c:layout>
      <c:scatterChart>
        <c:scatterStyle val="lineMarker"/>
        <c:varyColors val="0"/>
        <c:ser>
          <c:idx val="0"/>
          <c:order val="0"/>
          <c:tx>
            <c:strRef>
              <c:f>'[071917 HTS Hit Analysis RESPYR Dicumerol DRC.xlsx] Calculations'!$BQ$3</c:f>
              <c:strCache>
                <c:ptCount val="1"/>
                <c:pt idx="0">
                  <c:v>DMSO</c:v>
                </c:pt>
              </c:strCache>
            </c:strRef>
          </c:tx>
          <c:spPr>
            <a:ln w="9525">
              <a:solidFill>
                <a:srgbClr val="00B0F0"/>
              </a:solidFill>
            </a:ln>
          </c:spPr>
          <c:marker>
            <c:symbol val="square"/>
            <c:size val="4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071917 HTS Hit Analysis RESPYR Dicumerol DRC.xlsx] Calculations'!$BQ$29:$BQ$50</c:f>
                <c:numCache>
                  <c:formatCode>General</c:formatCode>
                  <c:ptCount val="22"/>
                  <c:pt idx="0">
                    <c:v>0.75207974075077233</c:v>
                  </c:pt>
                  <c:pt idx="1">
                    <c:v>0.85825467863862426</c:v>
                  </c:pt>
                  <c:pt idx="2">
                    <c:v>0.59865166276154769</c:v>
                  </c:pt>
                  <c:pt idx="3">
                    <c:v>0.8132208020552647</c:v>
                  </c:pt>
                  <c:pt idx="4">
                    <c:v>1.430131311431609</c:v>
                  </c:pt>
                  <c:pt idx="5">
                    <c:v>0.55063257202497973</c:v>
                  </c:pt>
                  <c:pt idx="6">
                    <c:v>0.92549988478580947</c:v>
                  </c:pt>
                  <c:pt idx="7">
                    <c:v>1.0118253923242251</c:v>
                  </c:pt>
                  <c:pt idx="8">
                    <c:v>1.1453142032282093</c:v>
                  </c:pt>
                  <c:pt idx="9">
                    <c:v>1.6266075469155639</c:v>
                  </c:pt>
                  <c:pt idx="10">
                    <c:v>1.0043757246734673</c:v>
                  </c:pt>
                  <c:pt idx="11">
                    <c:v>0.97952482169771282</c:v>
                  </c:pt>
                  <c:pt idx="12">
                    <c:v>1.9165676846974555</c:v>
                  </c:pt>
                  <c:pt idx="13">
                    <c:v>0.8062428554117127</c:v>
                  </c:pt>
                  <c:pt idx="14">
                    <c:v>0.65789135248208985</c:v>
                  </c:pt>
                  <c:pt idx="15">
                    <c:v>1.0934078113070971</c:v>
                  </c:pt>
                  <c:pt idx="16">
                    <c:v>1.0498794817847137</c:v>
                  </c:pt>
                  <c:pt idx="17">
                    <c:v>1.0594730864753676</c:v>
                  </c:pt>
                  <c:pt idx="18">
                    <c:v>1.377170566480217</c:v>
                  </c:pt>
                  <c:pt idx="19">
                    <c:v>1.181928652434048</c:v>
                  </c:pt>
                  <c:pt idx="20">
                    <c:v>0.83603430527479783</c:v>
                  </c:pt>
                  <c:pt idx="21">
                    <c:v>1.2561762190958325</c:v>
                  </c:pt>
                </c:numCache>
              </c:numRef>
            </c:plus>
            <c:minus>
              <c:numRef>
                <c:f>'[071917 HTS Hit Analysis RESPYR Dicumerol DRC.xlsx] Calculations'!$BQ$29:$BQ$50</c:f>
                <c:numCache>
                  <c:formatCode>General</c:formatCode>
                  <c:ptCount val="22"/>
                  <c:pt idx="0">
                    <c:v>0.75207974075077233</c:v>
                  </c:pt>
                  <c:pt idx="1">
                    <c:v>0.85825467863862426</c:v>
                  </c:pt>
                  <c:pt idx="2">
                    <c:v>0.59865166276154769</c:v>
                  </c:pt>
                  <c:pt idx="3">
                    <c:v>0.8132208020552647</c:v>
                  </c:pt>
                  <c:pt idx="4">
                    <c:v>1.430131311431609</c:v>
                  </c:pt>
                  <c:pt idx="5">
                    <c:v>0.55063257202497973</c:v>
                  </c:pt>
                  <c:pt idx="6">
                    <c:v>0.92549988478580947</c:v>
                  </c:pt>
                  <c:pt idx="7">
                    <c:v>1.0118253923242251</c:v>
                  </c:pt>
                  <c:pt idx="8">
                    <c:v>1.1453142032282093</c:v>
                  </c:pt>
                  <c:pt idx="9">
                    <c:v>1.6266075469155639</c:v>
                  </c:pt>
                  <c:pt idx="10">
                    <c:v>1.0043757246734673</c:v>
                  </c:pt>
                  <c:pt idx="11">
                    <c:v>0.97952482169771282</c:v>
                  </c:pt>
                  <c:pt idx="12">
                    <c:v>1.9165676846974555</c:v>
                  </c:pt>
                  <c:pt idx="13">
                    <c:v>0.8062428554117127</c:v>
                  </c:pt>
                  <c:pt idx="14">
                    <c:v>0.65789135248208985</c:v>
                  </c:pt>
                  <c:pt idx="15">
                    <c:v>1.0934078113070971</c:v>
                  </c:pt>
                  <c:pt idx="16">
                    <c:v>1.0498794817847137</c:v>
                  </c:pt>
                  <c:pt idx="17">
                    <c:v>1.0594730864753676</c:v>
                  </c:pt>
                  <c:pt idx="18">
                    <c:v>1.377170566480217</c:v>
                  </c:pt>
                  <c:pt idx="19">
                    <c:v>1.181928652434048</c:v>
                  </c:pt>
                  <c:pt idx="20">
                    <c:v>0.83603430527479783</c:v>
                  </c:pt>
                  <c:pt idx="21">
                    <c:v>1.2561762190958325</c:v>
                  </c:pt>
                </c:numCache>
              </c:numRef>
            </c:minus>
            <c:spPr>
              <a:ln>
                <a:solidFill>
                  <a:srgbClr val="00B0F0"/>
                </a:solidFill>
              </a:ln>
            </c:spPr>
          </c:errBars>
          <c:xVal>
            <c:numRef>
              <c:f>'[071917 HTS Hit Analysis RESPYR Dicumerol DRC.xlsx]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[071917 HTS Hit Analysis RESPYR Dicumerol DRC.xlsx] Calculations'!$BQ$4:$BQ$25</c:f>
              <c:numCache>
                <c:formatCode>General</c:formatCode>
                <c:ptCount val="22"/>
                <c:pt idx="0">
                  <c:v>96.875193197025851</c:v>
                </c:pt>
                <c:pt idx="1">
                  <c:v>97.424915119149176</c:v>
                </c:pt>
                <c:pt idx="2">
                  <c:v>100</c:v>
                </c:pt>
                <c:pt idx="3">
                  <c:v>107.06754937178522</c:v>
                </c:pt>
                <c:pt idx="4">
                  <c:v>108.19749793409773</c:v>
                </c:pt>
                <c:pt idx="5">
                  <c:v>112.34610785897678</c:v>
                </c:pt>
                <c:pt idx="6">
                  <c:v>113.21826491707043</c:v>
                </c:pt>
                <c:pt idx="7">
                  <c:v>115.37102431731027</c:v>
                </c:pt>
                <c:pt idx="8">
                  <c:v>121.0233429599452</c:v>
                </c:pt>
                <c:pt idx="9">
                  <c:v>121.39811368742943</c:v>
                </c:pt>
                <c:pt idx="10">
                  <c:v>117.9034649944317</c:v>
                </c:pt>
                <c:pt idx="11">
                  <c:v>124.18095089261574</c:v>
                </c:pt>
                <c:pt idx="12">
                  <c:v>125.52466687097497</c:v>
                </c:pt>
                <c:pt idx="13">
                  <c:v>125.02337524614271</c:v>
                </c:pt>
                <c:pt idx="14">
                  <c:v>124.60649937284262</c:v>
                </c:pt>
                <c:pt idx="15">
                  <c:v>125.92630276540191</c:v>
                </c:pt>
                <c:pt idx="16">
                  <c:v>127.84762643847071</c:v>
                </c:pt>
                <c:pt idx="17">
                  <c:v>132.40290628001512</c:v>
                </c:pt>
                <c:pt idx="18">
                  <c:v>131.72972924063322</c:v>
                </c:pt>
                <c:pt idx="19">
                  <c:v>130.34044586503336</c:v>
                </c:pt>
                <c:pt idx="20">
                  <c:v>128.63981652138006</c:v>
                </c:pt>
                <c:pt idx="21">
                  <c:v>131.2154650044108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0A2-4F72-88A8-B32BEEF5A92E}"/>
            </c:ext>
          </c:extLst>
        </c:ser>
        <c:ser>
          <c:idx val="1"/>
          <c:order val="1"/>
          <c:tx>
            <c:strRef>
              <c:f>'[071917 HTS Hit Analysis RESPYR Dicumerol DRC.xlsx] Calculations'!$BR$3</c:f>
              <c:strCache>
                <c:ptCount val="1"/>
                <c:pt idx="0">
                  <c:v>5 µM UK5099</c:v>
                </c:pt>
              </c:strCache>
            </c:strRef>
          </c:tx>
          <c:spPr>
            <a:ln w="9525">
              <a:solidFill>
                <a:schemeClr val="accent2">
                  <a:lumMod val="75000"/>
                </a:schemeClr>
              </a:solidFill>
            </a:ln>
          </c:spPr>
          <c:marker>
            <c:symbol val="circle"/>
            <c:size val="4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071917 HTS Hit Analysis RESPYR Dicumerol DRC.xlsx] Calculations'!$BR$29:$BR$50</c:f>
                <c:numCache>
                  <c:formatCode>General</c:formatCode>
                  <c:ptCount val="22"/>
                  <c:pt idx="0">
                    <c:v>1.0832221539062845</c:v>
                  </c:pt>
                  <c:pt idx="1">
                    <c:v>1.2013314092516987</c:v>
                  </c:pt>
                  <c:pt idx="2">
                    <c:v>1.3269724030771348</c:v>
                  </c:pt>
                  <c:pt idx="3">
                    <c:v>1.0481285872802968</c:v>
                  </c:pt>
                  <c:pt idx="4">
                    <c:v>0.95458291404800744</c:v>
                  </c:pt>
                  <c:pt idx="5">
                    <c:v>0.60126371667945966</c:v>
                  </c:pt>
                  <c:pt idx="6">
                    <c:v>1.7499435867340498</c:v>
                  </c:pt>
                  <c:pt idx="7">
                    <c:v>1.4323152992753381</c:v>
                  </c:pt>
                  <c:pt idx="8">
                    <c:v>1.7225143397227582</c:v>
                  </c:pt>
                  <c:pt idx="9">
                    <c:v>1.1466174056883027</c:v>
                  </c:pt>
                  <c:pt idx="10">
                    <c:v>1.4538290851665681</c:v>
                  </c:pt>
                  <c:pt idx="11">
                    <c:v>0.58943672604227526</c:v>
                  </c:pt>
                  <c:pt idx="12">
                    <c:v>0.86206944548816855</c:v>
                  </c:pt>
                  <c:pt idx="13">
                    <c:v>1.0143894383743239</c:v>
                  </c:pt>
                  <c:pt idx="14">
                    <c:v>1.1076166800140825</c:v>
                  </c:pt>
                  <c:pt idx="15">
                    <c:v>1.5496611925203427</c:v>
                  </c:pt>
                  <c:pt idx="16">
                    <c:v>1.1990576500948027</c:v>
                  </c:pt>
                  <c:pt idx="17">
                    <c:v>1.3469328707175523</c:v>
                  </c:pt>
                  <c:pt idx="18">
                    <c:v>0.6754389105695372</c:v>
                  </c:pt>
                  <c:pt idx="19">
                    <c:v>1.6942978877076538</c:v>
                  </c:pt>
                  <c:pt idx="20">
                    <c:v>1.105156846630712</c:v>
                  </c:pt>
                  <c:pt idx="21">
                    <c:v>1.312557999630348</c:v>
                  </c:pt>
                </c:numCache>
              </c:numRef>
            </c:plus>
            <c:minus>
              <c:numRef>
                <c:f>'[071917 HTS Hit Analysis RESPYR Dicumerol DRC.xlsx] Calculations'!$BR$29:$BR$50</c:f>
                <c:numCache>
                  <c:formatCode>General</c:formatCode>
                  <c:ptCount val="22"/>
                  <c:pt idx="0">
                    <c:v>1.0832221539062845</c:v>
                  </c:pt>
                  <c:pt idx="1">
                    <c:v>1.2013314092516987</c:v>
                  </c:pt>
                  <c:pt idx="2">
                    <c:v>1.3269724030771348</c:v>
                  </c:pt>
                  <c:pt idx="3">
                    <c:v>1.0481285872802968</c:v>
                  </c:pt>
                  <c:pt idx="4">
                    <c:v>0.95458291404800744</c:v>
                  </c:pt>
                  <c:pt idx="5">
                    <c:v>0.60126371667945966</c:v>
                  </c:pt>
                  <c:pt idx="6">
                    <c:v>1.7499435867340498</c:v>
                  </c:pt>
                  <c:pt idx="7">
                    <c:v>1.4323152992753381</c:v>
                  </c:pt>
                  <c:pt idx="8">
                    <c:v>1.7225143397227582</c:v>
                  </c:pt>
                  <c:pt idx="9">
                    <c:v>1.1466174056883027</c:v>
                  </c:pt>
                  <c:pt idx="10">
                    <c:v>1.4538290851665681</c:v>
                  </c:pt>
                  <c:pt idx="11">
                    <c:v>0.58943672604227526</c:v>
                  </c:pt>
                  <c:pt idx="12">
                    <c:v>0.86206944548816855</c:v>
                  </c:pt>
                  <c:pt idx="13">
                    <c:v>1.0143894383743239</c:v>
                  </c:pt>
                  <c:pt idx="14">
                    <c:v>1.1076166800140825</c:v>
                  </c:pt>
                  <c:pt idx="15">
                    <c:v>1.5496611925203427</c:v>
                  </c:pt>
                  <c:pt idx="16">
                    <c:v>1.1990576500948027</c:v>
                  </c:pt>
                  <c:pt idx="17">
                    <c:v>1.3469328707175523</c:v>
                  </c:pt>
                  <c:pt idx="18">
                    <c:v>0.6754389105695372</c:v>
                  </c:pt>
                  <c:pt idx="19">
                    <c:v>1.6942978877076538</c:v>
                  </c:pt>
                  <c:pt idx="20">
                    <c:v>1.105156846630712</c:v>
                  </c:pt>
                  <c:pt idx="21">
                    <c:v>1.312557999630348</c:v>
                  </c:pt>
                </c:numCache>
              </c:numRef>
            </c:minus>
            <c:spPr>
              <a:ln>
                <a:solidFill>
                  <a:schemeClr val="accent2">
                    <a:lumMod val="75000"/>
                  </a:schemeClr>
                </a:solidFill>
              </a:ln>
            </c:spPr>
          </c:errBars>
          <c:xVal>
            <c:numRef>
              <c:f>'[071917 HTS Hit Analysis RESPYR Dicumerol DRC.xlsx]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[071917 HTS Hit Analysis RESPYR Dicumerol DRC.xlsx] Calculations'!$BR$4:$BR$25</c:f>
              <c:numCache>
                <c:formatCode>General</c:formatCode>
                <c:ptCount val="22"/>
                <c:pt idx="0">
                  <c:v>95.834781151888535</c:v>
                </c:pt>
                <c:pt idx="1">
                  <c:v>96.906775467535965</c:v>
                </c:pt>
                <c:pt idx="2">
                  <c:v>100</c:v>
                </c:pt>
                <c:pt idx="3">
                  <c:v>144.50417041137558</c:v>
                </c:pt>
                <c:pt idx="4">
                  <c:v>147.38944447699555</c:v>
                </c:pt>
                <c:pt idx="5">
                  <c:v>152.58605066179746</c:v>
                </c:pt>
                <c:pt idx="6">
                  <c:v>150.88988387520118</c:v>
                </c:pt>
                <c:pt idx="7">
                  <c:v>155.02957619290257</c:v>
                </c:pt>
                <c:pt idx="8">
                  <c:v>160.30029667128071</c:v>
                </c:pt>
                <c:pt idx="9">
                  <c:v>163.52867949211893</c:v>
                </c:pt>
                <c:pt idx="10">
                  <c:v>165.82786551260838</c:v>
                </c:pt>
                <c:pt idx="11">
                  <c:v>169.60125949783577</c:v>
                </c:pt>
                <c:pt idx="12">
                  <c:v>167.62664965626286</c:v>
                </c:pt>
                <c:pt idx="13">
                  <c:v>174.84318749689157</c:v>
                </c:pt>
                <c:pt idx="14">
                  <c:v>174.77385132388287</c:v>
                </c:pt>
                <c:pt idx="15">
                  <c:v>181.22615678414618</c:v>
                </c:pt>
                <c:pt idx="16">
                  <c:v>178.87356677393302</c:v>
                </c:pt>
                <c:pt idx="17">
                  <c:v>179.14062403349686</c:v>
                </c:pt>
                <c:pt idx="18">
                  <c:v>188.81026854486868</c:v>
                </c:pt>
                <c:pt idx="19">
                  <c:v>189.87809861045707</c:v>
                </c:pt>
                <c:pt idx="20">
                  <c:v>192.81941030514594</c:v>
                </c:pt>
                <c:pt idx="21">
                  <c:v>192.516262709301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0A2-4F72-88A8-B32BEEF5A92E}"/>
            </c:ext>
          </c:extLst>
        </c:ser>
        <c:ser>
          <c:idx val="2"/>
          <c:order val="2"/>
          <c:tx>
            <c:strRef>
              <c:f>'[071917 HTS Hit Analysis RESPYR Dicumerol DRC.xlsx] Calculations'!$BS$3</c:f>
              <c:strCache>
                <c:ptCount val="1"/>
                <c:pt idx="0">
                  <c:v>10 µM Dicumerol</c:v>
                </c:pt>
              </c:strCache>
            </c:strRef>
          </c:tx>
          <c:spPr>
            <a:ln w="9525"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071917 HTS Hit Analysis RESPYR Dicumerol DRC.xlsx] Calculations'!$BS$29:$BS$50</c:f>
                <c:numCache>
                  <c:formatCode>General</c:formatCode>
                  <c:ptCount val="22"/>
                  <c:pt idx="0">
                    <c:v>1.3064664022003341</c:v>
                  </c:pt>
                  <c:pt idx="1">
                    <c:v>0.996764183859429</c:v>
                  </c:pt>
                  <c:pt idx="2">
                    <c:v>0.97136672900833243</c:v>
                  </c:pt>
                  <c:pt idx="3">
                    <c:v>1.6463109042833224</c:v>
                  </c:pt>
                  <c:pt idx="4">
                    <c:v>1.286014716545316</c:v>
                  </c:pt>
                  <c:pt idx="5">
                    <c:v>1.7354077198024163</c:v>
                  </c:pt>
                  <c:pt idx="6">
                    <c:v>1.2915943369564342</c:v>
                  </c:pt>
                  <c:pt idx="7">
                    <c:v>1.2610041729213988</c:v>
                  </c:pt>
                  <c:pt idx="8">
                    <c:v>1.9586479029365853</c:v>
                  </c:pt>
                  <c:pt idx="9">
                    <c:v>1.1112935195227924</c:v>
                  </c:pt>
                  <c:pt idx="10">
                    <c:v>1.6534209189137488</c:v>
                  </c:pt>
                  <c:pt idx="11">
                    <c:v>1.8889972593669948</c:v>
                  </c:pt>
                  <c:pt idx="12">
                    <c:v>0.85770347936560942</c:v>
                  </c:pt>
                  <c:pt idx="13">
                    <c:v>1.4190159588015867</c:v>
                  </c:pt>
                  <c:pt idx="14">
                    <c:v>0.69714935704635517</c:v>
                  </c:pt>
                  <c:pt idx="15">
                    <c:v>1.1682533324678614</c:v>
                  </c:pt>
                  <c:pt idx="16">
                    <c:v>1.3378261920641887</c:v>
                  </c:pt>
                  <c:pt idx="17">
                    <c:v>0.93889022098461861</c:v>
                  </c:pt>
                  <c:pt idx="18">
                    <c:v>1.6912975882810426</c:v>
                  </c:pt>
                  <c:pt idx="19">
                    <c:v>0.68511452552698948</c:v>
                  </c:pt>
                  <c:pt idx="20">
                    <c:v>2.3248275850044231</c:v>
                  </c:pt>
                  <c:pt idx="21">
                    <c:v>0.95041444050582624</c:v>
                  </c:pt>
                </c:numCache>
              </c:numRef>
            </c:plus>
            <c:minus>
              <c:numRef>
                <c:f>'[071917 HTS Hit Analysis RESPYR Dicumerol DRC.xlsx] Calculations'!$BS$29:$BS$50</c:f>
                <c:numCache>
                  <c:formatCode>General</c:formatCode>
                  <c:ptCount val="22"/>
                  <c:pt idx="0">
                    <c:v>1.3064664022003341</c:v>
                  </c:pt>
                  <c:pt idx="1">
                    <c:v>0.996764183859429</c:v>
                  </c:pt>
                  <c:pt idx="2">
                    <c:v>0.97136672900833243</c:v>
                  </c:pt>
                  <c:pt idx="3">
                    <c:v>1.6463109042833224</c:v>
                  </c:pt>
                  <c:pt idx="4">
                    <c:v>1.286014716545316</c:v>
                  </c:pt>
                  <c:pt idx="5">
                    <c:v>1.7354077198024163</c:v>
                  </c:pt>
                  <c:pt idx="6">
                    <c:v>1.2915943369564342</c:v>
                  </c:pt>
                  <c:pt idx="7">
                    <c:v>1.2610041729213988</c:v>
                  </c:pt>
                  <c:pt idx="8">
                    <c:v>1.9586479029365853</c:v>
                  </c:pt>
                  <c:pt idx="9">
                    <c:v>1.1112935195227924</c:v>
                  </c:pt>
                  <c:pt idx="10">
                    <c:v>1.6534209189137488</c:v>
                  </c:pt>
                  <c:pt idx="11">
                    <c:v>1.8889972593669948</c:v>
                  </c:pt>
                  <c:pt idx="12">
                    <c:v>0.85770347936560942</c:v>
                  </c:pt>
                  <c:pt idx="13">
                    <c:v>1.4190159588015867</c:v>
                  </c:pt>
                  <c:pt idx="14">
                    <c:v>0.69714935704635517</c:v>
                  </c:pt>
                  <c:pt idx="15">
                    <c:v>1.1682533324678614</c:v>
                  </c:pt>
                  <c:pt idx="16">
                    <c:v>1.3378261920641887</c:v>
                  </c:pt>
                  <c:pt idx="17">
                    <c:v>0.93889022098461861</c:v>
                  </c:pt>
                  <c:pt idx="18">
                    <c:v>1.6912975882810426</c:v>
                  </c:pt>
                  <c:pt idx="19">
                    <c:v>0.68511452552698948</c:v>
                  </c:pt>
                  <c:pt idx="20">
                    <c:v>2.3248275850044231</c:v>
                  </c:pt>
                  <c:pt idx="21">
                    <c:v>0.95041444050582624</c:v>
                  </c:pt>
                </c:numCache>
              </c:numRef>
            </c:minus>
            <c:spPr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errBars>
          <c:xVal>
            <c:numRef>
              <c:f>'[071917 HTS Hit Analysis RESPYR Dicumerol DRC.xlsx]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[071917 HTS Hit Analysis RESPYR Dicumerol DRC.xlsx] Calculations'!$BS$4:$BS$25</c:f>
              <c:numCache>
                <c:formatCode>General</c:formatCode>
                <c:ptCount val="22"/>
                <c:pt idx="0">
                  <c:v>95.325877677600744</c:v>
                </c:pt>
                <c:pt idx="1">
                  <c:v>95.876152486134288</c:v>
                </c:pt>
                <c:pt idx="2">
                  <c:v>100</c:v>
                </c:pt>
                <c:pt idx="3">
                  <c:v>150.62287991690363</c:v>
                </c:pt>
                <c:pt idx="4">
                  <c:v>148.62741435391234</c:v>
                </c:pt>
                <c:pt idx="5">
                  <c:v>147.43364658249936</c:v>
                </c:pt>
                <c:pt idx="6">
                  <c:v>145.01122146402915</c:v>
                </c:pt>
                <c:pt idx="7">
                  <c:v>142.36294407074863</c:v>
                </c:pt>
                <c:pt idx="8">
                  <c:v>136.66347444487022</c:v>
                </c:pt>
                <c:pt idx="9">
                  <c:v>137.00175790345574</c:v>
                </c:pt>
                <c:pt idx="10">
                  <c:v>135.51770175804754</c:v>
                </c:pt>
                <c:pt idx="11">
                  <c:v>136.99836314270314</c:v>
                </c:pt>
                <c:pt idx="12">
                  <c:v>138.19649424796958</c:v>
                </c:pt>
                <c:pt idx="13">
                  <c:v>139.33605190445303</c:v>
                </c:pt>
                <c:pt idx="14">
                  <c:v>136.54751137426032</c:v>
                </c:pt>
                <c:pt idx="15">
                  <c:v>143.03302018269764</c:v>
                </c:pt>
                <c:pt idx="16">
                  <c:v>142.39716460096</c:v>
                </c:pt>
                <c:pt idx="17">
                  <c:v>141.54285433739284</c:v>
                </c:pt>
                <c:pt idx="18">
                  <c:v>141.82253893949888</c:v>
                </c:pt>
                <c:pt idx="19">
                  <c:v>143.27874859750713</c:v>
                </c:pt>
                <c:pt idx="20">
                  <c:v>142.34556570361227</c:v>
                </c:pt>
                <c:pt idx="21">
                  <c:v>145.683602081468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0A2-4F72-88A8-B32BEEF5A92E}"/>
            </c:ext>
          </c:extLst>
        </c:ser>
        <c:ser>
          <c:idx val="3"/>
          <c:order val="3"/>
          <c:tx>
            <c:strRef>
              <c:f>'[071917 HTS Hit Analysis RESPYR Dicumerol DRC.xlsx] Calculations'!$BT$3</c:f>
              <c:strCache>
                <c:ptCount val="1"/>
                <c:pt idx="0">
                  <c:v>1 µM Dicumerol</c:v>
                </c:pt>
              </c:strCache>
            </c:strRef>
          </c:tx>
          <c:spPr>
            <a:ln w="9525">
              <a:solidFill>
                <a:schemeClr val="accent2">
                  <a:lumMod val="40000"/>
                  <a:lumOff val="60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accent2">
                  <a:lumMod val="40000"/>
                  <a:lumOff val="60000"/>
                </a:schemeClr>
              </a:solidFill>
              <a:ln w="9525">
                <a:solidFill>
                  <a:schemeClr val="accent2">
                    <a:lumMod val="40000"/>
                    <a:lumOff val="6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071917 HTS Hit Analysis RESPYR Dicumerol DRC.xlsx] Calculations'!$BT$29:$BT$50</c:f>
                <c:numCache>
                  <c:formatCode>General</c:formatCode>
                  <c:ptCount val="22"/>
                  <c:pt idx="0">
                    <c:v>1.3536391886074335</c:v>
                  </c:pt>
                  <c:pt idx="1">
                    <c:v>1.4973541699619639</c:v>
                  </c:pt>
                  <c:pt idx="2">
                    <c:v>0.92301310485692767</c:v>
                  </c:pt>
                  <c:pt idx="3">
                    <c:v>0.77320042809325717</c:v>
                  </c:pt>
                  <c:pt idx="4">
                    <c:v>1.380623397942113</c:v>
                  </c:pt>
                  <c:pt idx="5">
                    <c:v>0.5184877738903948</c:v>
                  </c:pt>
                  <c:pt idx="6">
                    <c:v>1.004972616806511</c:v>
                  </c:pt>
                  <c:pt idx="7">
                    <c:v>1.750623663570362</c:v>
                  </c:pt>
                  <c:pt idx="8">
                    <c:v>1.5883368815785053</c:v>
                  </c:pt>
                  <c:pt idx="9">
                    <c:v>1.2281790773558501</c:v>
                  </c:pt>
                  <c:pt idx="10">
                    <c:v>0.5088422569464387</c:v>
                  </c:pt>
                  <c:pt idx="11">
                    <c:v>0.67873315995619665</c:v>
                  </c:pt>
                  <c:pt idx="12">
                    <c:v>0.56517758447004884</c:v>
                  </c:pt>
                  <c:pt idx="13">
                    <c:v>1.3491513698866433</c:v>
                  </c:pt>
                  <c:pt idx="14">
                    <c:v>0.94869698625065002</c:v>
                  </c:pt>
                  <c:pt idx="15">
                    <c:v>0.42528784483760784</c:v>
                  </c:pt>
                  <c:pt idx="16">
                    <c:v>0.79141544694638299</c:v>
                  </c:pt>
                  <c:pt idx="17">
                    <c:v>1.0857943281101587</c:v>
                  </c:pt>
                  <c:pt idx="18">
                    <c:v>0.63734905510901563</c:v>
                  </c:pt>
                  <c:pt idx="19">
                    <c:v>1.7891799144234162</c:v>
                  </c:pt>
                  <c:pt idx="20">
                    <c:v>0.88350405026950873</c:v>
                  </c:pt>
                  <c:pt idx="21">
                    <c:v>1.1761312170401454</c:v>
                  </c:pt>
                </c:numCache>
              </c:numRef>
            </c:plus>
            <c:minus>
              <c:numRef>
                <c:f>'[071917 HTS Hit Analysis RESPYR Dicumerol DRC.xlsx] Calculations'!$BT$29:$BT$50</c:f>
                <c:numCache>
                  <c:formatCode>General</c:formatCode>
                  <c:ptCount val="22"/>
                  <c:pt idx="0">
                    <c:v>1.3536391886074335</c:v>
                  </c:pt>
                  <c:pt idx="1">
                    <c:v>1.4973541699619639</c:v>
                  </c:pt>
                  <c:pt idx="2">
                    <c:v>0.92301310485692767</c:v>
                  </c:pt>
                  <c:pt idx="3">
                    <c:v>0.77320042809325717</c:v>
                  </c:pt>
                  <c:pt idx="4">
                    <c:v>1.380623397942113</c:v>
                  </c:pt>
                  <c:pt idx="5">
                    <c:v>0.5184877738903948</c:v>
                  </c:pt>
                  <c:pt idx="6">
                    <c:v>1.004972616806511</c:v>
                  </c:pt>
                  <c:pt idx="7">
                    <c:v>1.750623663570362</c:v>
                  </c:pt>
                  <c:pt idx="8">
                    <c:v>1.5883368815785053</c:v>
                  </c:pt>
                  <c:pt idx="9">
                    <c:v>1.2281790773558501</c:v>
                  </c:pt>
                  <c:pt idx="10">
                    <c:v>0.5088422569464387</c:v>
                  </c:pt>
                  <c:pt idx="11">
                    <c:v>0.67873315995619665</c:v>
                  </c:pt>
                  <c:pt idx="12">
                    <c:v>0.56517758447004884</c:v>
                  </c:pt>
                  <c:pt idx="13">
                    <c:v>1.3491513698866433</c:v>
                  </c:pt>
                  <c:pt idx="14">
                    <c:v>0.94869698625065002</c:v>
                  </c:pt>
                  <c:pt idx="15">
                    <c:v>0.42528784483760784</c:v>
                  </c:pt>
                  <c:pt idx="16">
                    <c:v>0.79141544694638299</c:v>
                  </c:pt>
                  <c:pt idx="17">
                    <c:v>1.0857943281101587</c:v>
                  </c:pt>
                  <c:pt idx="18">
                    <c:v>0.63734905510901563</c:v>
                  </c:pt>
                  <c:pt idx="19">
                    <c:v>1.7891799144234162</c:v>
                  </c:pt>
                  <c:pt idx="20">
                    <c:v>0.88350405026950873</c:v>
                  </c:pt>
                  <c:pt idx="21">
                    <c:v>1.1761312170401454</c:v>
                  </c:pt>
                </c:numCache>
              </c:numRef>
            </c:minus>
            <c:spPr>
              <a:ln>
                <a:solidFill>
                  <a:schemeClr val="accent2">
                    <a:lumMod val="40000"/>
                    <a:lumOff val="60000"/>
                  </a:schemeClr>
                </a:solidFill>
              </a:ln>
            </c:spPr>
          </c:errBars>
          <c:xVal>
            <c:numRef>
              <c:f>'[071917 HTS Hit Analysis RESPYR Dicumerol DRC.xlsx]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[071917 HTS Hit Analysis RESPYR Dicumerol DRC.xlsx] Calculations'!$BT$4:$BT$25</c:f>
              <c:numCache>
                <c:formatCode>General</c:formatCode>
                <c:ptCount val="22"/>
                <c:pt idx="0">
                  <c:v>94.124779115862822</c:v>
                </c:pt>
                <c:pt idx="1">
                  <c:v>97.785944994728908</c:v>
                </c:pt>
                <c:pt idx="2">
                  <c:v>100</c:v>
                </c:pt>
                <c:pt idx="3">
                  <c:v>109.57894752461908</c:v>
                </c:pt>
                <c:pt idx="4">
                  <c:v>112.47239305221197</c:v>
                </c:pt>
                <c:pt idx="5">
                  <c:v>117.60391300566423</c:v>
                </c:pt>
                <c:pt idx="6">
                  <c:v>119.59806860676998</c:v>
                </c:pt>
                <c:pt idx="7">
                  <c:v>120.55076942684192</c:v>
                </c:pt>
                <c:pt idx="8">
                  <c:v>120.12044700174533</c:v>
                </c:pt>
                <c:pt idx="9">
                  <c:v>124.04888865667509</c:v>
                </c:pt>
                <c:pt idx="10">
                  <c:v>125.61876560218523</c:v>
                </c:pt>
                <c:pt idx="11">
                  <c:v>123.73348007898998</c:v>
                </c:pt>
                <c:pt idx="12">
                  <c:v>126.20114839649696</c:v>
                </c:pt>
                <c:pt idx="13">
                  <c:v>127.90307603233737</c:v>
                </c:pt>
                <c:pt idx="14">
                  <c:v>131.21508879716171</c:v>
                </c:pt>
                <c:pt idx="15">
                  <c:v>132.3563904971368</c:v>
                </c:pt>
                <c:pt idx="16">
                  <c:v>131.41097652436218</c:v>
                </c:pt>
                <c:pt idx="17">
                  <c:v>133.6219244824224</c:v>
                </c:pt>
                <c:pt idx="18">
                  <c:v>135.17006521785038</c:v>
                </c:pt>
                <c:pt idx="19">
                  <c:v>135.47616057609073</c:v>
                </c:pt>
                <c:pt idx="20">
                  <c:v>140.72075180377456</c:v>
                </c:pt>
                <c:pt idx="21">
                  <c:v>137.196707825650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0A2-4F72-88A8-B32BEEF5A92E}"/>
            </c:ext>
          </c:extLst>
        </c:ser>
        <c:ser>
          <c:idx val="4"/>
          <c:order val="4"/>
          <c:tx>
            <c:strRef>
              <c:f>'[071917 HTS Hit Analysis RESPYR Dicumerol DRC.xlsx] Calculations'!$BU$3</c:f>
              <c:strCache>
                <c:ptCount val="1"/>
                <c:pt idx="0">
                  <c:v>0.1 µM Dicumerol</c:v>
                </c:pt>
              </c:strCache>
            </c:strRef>
          </c:tx>
          <c:spPr>
            <a:ln w="952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071917 HTS Hit Analysis RESPYR Dicumerol DRC.xlsx] Calculations'!$BU$29:$BU$50</c:f>
                <c:numCache>
                  <c:formatCode>General</c:formatCode>
                  <c:ptCount val="22"/>
                  <c:pt idx="0">
                    <c:v>1.9733991607717334</c:v>
                  </c:pt>
                  <c:pt idx="1">
                    <c:v>1.8199782086351541</c:v>
                  </c:pt>
                  <c:pt idx="2">
                    <c:v>1.6530326330720313</c:v>
                  </c:pt>
                  <c:pt idx="3">
                    <c:v>1.1049791509015094</c:v>
                  </c:pt>
                  <c:pt idx="4">
                    <c:v>0.44209554552706798</c:v>
                  </c:pt>
                  <c:pt idx="5">
                    <c:v>1.3547125742272919</c:v>
                  </c:pt>
                  <c:pt idx="6">
                    <c:v>0.84990265472161397</c:v>
                  </c:pt>
                  <c:pt idx="7">
                    <c:v>0.9733983864777076</c:v>
                  </c:pt>
                  <c:pt idx="8">
                    <c:v>1.3941341879531022</c:v>
                  </c:pt>
                  <c:pt idx="9">
                    <c:v>1.4009547558622204</c:v>
                  </c:pt>
                  <c:pt idx="10">
                    <c:v>1.4037910647758696</c:v>
                  </c:pt>
                  <c:pt idx="11">
                    <c:v>1.3475781151760293</c:v>
                  </c:pt>
                  <c:pt idx="12">
                    <c:v>1.3719455626027037</c:v>
                  </c:pt>
                  <c:pt idx="13">
                    <c:v>1.2906878759087363</c:v>
                  </c:pt>
                  <c:pt idx="14">
                    <c:v>1.6446615036202901</c:v>
                  </c:pt>
                  <c:pt idx="15">
                    <c:v>0.833686991358501</c:v>
                  </c:pt>
                  <c:pt idx="16">
                    <c:v>1.7441317208908773</c:v>
                  </c:pt>
                  <c:pt idx="17">
                    <c:v>1.3112715671916668</c:v>
                  </c:pt>
                  <c:pt idx="18">
                    <c:v>1.2173884605577387</c:v>
                  </c:pt>
                  <c:pt idx="19">
                    <c:v>1.0305034257505485</c:v>
                  </c:pt>
                  <c:pt idx="20">
                    <c:v>1.2805556036998205</c:v>
                  </c:pt>
                  <c:pt idx="21">
                    <c:v>1.3529944969932923</c:v>
                  </c:pt>
                </c:numCache>
              </c:numRef>
            </c:plus>
            <c:minus>
              <c:numRef>
                <c:f>'[071917 HTS Hit Analysis RESPYR Dicumerol DRC.xlsx] Calculations'!$BU$29:$BU$50</c:f>
                <c:numCache>
                  <c:formatCode>General</c:formatCode>
                  <c:ptCount val="22"/>
                  <c:pt idx="0">
                    <c:v>1.9733991607717334</c:v>
                  </c:pt>
                  <c:pt idx="1">
                    <c:v>1.8199782086351541</c:v>
                  </c:pt>
                  <c:pt idx="2">
                    <c:v>1.6530326330720313</c:v>
                  </c:pt>
                  <c:pt idx="3">
                    <c:v>1.1049791509015094</c:v>
                  </c:pt>
                  <c:pt idx="4">
                    <c:v>0.44209554552706798</c:v>
                  </c:pt>
                  <c:pt idx="5">
                    <c:v>1.3547125742272919</c:v>
                  </c:pt>
                  <c:pt idx="6">
                    <c:v>0.84990265472161397</c:v>
                  </c:pt>
                  <c:pt idx="7">
                    <c:v>0.9733983864777076</c:v>
                  </c:pt>
                  <c:pt idx="8">
                    <c:v>1.3941341879531022</c:v>
                  </c:pt>
                  <c:pt idx="9">
                    <c:v>1.4009547558622204</c:v>
                  </c:pt>
                  <c:pt idx="10">
                    <c:v>1.4037910647758696</c:v>
                  </c:pt>
                  <c:pt idx="11">
                    <c:v>1.3475781151760293</c:v>
                  </c:pt>
                  <c:pt idx="12">
                    <c:v>1.3719455626027037</c:v>
                  </c:pt>
                  <c:pt idx="13">
                    <c:v>1.2906878759087363</c:v>
                  </c:pt>
                  <c:pt idx="14">
                    <c:v>1.6446615036202901</c:v>
                  </c:pt>
                  <c:pt idx="15">
                    <c:v>0.833686991358501</c:v>
                  </c:pt>
                  <c:pt idx="16">
                    <c:v>1.7441317208908773</c:v>
                  </c:pt>
                  <c:pt idx="17">
                    <c:v>1.3112715671916668</c:v>
                  </c:pt>
                  <c:pt idx="18">
                    <c:v>1.2173884605577387</c:v>
                  </c:pt>
                  <c:pt idx="19">
                    <c:v>1.0305034257505485</c:v>
                  </c:pt>
                  <c:pt idx="20">
                    <c:v>1.2805556036998205</c:v>
                  </c:pt>
                  <c:pt idx="21">
                    <c:v>1.3529944969932923</c:v>
                  </c:pt>
                </c:numCache>
              </c:numRef>
            </c:minus>
            <c:spPr>
              <a:ln>
                <a:solidFill>
                  <a:srgbClr val="00B050"/>
                </a:solidFill>
              </a:ln>
            </c:spPr>
          </c:errBars>
          <c:xVal>
            <c:numRef>
              <c:f>'[071917 HTS Hit Analysis RESPYR Dicumerol DRC.xlsx]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[071917 HTS Hit Analysis RESPYR Dicumerol DRC.xlsx] Calculations'!$BU$4:$BU$25</c:f>
              <c:numCache>
                <c:formatCode>General</c:formatCode>
                <c:ptCount val="22"/>
                <c:pt idx="0">
                  <c:v>97.636081540203122</c:v>
                </c:pt>
                <c:pt idx="1">
                  <c:v>102.96858012974445</c:v>
                </c:pt>
                <c:pt idx="2">
                  <c:v>100</c:v>
                </c:pt>
                <c:pt idx="3">
                  <c:v>103.63781115014665</c:v>
                </c:pt>
                <c:pt idx="4">
                  <c:v>110.03742101553959</c:v>
                </c:pt>
                <c:pt idx="5">
                  <c:v>114.63851351908274</c:v>
                </c:pt>
                <c:pt idx="6">
                  <c:v>115.96480900357797</c:v>
                </c:pt>
                <c:pt idx="7">
                  <c:v>119.65000670982313</c:v>
                </c:pt>
                <c:pt idx="8">
                  <c:v>120.86771537789467</c:v>
                </c:pt>
                <c:pt idx="9">
                  <c:v>121.67985976920632</c:v>
                </c:pt>
                <c:pt idx="10">
                  <c:v>126.62166431941597</c:v>
                </c:pt>
                <c:pt idx="11">
                  <c:v>124.89671617240059</c:v>
                </c:pt>
                <c:pt idx="12">
                  <c:v>125.05633416283925</c:v>
                </c:pt>
                <c:pt idx="13">
                  <c:v>127.5806225430715</c:v>
                </c:pt>
                <c:pt idx="14">
                  <c:v>126.19898838297165</c:v>
                </c:pt>
                <c:pt idx="15">
                  <c:v>131.08750287899258</c:v>
                </c:pt>
                <c:pt idx="16">
                  <c:v>132.39888331004803</c:v>
                </c:pt>
                <c:pt idx="17">
                  <c:v>137.17107769476817</c:v>
                </c:pt>
                <c:pt idx="18">
                  <c:v>133.36860056483289</c:v>
                </c:pt>
                <c:pt idx="19">
                  <c:v>131.64204999806927</c:v>
                </c:pt>
                <c:pt idx="20">
                  <c:v>135.72570816610511</c:v>
                </c:pt>
                <c:pt idx="21">
                  <c:v>138.194359302185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C0A2-4F72-88A8-B32BEEF5A92E}"/>
            </c:ext>
          </c:extLst>
        </c:ser>
        <c:ser>
          <c:idx val="5"/>
          <c:order val="5"/>
          <c:tx>
            <c:strRef>
              <c:f>'[071917 HTS Hit Analysis RESPYR Dicumerol DRC.xlsx] Calculations'!$BV$3</c:f>
              <c:strCache>
                <c:ptCount val="1"/>
                <c:pt idx="0">
                  <c:v>0.01 µM Dicumerol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star"/>
            <c:size val="4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071917 HTS Hit Analysis RESPYR Dicumerol DRC.xlsx] Calculations'!$BV$29:$BV$50</c:f>
                <c:numCache>
                  <c:formatCode>General</c:formatCode>
                  <c:ptCount val="22"/>
                  <c:pt idx="0">
                    <c:v>1.718273742826026</c:v>
                  </c:pt>
                  <c:pt idx="1">
                    <c:v>1.5099218275237856</c:v>
                  </c:pt>
                  <c:pt idx="2">
                    <c:v>0.97873982598638831</c:v>
                  </c:pt>
                  <c:pt idx="3">
                    <c:v>1.234127522333047</c:v>
                  </c:pt>
                  <c:pt idx="4">
                    <c:v>1.5794949036811761</c:v>
                  </c:pt>
                  <c:pt idx="5">
                    <c:v>1.2052972569924043</c:v>
                  </c:pt>
                  <c:pt idx="6">
                    <c:v>0.98247133307288359</c:v>
                  </c:pt>
                  <c:pt idx="7">
                    <c:v>0.48221094493049743</c:v>
                  </c:pt>
                  <c:pt idx="8">
                    <c:v>0.41116803547512537</c:v>
                  </c:pt>
                  <c:pt idx="9">
                    <c:v>0.99515086591353552</c:v>
                  </c:pt>
                  <c:pt idx="10">
                    <c:v>1.068310632692606</c:v>
                  </c:pt>
                  <c:pt idx="11">
                    <c:v>1.3549498750039026</c:v>
                  </c:pt>
                  <c:pt idx="12">
                    <c:v>1.8062103414498396</c:v>
                  </c:pt>
                  <c:pt idx="13">
                    <c:v>0.64338582312878079</c:v>
                  </c:pt>
                  <c:pt idx="14">
                    <c:v>1.7910602476084498</c:v>
                  </c:pt>
                  <c:pt idx="15">
                    <c:v>1.8226914010182873</c:v>
                  </c:pt>
                  <c:pt idx="16">
                    <c:v>1.6343016355479887</c:v>
                  </c:pt>
                  <c:pt idx="17">
                    <c:v>1.5691024089684849</c:v>
                  </c:pt>
                  <c:pt idx="18">
                    <c:v>0.98004309076380258</c:v>
                  </c:pt>
                  <c:pt idx="19">
                    <c:v>1.4121941605125337</c:v>
                  </c:pt>
                  <c:pt idx="20">
                    <c:v>0.92832948092488077</c:v>
                  </c:pt>
                  <c:pt idx="21">
                    <c:v>1.0728970918140042</c:v>
                  </c:pt>
                </c:numCache>
              </c:numRef>
            </c:plus>
            <c:minus>
              <c:numRef>
                <c:f>'[071917 HTS Hit Analysis RESPYR Dicumerol DRC.xlsx] Calculations'!$BV$29:$BV$50</c:f>
                <c:numCache>
                  <c:formatCode>General</c:formatCode>
                  <c:ptCount val="22"/>
                  <c:pt idx="0">
                    <c:v>1.718273742826026</c:v>
                  </c:pt>
                  <c:pt idx="1">
                    <c:v>1.5099218275237856</c:v>
                  </c:pt>
                  <c:pt idx="2">
                    <c:v>0.97873982598638831</c:v>
                  </c:pt>
                  <c:pt idx="3">
                    <c:v>1.234127522333047</c:v>
                  </c:pt>
                  <c:pt idx="4">
                    <c:v>1.5794949036811761</c:v>
                  </c:pt>
                  <c:pt idx="5">
                    <c:v>1.2052972569924043</c:v>
                  </c:pt>
                  <c:pt idx="6">
                    <c:v>0.98247133307288359</c:v>
                  </c:pt>
                  <c:pt idx="7">
                    <c:v>0.48221094493049743</c:v>
                  </c:pt>
                  <c:pt idx="8">
                    <c:v>0.41116803547512537</c:v>
                  </c:pt>
                  <c:pt idx="9">
                    <c:v>0.99515086591353552</c:v>
                  </c:pt>
                  <c:pt idx="10">
                    <c:v>1.068310632692606</c:v>
                  </c:pt>
                  <c:pt idx="11">
                    <c:v>1.3549498750039026</c:v>
                  </c:pt>
                  <c:pt idx="12">
                    <c:v>1.8062103414498396</c:v>
                  </c:pt>
                  <c:pt idx="13">
                    <c:v>0.64338582312878079</c:v>
                  </c:pt>
                  <c:pt idx="14">
                    <c:v>1.7910602476084498</c:v>
                  </c:pt>
                  <c:pt idx="15">
                    <c:v>1.8226914010182873</c:v>
                  </c:pt>
                  <c:pt idx="16">
                    <c:v>1.6343016355479887</c:v>
                  </c:pt>
                  <c:pt idx="17">
                    <c:v>1.5691024089684849</c:v>
                  </c:pt>
                  <c:pt idx="18">
                    <c:v>0.98004309076380258</c:v>
                  </c:pt>
                  <c:pt idx="19">
                    <c:v>1.4121941605125337</c:v>
                  </c:pt>
                  <c:pt idx="20">
                    <c:v>0.92832948092488077</c:v>
                  </c:pt>
                  <c:pt idx="21">
                    <c:v>1.0728970918140042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xVal>
            <c:numRef>
              <c:f>'[071917 HTS Hit Analysis RESPYR Dicumerol DRC.xlsx]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[071917 HTS Hit Analysis RESPYR Dicumerol DRC.xlsx] Calculations'!$BV$4:$BV$25</c:f>
              <c:numCache>
                <c:formatCode>General</c:formatCode>
                <c:ptCount val="22"/>
                <c:pt idx="0">
                  <c:v>96.876527902118099</c:v>
                </c:pt>
                <c:pt idx="1">
                  <c:v>95.940443321278437</c:v>
                </c:pt>
                <c:pt idx="2">
                  <c:v>100</c:v>
                </c:pt>
                <c:pt idx="3">
                  <c:v>103.43943728531464</c:v>
                </c:pt>
                <c:pt idx="4">
                  <c:v>105.45159543365568</c:v>
                </c:pt>
                <c:pt idx="5">
                  <c:v>108.1957842042043</c:v>
                </c:pt>
                <c:pt idx="6">
                  <c:v>110.42604157837965</c:v>
                </c:pt>
                <c:pt idx="7">
                  <c:v>111.47425084064801</c:v>
                </c:pt>
                <c:pt idx="8">
                  <c:v>115.52635204214037</c:v>
                </c:pt>
                <c:pt idx="9">
                  <c:v>118.36615148022716</c:v>
                </c:pt>
                <c:pt idx="10">
                  <c:v>114.36500284219078</c:v>
                </c:pt>
                <c:pt idx="11">
                  <c:v>117.37151615690668</c:v>
                </c:pt>
                <c:pt idx="12">
                  <c:v>119.51826691514978</c:v>
                </c:pt>
                <c:pt idx="13">
                  <c:v>121.7320453271886</c:v>
                </c:pt>
                <c:pt idx="14">
                  <c:v>124.2404193328766</c:v>
                </c:pt>
                <c:pt idx="15">
                  <c:v>124.43827558393888</c:v>
                </c:pt>
                <c:pt idx="16">
                  <c:v>124.82125324434641</c:v>
                </c:pt>
                <c:pt idx="17">
                  <c:v>122.89023118281972</c:v>
                </c:pt>
                <c:pt idx="18">
                  <c:v>130.92041617943383</c:v>
                </c:pt>
                <c:pt idx="19">
                  <c:v>128.34525364397697</c:v>
                </c:pt>
                <c:pt idx="20">
                  <c:v>134.15352230105799</c:v>
                </c:pt>
                <c:pt idx="21">
                  <c:v>129.622794128505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C0A2-4F72-88A8-B32BEEF5A9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43945312"/>
        <c:axId val="-843949120"/>
      </c:scatterChart>
      <c:valAx>
        <c:axId val="-8439453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-843949120"/>
        <c:crosses val="autoZero"/>
        <c:crossBetween val="midCat"/>
      </c:valAx>
      <c:valAx>
        <c:axId val="-843949120"/>
        <c:scaling>
          <c:orientation val="minMax"/>
          <c:min val="9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BRET (% of basa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-84394531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4429776628710619"/>
          <c:y val="1.2738093278237797E-3"/>
          <c:w val="0.42584003873227605"/>
          <c:h val="0.34844069824232149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578924006543966"/>
          <c:y val="0.24208986811887584"/>
          <c:w val="0.64103272860603377"/>
          <c:h val="0.61799544160760722"/>
        </c:manualLayout>
      </c:layout>
      <c:scatterChart>
        <c:scatterStyle val="lineMarker"/>
        <c:varyColors val="0"/>
        <c:ser>
          <c:idx val="0"/>
          <c:order val="0"/>
          <c:tx>
            <c:strRef>
              <c:f>'[072817 HTS Hit Analysis RESPYR Telmisartan DRC.xlsx] Calculations'!$BQ$3</c:f>
              <c:strCache>
                <c:ptCount val="1"/>
                <c:pt idx="0">
                  <c:v>DMSO</c:v>
                </c:pt>
              </c:strCache>
            </c:strRef>
          </c:tx>
          <c:spPr>
            <a:ln w="9525">
              <a:solidFill>
                <a:srgbClr val="00B0F0"/>
              </a:solidFill>
            </a:ln>
          </c:spPr>
          <c:marker>
            <c:symbol val="square"/>
            <c:size val="4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072817 HTS Hit Analysis RESPYR Telmisartan DRC.xlsx] Calculations'!$BQ$29:$BQ$50</c:f>
                <c:numCache>
                  <c:formatCode>General</c:formatCode>
                  <c:ptCount val="22"/>
                  <c:pt idx="0">
                    <c:v>1.2247750039892129</c:v>
                  </c:pt>
                  <c:pt idx="1">
                    <c:v>1.1490929419819691</c:v>
                  </c:pt>
                  <c:pt idx="2">
                    <c:v>1.3042690549809395</c:v>
                  </c:pt>
                  <c:pt idx="3">
                    <c:v>0.82922338976814181</c:v>
                  </c:pt>
                  <c:pt idx="4">
                    <c:v>1.6792601614554272</c:v>
                  </c:pt>
                  <c:pt idx="5">
                    <c:v>1.8381966564192196</c:v>
                  </c:pt>
                  <c:pt idx="6">
                    <c:v>0.96566595276237521</c:v>
                  </c:pt>
                  <c:pt idx="7">
                    <c:v>1.5482845691121876</c:v>
                  </c:pt>
                  <c:pt idx="8">
                    <c:v>1.3074079431838235</c:v>
                  </c:pt>
                  <c:pt idx="9">
                    <c:v>1.2593717600050542</c:v>
                  </c:pt>
                  <c:pt idx="10">
                    <c:v>1.0943729213076394</c:v>
                  </c:pt>
                  <c:pt idx="11">
                    <c:v>0.94944523692649851</c:v>
                  </c:pt>
                  <c:pt idx="12">
                    <c:v>0.62900902151581284</c:v>
                  </c:pt>
                  <c:pt idx="13">
                    <c:v>1.2262160217647053</c:v>
                  </c:pt>
                  <c:pt idx="14">
                    <c:v>2.1034255935969788</c:v>
                  </c:pt>
                  <c:pt idx="15">
                    <c:v>0.64044279880453403</c:v>
                  </c:pt>
                  <c:pt idx="16">
                    <c:v>0.92556911423994703</c:v>
                  </c:pt>
                  <c:pt idx="17">
                    <c:v>0.95297873356699303</c:v>
                  </c:pt>
                  <c:pt idx="18">
                    <c:v>1.2223789021139686</c:v>
                  </c:pt>
                  <c:pt idx="19">
                    <c:v>2.3397044512074405</c:v>
                  </c:pt>
                  <c:pt idx="20">
                    <c:v>0.70015240110371069</c:v>
                  </c:pt>
                </c:numCache>
              </c:numRef>
            </c:plus>
            <c:minus>
              <c:numRef>
                <c:f>'[072817 HTS Hit Analysis RESPYR Telmisartan DRC.xlsx] Calculations'!$BQ$29:$BQ$50</c:f>
                <c:numCache>
                  <c:formatCode>General</c:formatCode>
                  <c:ptCount val="22"/>
                  <c:pt idx="0">
                    <c:v>1.2247750039892129</c:v>
                  </c:pt>
                  <c:pt idx="1">
                    <c:v>1.1490929419819691</c:v>
                  </c:pt>
                  <c:pt idx="2">
                    <c:v>1.3042690549809395</c:v>
                  </c:pt>
                  <c:pt idx="3">
                    <c:v>0.82922338976814181</c:v>
                  </c:pt>
                  <c:pt idx="4">
                    <c:v>1.6792601614554272</c:v>
                  </c:pt>
                  <c:pt idx="5">
                    <c:v>1.8381966564192196</c:v>
                  </c:pt>
                  <c:pt idx="6">
                    <c:v>0.96566595276237521</c:v>
                  </c:pt>
                  <c:pt idx="7">
                    <c:v>1.5482845691121876</c:v>
                  </c:pt>
                  <c:pt idx="8">
                    <c:v>1.3074079431838235</c:v>
                  </c:pt>
                  <c:pt idx="9">
                    <c:v>1.2593717600050542</c:v>
                  </c:pt>
                  <c:pt idx="10">
                    <c:v>1.0943729213076394</c:v>
                  </c:pt>
                  <c:pt idx="11">
                    <c:v>0.94944523692649851</c:v>
                  </c:pt>
                  <c:pt idx="12">
                    <c:v>0.62900902151581284</c:v>
                  </c:pt>
                  <c:pt idx="13">
                    <c:v>1.2262160217647053</c:v>
                  </c:pt>
                  <c:pt idx="14">
                    <c:v>2.1034255935969788</c:v>
                  </c:pt>
                  <c:pt idx="15">
                    <c:v>0.64044279880453403</c:v>
                  </c:pt>
                  <c:pt idx="16">
                    <c:v>0.92556911423994703</c:v>
                  </c:pt>
                  <c:pt idx="17">
                    <c:v>0.95297873356699303</c:v>
                  </c:pt>
                  <c:pt idx="18">
                    <c:v>1.2223789021139686</c:v>
                  </c:pt>
                  <c:pt idx="19">
                    <c:v>2.3397044512074405</c:v>
                  </c:pt>
                  <c:pt idx="20">
                    <c:v>0.70015240110371069</c:v>
                  </c:pt>
                </c:numCache>
              </c:numRef>
            </c:minus>
            <c:spPr>
              <a:ln>
                <a:solidFill>
                  <a:srgbClr val="00B0F0"/>
                </a:solidFill>
              </a:ln>
            </c:spPr>
          </c:errBars>
          <c:xVal>
            <c:numRef>
              <c:f>'[072817 HTS Hit Analysis RESPYR Telmisartan DRC.xlsx]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</c:numCache>
            </c:numRef>
          </c:xVal>
          <c:yVal>
            <c:numRef>
              <c:f>'[072817 HTS Hit Analysis RESPYR Telmisartan DRC.xlsx] Calculations'!$BQ$4:$BQ$25</c:f>
              <c:numCache>
                <c:formatCode>General</c:formatCode>
                <c:ptCount val="22"/>
                <c:pt idx="0">
                  <c:v>95.280658218922412</c:v>
                </c:pt>
                <c:pt idx="1">
                  <c:v>95.572496102199139</c:v>
                </c:pt>
                <c:pt idx="2">
                  <c:v>100</c:v>
                </c:pt>
                <c:pt idx="3">
                  <c:v>102.70395643434989</c:v>
                </c:pt>
                <c:pt idx="4">
                  <c:v>104.93123614414908</c:v>
                </c:pt>
                <c:pt idx="5">
                  <c:v>108.23952873616744</c:v>
                </c:pt>
                <c:pt idx="6">
                  <c:v>108.75216603276945</c:v>
                </c:pt>
                <c:pt idx="7">
                  <c:v>110.75641883801801</c:v>
                </c:pt>
                <c:pt idx="8">
                  <c:v>112.9193718357697</c:v>
                </c:pt>
                <c:pt idx="9">
                  <c:v>114.96627893651592</c:v>
                </c:pt>
                <c:pt idx="10">
                  <c:v>114.45726584901999</c:v>
                </c:pt>
                <c:pt idx="11">
                  <c:v>114.52956332461946</c:v>
                </c:pt>
                <c:pt idx="12">
                  <c:v>117.71931799282976</c:v>
                </c:pt>
                <c:pt idx="13">
                  <c:v>120.61197474463567</c:v>
                </c:pt>
                <c:pt idx="14">
                  <c:v>118.77339788470447</c:v>
                </c:pt>
                <c:pt idx="15">
                  <c:v>122.28261255774864</c:v>
                </c:pt>
                <c:pt idx="16">
                  <c:v>124.61342563979021</c:v>
                </c:pt>
                <c:pt idx="17">
                  <c:v>123.06613391334496</c:v>
                </c:pt>
                <c:pt idx="18">
                  <c:v>124.81951463232599</c:v>
                </c:pt>
                <c:pt idx="19">
                  <c:v>121.98958744750097</c:v>
                </c:pt>
                <c:pt idx="20">
                  <c:v>126.215746476754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72B-4D05-97A1-AD390802C11A}"/>
            </c:ext>
          </c:extLst>
        </c:ser>
        <c:ser>
          <c:idx val="1"/>
          <c:order val="1"/>
          <c:tx>
            <c:strRef>
              <c:f>'[072817 HTS Hit Analysis RESPYR Telmisartan DRC.xlsx] Calculations'!$BR$3</c:f>
              <c:strCache>
                <c:ptCount val="1"/>
                <c:pt idx="0">
                  <c:v>5 µM UK5099</c:v>
                </c:pt>
              </c:strCache>
            </c:strRef>
          </c:tx>
          <c:spPr>
            <a:ln w="9525">
              <a:solidFill>
                <a:schemeClr val="accent2">
                  <a:lumMod val="75000"/>
                </a:schemeClr>
              </a:solidFill>
            </a:ln>
          </c:spPr>
          <c:marker>
            <c:symbol val="circle"/>
            <c:size val="4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072817 HTS Hit Analysis RESPYR Telmisartan DRC.xlsx] Calculations'!$BR$29:$BR$50</c:f>
                <c:numCache>
                  <c:formatCode>General</c:formatCode>
                  <c:ptCount val="22"/>
                  <c:pt idx="0">
                    <c:v>0.9024800800645435</c:v>
                  </c:pt>
                  <c:pt idx="1">
                    <c:v>0.91155327074445691</c:v>
                  </c:pt>
                  <c:pt idx="2">
                    <c:v>1.2171859568281103</c:v>
                  </c:pt>
                  <c:pt idx="3">
                    <c:v>1.2386827634066595</c:v>
                  </c:pt>
                  <c:pt idx="4">
                    <c:v>0.24144909935736808</c:v>
                  </c:pt>
                  <c:pt idx="5">
                    <c:v>1.2670770118895895</c:v>
                  </c:pt>
                  <c:pt idx="6">
                    <c:v>1.0713714079873018</c:v>
                  </c:pt>
                  <c:pt idx="7">
                    <c:v>0.9995525426212003</c:v>
                  </c:pt>
                  <c:pt idx="8">
                    <c:v>1.3110667614035953</c:v>
                  </c:pt>
                  <c:pt idx="9">
                    <c:v>0.78333048536382499</c:v>
                  </c:pt>
                  <c:pt idx="10">
                    <c:v>1.1735294645647936</c:v>
                  </c:pt>
                  <c:pt idx="11">
                    <c:v>1.1254940147441754</c:v>
                  </c:pt>
                  <c:pt idx="12">
                    <c:v>0.75291600856545504</c:v>
                  </c:pt>
                  <c:pt idx="13">
                    <c:v>0.63518412569605986</c:v>
                  </c:pt>
                  <c:pt idx="14">
                    <c:v>1.7524068423442851</c:v>
                  </c:pt>
                  <c:pt idx="15">
                    <c:v>0.90438487415411728</c:v>
                  </c:pt>
                  <c:pt idx="16">
                    <c:v>0.79504345775517404</c:v>
                  </c:pt>
                  <c:pt idx="17">
                    <c:v>0.91356668745644654</c:v>
                  </c:pt>
                  <c:pt idx="18">
                    <c:v>0.58932711550563033</c:v>
                  </c:pt>
                  <c:pt idx="19">
                    <c:v>2.3301734838536969</c:v>
                  </c:pt>
                  <c:pt idx="20">
                    <c:v>1.3773635039905421</c:v>
                  </c:pt>
                </c:numCache>
              </c:numRef>
            </c:plus>
            <c:minus>
              <c:numRef>
                <c:f>'[072817 HTS Hit Analysis RESPYR Telmisartan DRC.xlsx] Calculations'!$BR$29:$BR$50</c:f>
                <c:numCache>
                  <c:formatCode>General</c:formatCode>
                  <c:ptCount val="22"/>
                  <c:pt idx="0">
                    <c:v>0.9024800800645435</c:v>
                  </c:pt>
                  <c:pt idx="1">
                    <c:v>0.91155327074445691</c:v>
                  </c:pt>
                  <c:pt idx="2">
                    <c:v>1.2171859568281103</c:v>
                  </c:pt>
                  <c:pt idx="3">
                    <c:v>1.2386827634066595</c:v>
                  </c:pt>
                  <c:pt idx="4">
                    <c:v>0.24144909935736808</c:v>
                  </c:pt>
                  <c:pt idx="5">
                    <c:v>1.2670770118895895</c:v>
                  </c:pt>
                  <c:pt idx="6">
                    <c:v>1.0713714079873018</c:v>
                  </c:pt>
                  <c:pt idx="7">
                    <c:v>0.9995525426212003</c:v>
                  </c:pt>
                  <c:pt idx="8">
                    <c:v>1.3110667614035953</c:v>
                  </c:pt>
                  <c:pt idx="9">
                    <c:v>0.78333048536382499</c:v>
                  </c:pt>
                  <c:pt idx="10">
                    <c:v>1.1735294645647936</c:v>
                  </c:pt>
                  <c:pt idx="11">
                    <c:v>1.1254940147441754</c:v>
                  </c:pt>
                  <c:pt idx="12">
                    <c:v>0.75291600856545504</c:v>
                  </c:pt>
                  <c:pt idx="13">
                    <c:v>0.63518412569605986</c:v>
                  </c:pt>
                  <c:pt idx="14">
                    <c:v>1.7524068423442851</c:v>
                  </c:pt>
                  <c:pt idx="15">
                    <c:v>0.90438487415411728</c:v>
                  </c:pt>
                  <c:pt idx="16">
                    <c:v>0.79504345775517404</c:v>
                  </c:pt>
                  <c:pt idx="17">
                    <c:v>0.91356668745644654</c:v>
                  </c:pt>
                  <c:pt idx="18">
                    <c:v>0.58932711550563033</c:v>
                  </c:pt>
                  <c:pt idx="19">
                    <c:v>2.3301734838536969</c:v>
                  </c:pt>
                  <c:pt idx="20">
                    <c:v>1.3773635039905421</c:v>
                  </c:pt>
                </c:numCache>
              </c:numRef>
            </c:minus>
            <c:spPr>
              <a:ln>
                <a:solidFill>
                  <a:schemeClr val="accent2">
                    <a:lumMod val="75000"/>
                  </a:schemeClr>
                </a:solidFill>
              </a:ln>
            </c:spPr>
          </c:errBars>
          <c:xVal>
            <c:numRef>
              <c:f>'[072817 HTS Hit Analysis RESPYR Telmisartan DRC.xlsx]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</c:numCache>
            </c:numRef>
          </c:xVal>
          <c:yVal>
            <c:numRef>
              <c:f>'[072817 HTS Hit Analysis RESPYR Telmisartan DRC.xlsx] Calculations'!$BR$4:$BR$25</c:f>
              <c:numCache>
                <c:formatCode>General</c:formatCode>
                <c:ptCount val="22"/>
                <c:pt idx="0">
                  <c:v>97.380476659566369</c:v>
                </c:pt>
                <c:pt idx="1">
                  <c:v>94.973130506001553</c:v>
                </c:pt>
                <c:pt idx="2">
                  <c:v>100</c:v>
                </c:pt>
                <c:pt idx="3">
                  <c:v>145.17490707095135</c:v>
                </c:pt>
                <c:pt idx="4">
                  <c:v>144.78783870916919</c:v>
                </c:pt>
                <c:pt idx="5">
                  <c:v>148.67945518369024</c:v>
                </c:pt>
                <c:pt idx="6">
                  <c:v>149.52354415301446</c:v>
                </c:pt>
                <c:pt idx="7">
                  <c:v>155.29840390094822</c:v>
                </c:pt>
                <c:pt idx="8">
                  <c:v>157.17846877335558</c:v>
                </c:pt>
                <c:pt idx="9">
                  <c:v>156.70186252536732</c:v>
                </c:pt>
                <c:pt idx="10">
                  <c:v>160.77747881222004</c:v>
                </c:pt>
                <c:pt idx="11">
                  <c:v>163.35816383837988</c:v>
                </c:pt>
                <c:pt idx="12">
                  <c:v>165.55275714680209</c:v>
                </c:pt>
                <c:pt idx="13">
                  <c:v>169.63599733856967</c:v>
                </c:pt>
                <c:pt idx="14">
                  <c:v>167.33536252160613</c:v>
                </c:pt>
                <c:pt idx="15">
                  <c:v>174.00526901583041</c:v>
                </c:pt>
                <c:pt idx="16">
                  <c:v>175.47364266207975</c:v>
                </c:pt>
                <c:pt idx="17">
                  <c:v>178.32739060682579</c:v>
                </c:pt>
                <c:pt idx="18">
                  <c:v>178.01697983895636</c:v>
                </c:pt>
                <c:pt idx="19">
                  <c:v>178.46994426140918</c:v>
                </c:pt>
                <c:pt idx="20">
                  <c:v>175.999485936465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72B-4D05-97A1-AD390802C11A}"/>
            </c:ext>
          </c:extLst>
        </c:ser>
        <c:ser>
          <c:idx val="2"/>
          <c:order val="2"/>
          <c:tx>
            <c:strRef>
              <c:f>'[072817 HTS Hit Analysis RESPYR Telmisartan DRC.xlsx] Calculations'!$BS$3</c:f>
              <c:strCache>
                <c:ptCount val="1"/>
                <c:pt idx="0">
                  <c:v>50 µM Telmisartan</c:v>
                </c:pt>
              </c:strCache>
            </c:strRef>
          </c:tx>
          <c:spPr>
            <a:ln w="9525"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072817 HTS Hit Analysis RESPYR Telmisartan DRC.xlsx] Calculations'!$BS$29:$BS$50</c:f>
                <c:numCache>
                  <c:formatCode>General</c:formatCode>
                  <c:ptCount val="22"/>
                  <c:pt idx="0">
                    <c:v>0.7692707583607622</c:v>
                  </c:pt>
                  <c:pt idx="1">
                    <c:v>0.53370086051550791</c:v>
                  </c:pt>
                  <c:pt idx="2">
                    <c:v>1.0992619192816258</c:v>
                  </c:pt>
                  <c:pt idx="3">
                    <c:v>3.4181823074352184</c:v>
                  </c:pt>
                  <c:pt idx="4">
                    <c:v>2.2305892507118461</c:v>
                  </c:pt>
                  <c:pt idx="5">
                    <c:v>1.9742464095373728</c:v>
                  </c:pt>
                  <c:pt idx="6">
                    <c:v>1.9004818704751347</c:v>
                  </c:pt>
                  <c:pt idx="7">
                    <c:v>1.4283595242436755</c:v>
                  </c:pt>
                  <c:pt idx="8">
                    <c:v>1.2326639209413102</c:v>
                  </c:pt>
                  <c:pt idx="9">
                    <c:v>0.99880049353414957</c:v>
                  </c:pt>
                  <c:pt idx="10">
                    <c:v>0.86706348722270354</c:v>
                  </c:pt>
                  <c:pt idx="11">
                    <c:v>0.99675981185890095</c:v>
                  </c:pt>
                  <c:pt idx="12">
                    <c:v>1.5522317798020988</c:v>
                  </c:pt>
                  <c:pt idx="13">
                    <c:v>0.92148977335557458</c:v>
                  </c:pt>
                  <c:pt idx="14">
                    <c:v>1.6531391024658775</c:v>
                  </c:pt>
                  <c:pt idx="15">
                    <c:v>1.3072217614247812</c:v>
                  </c:pt>
                  <c:pt idx="16">
                    <c:v>0.40844206813003398</c:v>
                  </c:pt>
                  <c:pt idx="17">
                    <c:v>0.90730824907325458</c:v>
                  </c:pt>
                  <c:pt idx="18">
                    <c:v>1.2279020647284411</c:v>
                  </c:pt>
                  <c:pt idx="19">
                    <c:v>1.6708848923475925</c:v>
                  </c:pt>
                  <c:pt idx="20">
                    <c:v>1.7747829328158951</c:v>
                  </c:pt>
                </c:numCache>
              </c:numRef>
            </c:plus>
            <c:minus>
              <c:numRef>
                <c:f>'[072817 HTS Hit Analysis RESPYR Telmisartan DRC.xlsx] Calculations'!$BS$29:$BS$50</c:f>
                <c:numCache>
                  <c:formatCode>General</c:formatCode>
                  <c:ptCount val="22"/>
                  <c:pt idx="0">
                    <c:v>0.7692707583607622</c:v>
                  </c:pt>
                  <c:pt idx="1">
                    <c:v>0.53370086051550791</c:v>
                  </c:pt>
                  <c:pt idx="2">
                    <c:v>1.0992619192816258</c:v>
                  </c:pt>
                  <c:pt idx="3">
                    <c:v>3.4181823074352184</c:v>
                  </c:pt>
                  <c:pt idx="4">
                    <c:v>2.2305892507118461</c:v>
                  </c:pt>
                  <c:pt idx="5">
                    <c:v>1.9742464095373728</c:v>
                  </c:pt>
                  <c:pt idx="6">
                    <c:v>1.9004818704751347</c:v>
                  </c:pt>
                  <c:pt idx="7">
                    <c:v>1.4283595242436755</c:v>
                  </c:pt>
                  <c:pt idx="8">
                    <c:v>1.2326639209413102</c:v>
                  </c:pt>
                  <c:pt idx="9">
                    <c:v>0.99880049353414957</c:v>
                  </c:pt>
                  <c:pt idx="10">
                    <c:v>0.86706348722270354</c:v>
                  </c:pt>
                  <c:pt idx="11">
                    <c:v>0.99675981185890095</c:v>
                  </c:pt>
                  <c:pt idx="12">
                    <c:v>1.5522317798020988</c:v>
                  </c:pt>
                  <c:pt idx="13">
                    <c:v>0.92148977335557458</c:v>
                  </c:pt>
                  <c:pt idx="14">
                    <c:v>1.6531391024658775</c:v>
                  </c:pt>
                  <c:pt idx="15">
                    <c:v>1.3072217614247812</c:v>
                  </c:pt>
                  <c:pt idx="16">
                    <c:v>0.40844206813003398</c:v>
                  </c:pt>
                  <c:pt idx="17">
                    <c:v>0.90730824907325458</c:v>
                  </c:pt>
                  <c:pt idx="18">
                    <c:v>1.2279020647284411</c:v>
                  </c:pt>
                  <c:pt idx="19">
                    <c:v>1.6708848923475925</c:v>
                  </c:pt>
                  <c:pt idx="20">
                    <c:v>1.7747829328158951</c:v>
                  </c:pt>
                </c:numCache>
              </c:numRef>
            </c:minus>
            <c:spPr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errBars>
          <c:xVal>
            <c:numRef>
              <c:f>'[072817 HTS Hit Analysis RESPYR Telmisartan DRC.xlsx]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</c:numCache>
            </c:numRef>
          </c:xVal>
          <c:yVal>
            <c:numRef>
              <c:f>'[072817 HTS Hit Analysis RESPYR Telmisartan DRC.xlsx] Calculations'!$BS$4:$BS$25</c:f>
              <c:numCache>
                <c:formatCode>General</c:formatCode>
                <c:ptCount val="22"/>
                <c:pt idx="0">
                  <c:v>96.83161369691426</c:v>
                </c:pt>
                <c:pt idx="1">
                  <c:v>97.30049827827952</c:v>
                </c:pt>
                <c:pt idx="2">
                  <c:v>100</c:v>
                </c:pt>
                <c:pt idx="3">
                  <c:v>135.041842327544</c:v>
                </c:pt>
                <c:pt idx="4">
                  <c:v>133.01075531060783</c:v>
                </c:pt>
                <c:pt idx="5">
                  <c:v>134.11135385378725</c:v>
                </c:pt>
                <c:pt idx="6">
                  <c:v>125.58857281696861</c:v>
                </c:pt>
                <c:pt idx="7">
                  <c:v>117.33759540619855</c:v>
                </c:pt>
                <c:pt idx="8">
                  <c:v>116.35292204188706</c:v>
                </c:pt>
                <c:pt idx="9">
                  <c:v>118.01372744051564</c:v>
                </c:pt>
                <c:pt idx="10">
                  <c:v>117.95668680705667</c:v>
                </c:pt>
                <c:pt idx="11">
                  <c:v>125.10748192929175</c:v>
                </c:pt>
                <c:pt idx="12">
                  <c:v>123.32672515037098</c:v>
                </c:pt>
                <c:pt idx="13">
                  <c:v>122.39737034459719</c:v>
                </c:pt>
                <c:pt idx="14">
                  <c:v>128.01235802457452</c:v>
                </c:pt>
                <c:pt idx="15">
                  <c:v>127.22513800058847</c:v>
                </c:pt>
                <c:pt idx="16">
                  <c:v>130.65917282205575</c:v>
                </c:pt>
                <c:pt idx="17">
                  <c:v>131.20237177910818</c:v>
                </c:pt>
                <c:pt idx="18">
                  <c:v>134.65655614766985</c:v>
                </c:pt>
                <c:pt idx="19">
                  <c:v>133.25682230404695</c:v>
                </c:pt>
                <c:pt idx="20">
                  <c:v>132.712510596718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72B-4D05-97A1-AD390802C11A}"/>
            </c:ext>
          </c:extLst>
        </c:ser>
        <c:ser>
          <c:idx val="3"/>
          <c:order val="3"/>
          <c:tx>
            <c:strRef>
              <c:f>'[072817 HTS Hit Analysis RESPYR Telmisartan DRC.xlsx] Calculations'!$BT$3</c:f>
              <c:strCache>
                <c:ptCount val="1"/>
                <c:pt idx="0">
                  <c:v>20 µM Telmisartan</c:v>
                </c:pt>
              </c:strCache>
            </c:strRef>
          </c:tx>
          <c:spPr>
            <a:ln w="9525">
              <a:solidFill>
                <a:schemeClr val="accent2">
                  <a:lumMod val="40000"/>
                  <a:lumOff val="60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accent2">
                  <a:lumMod val="40000"/>
                  <a:lumOff val="60000"/>
                </a:schemeClr>
              </a:solidFill>
              <a:ln w="9525">
                <a:solidFill>
                  <a:schemeClr val="accent2">
                    <a:lumMod val="40000"/>
                    <a:lumOff val="6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072817 HTS Hit Analysis RESPYR Telmisartan DRC.xlsx] Calculations'!$BT$29:$BT$50</c:f>
                <c:numCache>
                  <c:formatCode>General</c:formatCode>
                  <c:ptCount val="22"/>
                  <c:pt idx="0">
                    <c:v>1.3561164019914436</c:v>
                  </c:pt>
                  <c:pt idx="1">
                    <c:v>0.97616541682188951</c:v>
                  </c:pt>
                  <c:pt idx="2">
                    <c:v>1.2471732084980325</c:v>
                  </c:pt>
                  <c:pt idx="3">
                    <c:v>2.1019027766387408</c:v>
                  </c:pt>
                  <c:pt idx="4">
                    <c:v>2.2522564254022668</c:v>
                  </c:pt>
                  <c:pt idx="5">
                    <c:v>1.3669861354652333</c:v>
                  </c:pt>
                  <c:pt idx="6">
                    <c:v>1.3612248221117056</c:v>
                  </c:pt>
                  <c:pt idx="7">
                    <c:v>0.90905088651124855</c:v>
                  </c:pt>
                  <c:pt idx="8">
                    <c:v>1.0277531330593332</c:v>
                  </c:pt>
                  <c:pt idx="9">
                    <c:v>1.1783959695641515</c:v>
                  </c:pt>
                  <c:pt idx="10">
                    <c:v>1.3419222112155567</c:v>
                  </c:pt>
                  <c:pt idx="11">
                    <c:v>1.2833779719341212</c:v>
                  </c:pt>
                  <c:pt idx="12">
                    <c:v>1.1320726986910929</c:v>
                  </c:pt>
                  <c:pt idx="13">
                    <c:v>1.2700484420691716</c:v>
                  </c:pt>
                  <c:pt idx="14">
                    <c:v>1.2586855804180925</c:v>
                  </c:pt>
                  <c:pt idx="15">
                    <c:v>1.795277943651681</c:v>
                  </c:pt>
                  <c:pt idx="16">
                    <c:v>2.40162431006907</c:v>
                  </c:pt>
                  <c:pt idx="17">
                    <c:v>2.4423872397288582</c:v>
                  </c:pt>
                  <c:pt idx="18">
                    <c:v>1.5907960657104587</c:v>
                  </c:pt>
                  <c:pt idx="19">
                    <c:v>1.4606372130051413</c:v>
                  </c:pt>
                  <c:pt idx="20">
                    <c:v>2.1882843967058108</c:v>
                  </c:pt>
                </c:numCache>
              </c:numRef>
            </c:plus>
            <c:minus>
              <c:numRef>
                <c:f>'[072817 HTS Hit Analysis RESPYR Telmisartan DRC.xlsx] Calculations'!$BT$29:$BT$50</c:f>
                <c:numCache>
                  <c:formatCode>General</c:formatCode>
                  <c:ptCount val="22"/>
                  <c:pt idx="0">
                    <c:v>1.3561164019914436</c:v>
                  </c:pt>
                  <c:pt idx="1">
                    <c:v>0.97616541682188951</c:v>
                  </c:pt>
                  <c:pt idx="2">
                    <c:v>1.2471732084980325</c:v>
                  </c:pt>
                  <c:pt idx="3">
                    <c:v>2.1019027766387408</c:v>
                  </c:pt>
                  <c:pt idx="4">
                    <c:v>2.2522564254022668</c:v>
                  </c:pt>
                  <c:pt idx="5">
                    <c:v>1.3669861354652333</c:v>
                  </c:pt>
                  <c:pt idx="6">
                    <c:v>1.3612248221117056</c:v>
                  </c:pt>
                  <c:pt idx="7">
                    <c:v>0.90905088651124855</c:v>
                  </c:pt>
                  <c:pt idx="8">
                    <c:v>1.0277531330593332</c:v>
                  </c:pt>
                  <c:pt idx="9">
                    <c:v>1.1783959695641515</c:v>
                  </c:pt>
                  <c:pt idx="10">
                    <c:v>1.3419222112155567</c:v>
                  </c:pt>
                  <c:pt idx="11">
                    <c:v>1.2833779719341212</c:v>
                  </c:pt>
                  <c:pt idx="12">
                    <c:v>1.1320726986910929</c:v>
                  </c:pt>
                  <c:pt idx="13">
                    <c:v>1.2700484420691716</c:v>
                  </c:pt>
                  <c:pt idx="14">
                    <c:v>1.2586855804180925</c:v>
                  </c:pt>
                  <c:pt idx="15">
                    <c:v>1.795277943651681</c:v>
                  </c:pt>
                  <c:pt idx="16">
                    <c:v>2.40162431006907</c:v>
                  </c:pt>
                  <c:pt idx="17">
                    <c:v>2.4423872397288582</c:v>
                  </c:pt>
                  <c:pt idx="18">
                    <c:v>1.5907960657104587</c:v>
                  </c:pt>
                  <c:pt idx="19">
                    <c:v>1.4606372130051413</c:v>
                  </c:pt>
                  <c:pt idx="20">
                    <c:v>2.1882843967058108</c:v>
                  </c:pt>
                </c:numCache>
              </c:numRef>
            </c:minus>
            <c:spPr>
              <a:ln>
                <a:solidFill>
                  <a:schemeClr val="accent2">
                    <a:lumMod val="40000"/>
                    <a:lumOff val="60000"/>
                  </a:schemeClr>
                </a:solidFill>
              </a:ln>
            </c:spPr>
          </c:errBars>
          <c:xVal>
            <c:numRef>
              <c:f>'[072817 HTS Hit Analysis RESPYR Telmisartan DRC.xlsx]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</c:numCache>
            </c:numRef>
          </c:xVal>
          <c:yVal>
            <c:numRef>
              <c:f>'[072817 HTS Hit Analysis RESPYR Telmisartan DRC.xlsx] Calculations'!$BT$4:$BT$25</c:f>
              <c:numCache>
                <c:formatCode>General</c:formatCode>
                <c:ptCount val="22"/>
                <c:pt idx="0">
                  <c:v>96.704367778997664</c:v>
                </c:pt>
                <c:pt idx="1">
                  <c:v>96.18804093957452</c:v>
                </c:pt>
                <c:pt idx="2">
                  <c:v>100</c:v>
                </c:pt>
                <c:pt idx="3">
                  <c:v>117.22293009579738</c:v>
                </c:pt>
                <c:pt idx="4">
                  <c:v>116.02338497170204</c:v>
                </c:pt>
                <c:pt idx="5">
                  <c:v>112.51054409689418</c:v>
                </c:pt>
                <c:pt idx="6">
                  <c:v>115.97767377483518</c:v>
                </c:pt>
                <c:pt idx="7">
                  <c:v>114.39601117505538</c:v>
                </c:pt>
                <c:pt idx="8">
                  <c:v>115.4317218698701</c:v>
                </c:pt>
                <c:pt idx="9">
                  <c:v>116.96651053589133</c:v>
                </c:pt>
                <c:pt idx="10">
                  <c:v>121.46083755500763</c:v>
                </c:pt>
                <c:pt idx="11">
                  <c:v>122.80456646708922</c:v>
                </c:pt>
                <c:pt idx="12">
                  <c:v>125.50213318492887</c:v>
                </c:pt>
                <c:pt idx="13">
                  <c:v>125.22435502610112</c:v>
                </c:pt>
                <c:pt idx="14">
                  <c:v>126.6247640027142</c:v>
                </c:pt>
                <c:pt idx="15">
                  <c:v>128.38149931847528</c:v>
                </c:pt>
                <c:pt idx="16">
                  <c:v>127.23290927518676</c:v>
                </c:pt>
                <c:pt idx="17">
                  <c:v>130.18502281065648</c:v>
                </c:pt>
                <c:pt idx="18">
                  <c:v>131.10458284161501</c:v>
                </c:pt>
                <c:pt idx="19">
                  <c:v>133.04746776922943</c:v>
                </c:pt>
                <c:pt idx="20">
                  <c:v>132.182688785541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72B-4D05-97A1-AD390802C11A}"/>
            </c:ext>
          </c:extLst>
        </c:ser>
        <c:ser>
          <c:idx val="4"/>
          <c:order val="4"/>
          <c:tx>
            <c:strRef>
              <c:f>'[072817 HTS Hit Analysis RESPYR Telmisartan DRC.xlsx] Calculations'!$BU$3</c:f>
              <c:strCache>
                <c:ptCount val="1"/>
                <c:pt idx="0">
                  <c:v>10 µM Telmisartan</c:v>
                </c:pt>
              </c:strCache>
            </c:strRef>
          </c:tx>
          <c:spPr>
            <a:ln w="952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072817 HTS Hit Analysis RESPYR Telmisartan DRC.xlsx] Calculations'!$BU$29:$BU$50</c:f>
                <c:numCache>
                  <c:formatCode>General</c:formatCode>
                  <c:ptCount val="22"/>
                  <c:pt idx="0">
                    <c:v>0.60923779274985213</c:v>
                  </c:pt>
                  <c:pt idx="1">
                    <c:v>0.60157107931086518</c:v>
                  </c:pt>
                  <c:pt idx="2">
                    <c:v>1.1999132178773504</c:v>
                  </c:pt>
                  <c:pt idx="3">
                    <c:v>0.39817763541210671</c:v>
                  </c:pt>
                  <c:pt idx="4">
                    <c:v>0.78472919996780843</c:v>
                  </c:pt>
                  <c:pt idx="5">
                    <c:v>0.8408404916428599</c:v>
                  </c:pt>
                  <c:pt idx="6">
                    <c:v>1.1040652694560413</c:v>
                  </c:pt>
                  <c:pt idx="7">
                    <c:v>1.0502294362276692</c:v>
                  </c:pt>
                  <c:pt idx="8">
                    <c:v>1.2675428120591097</c:v>
                  </c:pt>
                  <c:pt idx="9">
                    <c:v>0.78869067681757254</c:v>
                  </c:pt>
                  <c:pt idx="10">
                    <c:v>1.001694309542557</c:v>
                  </c:pt>
                  <c:pt idx="11">
                    <c:v>0.74630292114223717</c:v>
                  </c:pt>
                  <c:pt idx="12">
                    <c:v>0.60052944506928441</c:v>
                  </c:pt>
                  <c:pt idx="13">
                    <c:v>1.5883174566066822</c:v>
                  </c:pt>
                  <c:pt idx="14">
                    <c:v>1.5674888725018457</c:v>
                  </c:pt>
                  <c:pt idx="15">
                    <c:v>1.741519605064501</c:v>
                  </c:pt>
                  <c:pt idx="16">
                    <c:v>1.4773654946539354</c:v>
                  </c:pt>
                  <c:pt idx="17">
                    <c:v>1.6974932212077039</c:v>
                  </c:pt>
                  <c:pt idx="18">
                    <c:v>0.76056008789811669</c:v>
                  </c:pt>
                  <c:pt idx="19">
                    <c:v>1.2262839050672552</c:v>
                  </c:pt>
                  <c:pt idx="20">
                    <c:v>1.128069917756418</c:v>
                  </c:pt>
                </c:numCache>
              </c:numRef>
            </c:plus>
            <c:minus>
              <c:numRef>
                <c:f>'[072817 HTS Hit Analysis RESPYR Telmisartan DRC.xlsx] Calculations'!$BU$29:$BU$50</c:f>
                <c:numCache>
                  <c:formatCode>General</c:formatCode>
                  <c:ptCount val="22"/>
                  <c:pt idx="0">
                    <c:v>0.60923779274985213</c:v>
                  </c:pt>
                  <c:pt idx="1">
                    <c:v>0.60157107931086518</c:v>
                  </c:pt>
                  <c:pt idx="2">
                    <c:v>1.1999132178773504</c:v>
                  </c:pt>
                  <c:pt idx="3">
                    <c:v>0.39817763541210671</c:v>
                  </c:pt>
                  <c:pt idx="4">
                    <c:v>0.78472919996780843</c:v>
                  </c:pt>
                  <c:pt idx="5">
                    <c:v>0.8408404916428599</c:v>
                  </c:pt>
                  <c:pt idx="6">
                    <c:v>1.1040652694560413</c:v>
                  </c:pt>
                  <c:pt idx="7">
                    <c:v>1.0502294362276692</c:v>
                  </c:pt>
                  <c:pt idx="8">
                    <c:v>1.2675428120591097</c:v>
                  </c:pt>
                  <c:pt idx="9">
                    <c:v>0.78869067681757254</c:v>
                  </c:pt>
                  <c:pt idx="10">
                    <c:v>1.001694309542557</c:v>
                  </c:pt>
                  <c:pt idx="11">
                    <c:v>0.74630292114223717</c:v>
                  </c:pt>
                  <c:pt idx="12">
                    <c:v>0.60052944506928441</c:v>
                  </c:pt>
                  <c:pt idx="13">
                    <c:v>1.5883174566066822</c:v>
                  </c:pt>
                  <c:pt idx="14">
                    <c:v>1.5674888725018457</c:v>
                  </c:pt>
                  <c:pt idx="15">
                    <c:v>1.741519605064501</c:v>
                  </c:pt>
                  <c:pt idx="16">
                    <c:v>1.4773654946539354</c:v>
                  </c:pt>
                  <c:pt idx="17">
                    <c:v>1.6974932212077039</c:v>
                  </c:pt>
                  <c:pt idx="18">
                    <c:v>0.76056008789811669</c:v>
                  </c:pt>
                  <c:pt idx="19">
                    <c:v>1.2262839050672552</c:v>
                  </c:pt>
                  <c:pt idx="20">
                    <c:v>1.128069917756418</c:v>
                  </c:pt>
                </c:numCache>
              </c:numRef>
            </c:minus>
            <c:spPr>
              <a:ln>
                <a:solidFill>
                  <a:srgbClr val="00B050"/>
                </a:solidFill>
              </a:ln>
            </c:spPr>
          </c:errBars>
          <c:xVal>
            <c:numRef>
              <c:f>'[072817 HTS Hit Analysis RESPYR Telmisartan DRC.xlsx]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</c:numCache>
            </c:numRef>
          </c:xVal>
          <c:yVal>
            <c:numRef>
              <c:f>'[072817 HTS Hit Analysis RESPYR Telmisartan DRC.xlsx] Calculations'!$BU$4:$BU$25</c:f>
              <c:numCache>
                <c:formatCode>General</c:formatCode>
                <c:ptCount val="22"/>
                <c:pt idx="0">
                  <c:v>96.764510274895628</c:v>
                </c:pt>
                <c:pt idx="1">
                  <c:v>98.898697444399687</c:v>
                </c:pt>
                <c:pt idx="2">
                  <c:v>100</c:v>
                </c:pt>
                <c:pt idx="3">
                  <c:v>109.5432923557989</c:v>
                </c:pt>
                <c:pt idx="4">
                  <c:v>111.14516249024136</c:v>
                </c:pt>
                <c:pt idx="5">
                  <c:v>112.25045226581776</c:v>
                </c:pt>
                <c:pt idx="6">
                  <c:v>113.0693684019908</c:v>
                </c:pt>
                <c:pt idx="7">
                  <c:v>114.29040269508859</c:v>
                </c:pt>
                <c:pt idx="8">
                  <c:v>116.47283330231171</c:v>
                </c:pt>
                <c:pt idx="9">
                  <c:v>115.38067125595921</c:v>
                </c:pt>
                <c:pt idx="10">
                  <c:v>116.53659321649943</c:v>
                </c:pt>
                <c:pt idx="11">
                  <c:v>119.83769261018861</c:v>
                </c:pt>
                <c:pt idx="12">
                  <c:v>121.91400306069897</c:v>
                </c:pt>
                <c:pt idx="13">
                  <c:v>121.95952855381691</c:v>
                </c:pt>
                <c:pt idx="14">
                  <c:v>124.32530982039556</c:v>
                </c:pt>
                <c:pt idx="15">
                  <c:v>127.09518404445186</c:v>
                </c:pt>
                <c:pt idx="16">
                  <c:v>129.00596633794311</c:v>
                </c:pt>
                <c:pt idx="17">
                  <c:v>129.73278383119239</c:v>
                </c:pt>
                <c:pt idx="18">
                  <c:v>124.21887878086204</c:v>
                </c:pt>
                <c:pt idx="19">
                  <c:v>126.48356398722191</c:v>
                </c:pt>
                <c:pt idx="20">
                  <c:v>125.543175653888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72B-4D05-97A1-AD390802C11A}"/>
            </c:ext>
          </c:extLst>
        </c:ser>
        <c:ser>
          <c:idx val="5"/>
          <c:order val="5"/>
          <c:tx>
            <c:strRef>
              <c:f>'[072817 HTS Hit Analysis RESPYR Telmisartan DRC.xlsx] Calculations'!$BV$3</c:f>
              <c:strCache>
                <c:ptCount val="1"/>
                <c:pt idx="0">
                  <c:v>1 µM Telmisartan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star"/>
            <c:size val="4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072817 HTS Hit Analysis RESPYR Telmisartan DRC.xlsx] Calculations'!$BV$29:$BV$50</c:f>
                <c:numCache>
                  <c:formatCode>General</c:formatCode>
                  <c:ptCount val="22"/>
                  <c:pt idx="0">
                    <c:v>0.89818807593837413</c:v>
                  </c:pt>
                  <c:pt idx="1">
                    <c:v>1.2275390541040314</c:v>
                  </c:pt>
                  <c:pt idx="2">
                    <c:v>1.6574929601654946</c:v>
                  </c:pt>
                  <c:pt idx="3">
                    <c:v>0.58635977599427258</c:v>
                  </c:pt>
                  <c:pt idx="4">
                    <c:v>1.2182595642834042</c:v>
                  </c:pt>
                  <c:pt idx="5">
                    <c:v>1.0715259678616116</c:v>
                  </c:pt>
                  <c:pt idx="6">
                    <c:v>1.0120878352772433</c:v>
                  </c:pt>
                  <c:pt idx="7">
                    <c:v>1.8114752888211683</c:v>
                  </c:pt>
                  <c:pt idx="8">
                    <c:v>0.91131309393757598</c:v>
                  </c:pt>
                  <c:pt idx="9">
                    <c:v>1.0993825962140755</c:v>
                  </c:pt>
                  <c:pt idx="10">
                    <c:v>1.5252009841369847</c:v>
                  </c:pt>
                  <c:pt idx="11">
                    <c:v>1.6069526256619682</c:v>
                  </c:pt>
                  <c:pt idx="12">
                    <c:v>0.64601223934290308</c:v>
                  </c:pt>
                  <c:pt idx="13">
                    <c:v>0.43720193792922535</c:v>
                  </c:pt>
                  <c:pt idx="14">
                    <c:v>0.61627982450347307</c:v>
                  </c:pt>
                  <c:pt idx="15">
                    <c:v>1.4875981871358437</c:v>
                  </c:pt>
                  <c:pt idx="16">
                    <c:v>0.95460940840061992</c:v>
                  </c:pt>
                  <c:pt idx="17">
                    <c:v>1.2825898150815753</c:v>
                  </c:pt>
                  <c:pt idx="18">
                    <c:v>0.8042332506050669</c:v>
                  </c:pt>
                  <c:pt idx="19">
                    <c:v>1.1688309885656949</c:v>
                  </c:pt>
                  <c:pt idx="20">
                    <c:v>1.4594024537362882</c:v>
                  </c:pt>
                </c:numCache>
              </c:numRef>
            </c:plus>
            <c:minus>
              <c:numRef>
                <c:f>'[072817 HTS Hit Analysis RESPYR Telmisartan DRC.xlsx] Calculations'!$BV$29:$BV$50</c:f>
                <c:numCache>
                  <c:formatCode>General</c:formatCode>
                  <c:ptCount val="22"/>
                  <c:pt idx="0">
                    <c:v>0.89818807593837413</c:v>
                  </c:pt>
                  <c:pt idx="1">
                    <c:v>1.2275390541040314</c:v>
                  </c:pt>
                  <c:pt idx="2">
                    <c:v>1.6574929601654946</c:v>
                  </c:pt>
                  <c:pt idx="3">
                    <c:v>0.58635977599427258</c:v>
                  </c:pt>
                  <c:pt idx="4">
                    <c:v>1.2182595642834042</c:v>
                  </c:pt>
                  <c:pt idx="5">
                    <c:v>1.0715259678616116</c:v>
                  </c:pt>
                  <c:pt idx="6">
                    <c:v>1.0120878352772433</c:v>
                  </c:pt>
                  <c:pt idx="7">
                    <c:v>1.8114752888211683</c:v>
                  </c:pt>
                  <c:pt idx="8">
                    <c:v>0.91131309393757598</c:v>
                  </c:pt>
                  <c:pt idx="9">
                    <c:v>1.0993825962140755</c:v>
                  </c:pt>
                  <c:pt idx="10">
                    <c:v>1.5252009841369847</c:v>
                  </c:pt>
                  <c:pt idx="11">
                    <c:v>1.6069526256619682</c:v>
                  </c:pt>
                  <c:pt idx="12">
                    <c:v>0.64601223934290308</c:v>
                  </c:pt>
                  <c:pt idx="13">
                    <c:v>0.43720193792922535</c:v>
                  </c:pt>
                  <c:pt idx="14">
                    <c:v>0.61627982450347307</c:v>
                  </c:pt>
                  <c:pt idx="15">
                    <c:v>1.4875981871358437</c:v>
                  </c:pt>
                  <c:pt idx="16">
                    <c:v>0.95460940840061992</c:v>
                  </c:pt>
                  <c:pt idx="17">
                    <c:v>1.2825898150815753</c:v>
                  </c:pt>
                  <c:pt idx="18">
                    <c:v>0.8042332506050669</c:v>
                  </c:pt>
                  <c:pt idx="19">
                    <c:v>1.1688309885656949</c:v>
                  </c:pt>
                  <c:pt idx="20">
                    <c:v>1.4594024537362882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xVal>
            <c:numRef>
              <c:f>'[072817 HTS Hit Analysis RESPYR Telmisartan DRC.xlsx]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</c:numCache>
            </c:numRef>
          </c:xVal>
          <c:yVal>
            <c:numRef>
              <c:f>'[072817 HTS Hit Analysis RESPYR Telmisartan DRC.xlsx] Calculations'!$BV$4:$BV$25</c:f>
              <c:numCache>
                <c:formatCode>General</c:formatCode>
                <c:ptCount val="22"/>
                <c:pt idx="0">
                  <c:v>96.891616827606569</c:v>
                </c:pt>
                <c:pt idx="1">
                  <c:v>98.589641362793728</c:v>
                </c:pt>
                <c:pt idx="2">
                  <c:v>100</c:v>
                </c:pt>
                <c:pt idx="3">
                  <c:v>102.99550271240452</c:v>
                </c:pt>
                <c:pt idx="4">
                  <c:v>108.17157411731655</c:v>
                </c:pt>
                <c:pt idx="5">
                  <c:v>109.29623780134168</c:v>
                </c:pt>
                <c:pt idx="6">
                  <c:v>111.85190407281311</c:v>
                </c:pt>
                <c:pt idx="7">
                  <c:v>109.53221217695641</c:v>
                </c:pt>
                <c:pt idx="8">
                  <c:v>111.94379620516057</c:v>
                </c:pt>
                <c:pt idx="9">
                  <c:v>114.88421648628231</c:v>
                </c:pt>
                <c:pt idx="10">
                  <c:v>112.74134196088794</c:v>
                </c:pt>
                <c:pt idx="11">
                  <c:v>117.71075786154101</c:v>
                </c:pt>
                <c:pt idx="12">
                  <c:v>118.19615408577523</c:v>
                </c:pt>
                <c:pt idx="13">
                  <c:v>119.09418113297177</c:v>
                </c:pt>
                <c:pt idx="14">
                  <c:v>120.33547316559022</c:v>
                </c:pt>
                <c:pt idx="15">
                  <c:v>118.9067268492948</c:v>
                </c:pt>
                <c:pt idx="16">
                  <c:v>120.61379711496252</c:v>
                </c:pt>
                <c:pt idx="17">
                  <c:v>116.38221759002386</c:v>
                </c:pt>
                <c:pt idx="18">
                  <c:v>121.1752242545908</c:v>
                </c:pt>
                <c:pt idx="19">
                  <c:v>122.94938281722673</c:v>
                </c:pt>
                <c:pt idx="20">
                  <c:v>123.127502092736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72B-4D05-97A1-AD390802C1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43951296"/>
        <c:axId val="-843950752"/>
      </c:scatterChart>
      <c:valAx>
        <c:axId val="-84395129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-843950752"/>
        <c:crosses val="autoZero"/>
        <c:crossBetween val="midCat"/>
      </c:valAx>
      <c:valAx>
        <c:axId val="-843950752"/>
        <c:scaling>
          <c:orientation val="minMax"/>
          <c:min val="9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BRET (% of basa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-84395129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2971899164902648"/>
          <c:y val="1.5951370920499031E-2"/>
          <c:w val="0.32581089617643988"/>
          <c:h val="0.35799860419249324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298678538779521"/>
          <c:y val="0.25528260627350058"/>
          <c:w val="0.69818697221581361"/>
          <c:h val="0.61642089191502281"/>
        </c:manualLayout>
      </c:layout>
      <c:scatterChart>
        <c:scatterStyle val="lineMarker"/>
        <c:varyColors val="0"/>
        <c:ser>
          <c:idx val="0"/>
          <c:order val="0"/>
          <c:tx>
            <c:strRef>
              <c:f>' Calculations'!$BQ$3</c:f>
              <c:strCache>
                <c:ptCount val="1"/>
                <c:pt idx="0">
                  <c:v>DMSO</c:v>
                </c:pt>
              </c:strCache>
            </c:strRef>
          </c:tx>
          <c:spPr>
            <a:ln w="9525">
              <a:solidFill>
                <a:srgbClr val="00B0F0"/>
              </a:solidFill>
            </a:ln>
          </c:spPr>
          <c:marker>
            <c:symbol val="square"/>
            <c:size val="4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Q$29:$BQ$50</c:f>
                <c:numCache>
                  <c:formatCode>General</c:formatCode>
                  <c:ptCount val="22"/>
                  <c:pt idx="0">
                    <c:v>0.68808570372167266</c:v>
                  </c:pt>
                  <c:pt idx="1">
                    <c:v>0.65596714062073724</c:v>
                  </c:pt>
                  <c:pt idx="2">
                    <c:v>1.2147111866879241</c:v>
                  </c:pt>
                  <c:pt idx="3">
                    <c:v>1.0957841288634083</c:v>
                  </c:pt>
                  <c:pt idx="4">
                    <c:v>0.51300497830240499</c:v>
                  </c:pt>
                  <c:pt idx="5">
                    <c:v>0.51198308576878737</c:v>
                  </c:pt>
                  <c:pt idx="6">
                    <c:v>0.67767693444159927</c:v>
                  </c:pt>
                  <c:pt idx="7">
                    <c:v>1.6534828355078024</c:v>
                  </c:pt>
                  <c:pt idx="8">
                    <c:v>1.3043259603215076</c:v>
                  </c:pt>
                  <c:pt idx="9">
                    <c:v>1.0602616064600996</c:v>
                  </c:pt>
                  <c:pt idx="10">
                    <c:v>1.3033033187863343</c:v>
                  </c:pt>
                  <c:pt idx="11">
                    <c:v>1.0208020166272223</c:v>
                  </c:pt>
                  <c:pt idx="12">
                    <c:v>0.47572208796412979</c:v>
                  </c:pt>
                  <c:pt idx="13">
                    <c:v>1.273805449597615</c:v>
                  </c:pt>
                  <c:pt idx="14">
                    <c:v>1.0327820642734979</c:v>
                  </c:pt>
                  <c:pt idx="15">
                    <c:v>1.9570291572275991</c:v>
                  </c:pt>
                  <c:pt idx="16">
                    <c:v>1.2393723489400357</c:v>
                  </c:pt>
                  <c:pt idx="17">
                    <c:v>2.1062699858071721</c:v>
                  </c:pt>
                  <c:pt idx="18">
                    <c:v>1.2483535555766765</c:v>
                  </c:pt>
                  <c:pt idx="19">
                    <c:v>0.83500999908177942</c:v>
                  </c:pt>
                  <c:pt idx="20">
                    <c:v>0.56663301190084914</c:v>
                  </c:pt>
                  <c:pt idx="21">
                    <c:v>1.6529703055196034</c:v>
                  </c:pt>
                </c:numCache>
              </c:numRef>
            </c:plus>
            <c:minus>
              <c:numRef>
                <c:f>' Calculations'!$BQ$29:$BQ$50</c:f>
                <c:numCache>
                  <c:formatCode>General</c:formatCode>
                  <c:ptCount val="22"/>
                  <c:pt idx="0">
                    <c:v>0.68808570372167266</c:v>
                  </c:pt>
                  <c:pt idx="1">
                    <c:v>0.65596714062073724</c:v>
                  </c:pt>
                  <c:pt idx="2">
                    <c:v>1.2147111866879241</c:v>
                  </c:pt>
                  <c:pt idx="3">
                    <c:v>1.0957841288634083</c:v>
                  </c:pt>
                  <c:pt idx="4">
                    <c:v>0.51300497830240499</c:v>
                  </c:pt>
                  <c:pt idx="5">
                    <c:v>0.51198308576878737</c:v>
                  </c:pt>
                  <c:pt idx="6">
                    <c:v>0.67767693444159927</c:v>
                  </c:pt>
                  <c:pt idx="7">
                    <c:v>1.6534828355078024</c:v>
                  </c:pt>
                  <c:pt idx="8">
                    <c:v>1.3043259603215076</c:v>
                  </c:pt>
                  <c:pt idx="9">
                    <c:v>1.0602616064600996</c:v>
                  </c:pt>
                  <c:pt idx="10">
                    <c:v>1.3033033187863343</c:v>
                  </c:pt>
                  <c:pt idx="11">
                    <c:v>1.0208020166272223</c:v>
                  </c:pt>
                  <c:pt idx="12">
                    <c:v>0.47572208796412979</c:v>
                  </c:pt>
                  <c:pt idx="13">
                    <c:v>1.273805449597615</c:v>
                  </c:pt>
                  <c:pt idx="14">
                    <c:v>1.0327820642734979</c:v>
                  </c:pt>
                  <c:pt idx="15">
                    <c:v>1.9570291572275991</c:v>
                  </c:pt>
                  <c:pt idx="16">
                    <c:v>1.2393723489400357</c:v>
                  </c:pt>
                  <c:pt idx="17">
                    <c:v>2.1062699858071721</c:v>
                  </c:pt>
                  <c:pt idx="18">
                    <c:v>1.2483535555766765</c:v>
                  </c:pt>
                  <c:pt idx="19">
                    <c:v>0.83500999908177942</c:v>
                  </c:pt>
                  <c:pt idx="20">
                    <c:v>0.56663301190084914</c:v>
                  </c:pt>
                  <c:pt idx="21">
                    <c:v>1.6529703055196034</c:v>
                  </c:pt>
                </c:numCache>
              </c:numRef>
            </c:minus>
            <c:spPr>
              <a:ln>
                <a:solidFill>
                  <a:srgbClr val="00B0F0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Q$4:$BQ$25</c:f>
              <c:numCache>
                <c:formatCode>General</c:formatCode>
                <c:ptCount val="22"/>
                <c:pt idx="0">
                  <c:v>97.891492157076243</c:v>
                </c:pt>
                <c:pt idx="1">
                  <c:v>96.535328945333191</c:v>
                </c:pt>
                <c:pt idx="2">
                  <c:v>100</c:v>
                </c:pt>
                <c:pt idx="3">
                  <c:v>103.80820494479666</c:v>
                </c:pt>
                <c:pt idx="4">
                  <c:v>107.43137697881497</c:v>
                </c:pt>
                <c:pt idx="5">
                  <c:v>107.49920350634947</c:v>
                </c:pt>
                <c:pt idx="6">
                  <c:v>109.00068529744193</c:v>
                </c:pt>
                <c:pt idx="7">
                  <c:v>114.35395334388656</c:v>
                </c:pt>
                <c:pt idx="8">
                  <c:v>112.33365913214179</c:v>
                </c:pt>
                <c:pt idx="9">
                  <c:v>116.50942743264909</c:v>
                </c:pt>
                <c:pt idx="10">
                  <c:v>118.9396830577073</c:v>
                </c:pt>
                <c:pt idx="11">
                  <c:v>119.82696223981675</c:v>
                </c:pt>
                <c:pt idx="12">
                  <c:v>120.07603526232474</c:v>
                </c:pt>
                <c:pt idx="13">
                  <c:v>121.23714760200477</c:v>
                </c:pt>
                <c:pt idx="14">
                  <c:v>125.24339722563691</c:v>
                </c:pt>
                <c:pt idx="15">
                  <c:v>127.25274454409603</c:v>
                </c:pt>
                <c:pt idx="16">
                  <c:v>127.13219837558749</c:v>
                </c:pt>
                <c:pt idx="17">
                  <c:v>127.30447432529868</c:v>
                </c:pt>
                <c:pt idx="18">
                  <c:v>126.08758881882753</c:v>
                </c:pt>
                <c:pt idx="19">
                  <c:v>127.4426327281161</c:v>
                </c:pt>
                <c:pt idx="20">
                  <c:v>128.55741526761045</c:v>
                </c:pt>
                <c:pt idx="21">
                  <c:v>129.357396035775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939-49CE-A12C-24436756E128}"/>
            </c:ext>
          </c:extLst>
        </c:ser>
        <c:ser>
          <c:idx val="1"/>
          <c:order val="1"/>
          <c:tx>
            <c:strRef>
              <c:f>' Calculations'!$BR$3</c:f>
              <c:strCache>
                <c:ptCount val="1"/>
                <c:pt idx="0">
                  <c:v>5 µM UK5099</c:v>
                </c:pt>
              </c:strCache>
            </c:strRef>
          </c:tx>
          <c:spPr>
            <a:ln w="9525">
              <a:solidFill>
                <a:schemeClr val="accent2">
                  <a:lumMod val="75000"/>
                </a:schemeClr>
              </a:solidFill>
            </a:ln>
          </c:spPr>
          <c:marker>
            <c:symbol val="circle"/>
            <c:size val="4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R$29:$BR$50</c:f>
                <c:numCache>
                  <c:formatCode>General</c:formatCode>
                  <c:ptCount val="22"/>
                  <c:pt idx="0">
                    <c:v>2.078013983393487</c:v>
                  </c:pt>
                  <c:pt idx="1">
                    <c:v>0.96823862104727221</c:v>
                  </c:pt>
                  <c:pt idx="2">
                    <c:v>1.2262255303606757</c:v>
                  </c:pt>
                  <c:pt idx="3">
                    <c:v>0.80635143849927071</c:v>
                  </c:pt>
                  <c:pt idx="4">
                    <c:v>1.4463561000319403</c:v>
                  </c:pt>
                  <c:pt idx="5">
                    <c:v>1.3527016447683411</c:v>
                  </c:pt>
                  <c:pt idx="6">
                    <c:v>1.068982370827263</c:v>
                  </c:pt>
                  <c:pt idx="7">
                    <c:v>1.4613136720894691</c:v>
                  </c:pt>
                  <c:pt idx="8">
                    <c:v>0.94541291871874067</c:v>
                  </c:pt>
                  <c:pt idx="9">
                    <c:v>1.5500010578154406</c:v>
                  </c:pt>
                  <c:pt idx="10">
                    <c:v>1.4206426164047357</c:v>
                  </c:pt>
                  <c:pt idx="11">
                    <c:v>1.50112997683552</c:v>
                  </c:pt>
                  <c:pt idx="12">
                    <c:v>0.87040014146518985</c:v>
                  </c:pt>
                  <c:pt idx="13">
                    <c:v>0.91067649118654592</c:v>
                  </c:pt>
                  <c:pt idx="14">
                    <c:v>0.75594995622405137</c:v>
                  </c:pt>
                  <c:pt idx="15">
                    <c:v>1.4981963363438859</c:v>
                  </c:pt>
                  <c:pt idx="16">
                    <c:v>1.3519935699450105</c:v>
                  </c:pt>
                  <c:pt idx="17">
                    <c:v>1.0194751493209702</c:v>
                  </c:pt>
                  <c:pt idx="18">
                    <c:v>1.3288941715255145</c:v>
                  </c:pt>
                  <c:pt idx="19">
                    <c:v>1.7973469517879235</c:v>
                  </c:pt>
                  <c:pt idx="20">
                    <c:v>1.3924536739382547</c:v>
                  </c:pt>
                  <c:pt idx="21">
                    <c:v>1.100529343200658</c:v>
                  </c:pt>
                </c:numCache>
              </c:numRef>
            </c:plus>
            <c:minus>
              <c:numRef>
                <c:f>' Calculations'!$BR$29:$BR$50</c:f>
                <c:numCache>
                  <c:formatCode>General</c:formatCode>
                  <c:ptCount val="22"/>
                  <c:pt idx="0">
                    <c:v>2.078013983393487</c:v>
                  </c:pt>
                  <c:pt idx="1">
                    <c:v>0.96823862104727221</c:v>
                  </c:pt>
                  <c:pt idx="2">
                    <c:v>1.2262255303606757</c:v>
                  </c:pt>
                  <c:pt idx="3">
                    <c:v>0.80635143849927071</c:v>
                  </c:pt>
                  <c:pt idx="4">
                    <c:v>1.4463561000319403</c:v>
                  </c:pt>
                  <c:pt idx="5">
                    <c:v>1.3527016447683411</c:v>
                  </c:pt>
                  <c:pt idx="6">
                    <c:v>1.068982370827263</c:v>
                  </c:pt>
                  <c:pt idx="7">
                    <c:v>1.4613136720894691</c:v>
                  </c:pt>
                  <c:pt idx="8">
                    <c:v>0.94541291871874067</c:v>
                  </c:pt>
                  <c:pt idx="9">
                    <c:v>1.5500010578154406</c:v>
                  </c:pt>
                  <c:pt idx="10">
                    <c:v>1.4206426164047357</c:v>
                  </c:pt>
                  <c:pt idx="11">
                    <c:v>1.50112997683552</c:v>
                  </c:pt>
                  <c:pt idx="12">
                    <c:v>0.87040014146518985</c:v>
                  </c:pt>
                  <c:pt idx="13">
                    <c:v>0.91067649118654592</c:v>
                  </c:pt>
                  <c:pt idx="14">
                    <c:v>0.75594995622405137</c:v>
                  </c:pt>
                  <c:pt idx="15">
                    <c:v>1.4981963363438859</c:v>
                  </c:pt>
                  <c:pt idx="16">
                    <c:v>1.3519935699450105</c:v>
                  </c:pt>
                  <c:pt idx="17">
                    <c:v>1.0194751493209702</c:v>
                  </c:pt>
                  <c:pt idx="18">
                    <c:v>1.3288941715255145</c:v>
                  </c:pt>
                  <c:pt idx="19">
                    <c:v>1.7973469517879235</c:v>
                  </c:pt>
                  <c:pt idx="20">
                    <c:v>1.3924536739382547</c:v>
                  </c:pt>
                  <c:pt idx="21">
                    <c:v>1.100529343200658</c:v>
                  </c:pt>
                </c:numCache>
              </c:numRef>
            </c:minus>
            <c:spPr>
              <a:ln>
                <a:solidFill>
                  <a:schemeClr val="accent2">
                    <a:lumMod val="75000"/>
                  </a:schemeClr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R$4:$BR$25</c:f>
              <c:numCache>
                <c:formatCode>General</c:formatCode>
                <c:ptCount val="22"/>
                <c:pt idx="0">
                  <c:v>95.170130022970966</c:v>
                </c:pt>
                <c:pt idx="1">
                  <c:v>94.710221522449388</c:v>
                </c:pt>
                <c:pt idx="2">
                  <c:v>100</c:v>
                </c:pt>
                <c:pt idx="3">
                  <c:v>139.83845660850923</c:v>
                </c:pt>
                <c:pt idx="4">
                  <c:v>146.39894073351368</c:v>
                </c:pt>
                <c:pt idx="5">
                  <c:v>149.12132788736471</c:v>
                </c:pt>
                <c:pt idx="6">
                  <c:v>152.52862139200445</c:v>
                </c:pt>
                <c:pt idx="7">
                  <c:v>155.72764494860988</c:v>
                </c:pt>
                <c:pt idx="8">
                  <c:v>157.34562570761068</c:v>
                </c:pt>
                <c:pt idx="9">
                  <c:v>159.33416349936326</c:v>
                </c:pt>
                <c:pt idx="10">
                  <c:v>163.77853597478796</c:v>
                </c:pt>
                <c:pt idx="11">
                  <c:v>167.15909952188349</c:v>
                </c:pt>
                <c:pt idx="12">
                  <c:v>167.67361095619268</c:v>
                </c:pt>
                <c:pt idx="13">
                  <c:v>168.22347107766873</c:v>
                </c:pt>
                <c:pt idx="14">
                  <c:v>175.85869527582162</c:v>
                </c:pt>
                <c:pt idx="15">
                  <c:v>176.47828177534021</c:v>
                </c:pt>
                <c:pt idx="16">
                  <c:v>175.72316128166256</c:v>
                </c:pt>
                <c:pt idx="17">
                  <c:v>182.57901136417541</c:v>
                </c:pt>
                <c:pt idx="18">
                  <c:v>182.53509498038568</c:v>
                </c:pt>
                <c:pt idx="19">
                  <c:v>179.59965398297933</c:v>
                </c:pt>
                <c:pt idx="20">
                  <c:v>182.32891120868109</c:v>
                </c:pt>
                <c:pt idx="21">
                  <c:v>182.06539273191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939-49CE-A12C-24436756E128}"/>
            </c:ext>
          </c:extLst>
        </c:ser>
        <c:ser>
          <c:idx val="2"/>
          <c:order val="2"/>
          <c:tx>
            <c:strRef>
              <c:f>' Calculations'!$BS$3</c:f>
              <c:strCache>
                <c:ptCount val="1"/>
                <c:pt idx="0">
                  <c:v>10 µM Dantrolene Na Salt</c:v>
                </c:pt>
              </c:strCache>
            </c:strRef>
          </c:tx>
          <c:spPr>
            <a:ln w="9525"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S$29:$BS$50</c:f>
                <c:numCache>
                  <c:formatCode>General</c:formatCode>
                  <c:ptCount val="22"/>
                  <c:pt idx="0">
                    <c:v>1.3221819413467621</c:v>
                  </c:pt>
                  <c:pt idx="1">
                    <c:v>1.6660230474502529</c:v>
                  </c:pt>
                  <c:pt idx="2">
                    <c:v>0.51339708002320128</c:v>
                  </c:pt>
                  <c:pt idx="3">
                    <c:v>2.7392457493139077</c:v>
                  </c:pt>
                  <c:pt idx="4">
                    <c:v>0.39202602742554232</c:v>
                  </c:pt>
                  <c:pt idx="5">
                    <c:v>0.91647633557619035</c:v>
                  </c:pt>
                  <c:pt idx="6">
                    <c:v>0.97554222471715468</c:v>
                  </c:pt>
                  <c:pt idx="7">
                    <c:v>1.2129924599575381</c:v>
                  </c:pt>
                  <c:pt idx="8">
                    <c:v>1.0066966144214868</c:v>
                  </c:pt>
                  <c:pt idx="9">
                    <c:v>1.3509863753109277</c:v>
                  </c:pt>
                  <c:pt idx="10">
                    <c:v>1.0040190463980534</c:v>
                  </c:pt>
                  <c:pt idx="11">
                    <c:v>0.8517492886847331</c:v>
                  </c:pt>
                  <c:pt idx="12">
                    <c:v>1.2151237243102975</c:v>
                  </c:pt>
                  <c:pt idx="13">
                    <c:v>0.61755467322548496</c:v>
                  </c:pt>
                  <c:pt idx="14">
                    <c:v>1.4170826194915866</c:v>
                  </c:pt>
                  <c:pt idx="15">
                    <c:v>1.2343544359225094</c:v>
                  </c:pt>
                  <c:pt idx="16">
                    <c:v>1.1223390092419261</c:v>
                  </c:pt>
                  <c:pt idx="17">
                    <c:v>0.90946592131242032</c:v>
                  </c:pt>
                  <c:pt idx="18">
                    <c:v>1.2429230595150387</c:v>
                  </c:pt>
                  <c:pt idx="19">
                    <c:v>1.3397058588152171</c:v>
                  </c:pt>
                  <c:pt idx="20">
                    <c:v>0.82060552283117083</c:v>
                  </c:pt>
                  <c:pt idx="21">
                    <c:v>2.3064598868227084</c:v>
                  </c:pt>
                </c:numCache>
              </c:numRef>
            </c:plus>
            <c:minus>
              <c:numRef>
                <c:f>' Calculations'!$BS$29:$BS$50</c:f>
                <c:numCache>
                  <c:formatCode>General</c:formatCode>
                  <c:ptCount val="22"/>
                  <c:pt idx="0">
                    <c:v>1.3221819413467621</c:v>
                  </c:pt>
                  <c:pt idx="1">
                    <c:v>1.6660230474502529</c:v>
                  </c:pt>
                  <c:pt idx="2">
                    <c:v>0.51339708002320128</c:v>
                  </c:pt>
                  <c:pt idx="3">
                    <c:v>2.7392457493139077</c:v>
                  </c:pt>
                  <c:pt idx="4">
                    <c:v>0.39202602742554232</c:v>
                  </c:pt>
                  <c:pt idx="5">
                    <c:v>0.91647633557619035</c:v>
                  </c:pt>
                  <c:pt idx="6">
                    <c:v>0.97554222471715468</c:v>
                  </c:pt>
                  <c:pt idx="7">
                    <c:v>1.2129924599575381</c:v>
                  </c:pt>
                  <c:pt idx="8">
                    <c:v>1.0066966144214868</c:v>
                  </c:pt>
                  <c:pt idx="9">
                    <c:v>1.3509863753109277</c:v>
                  </c:pt>
                  <c:pt idx="10">
                    <c:v>1.0040190463980534</c:v>
                  </c:pt>
                  <c:pt idx="11">
                    <c:v>0.8517492886847331</c:v>
                  </c:pt>
                  <c:pt idx="12">
                    <c:v>1.2151237243102975</c:v>
                  </c:pt>
                  <c:pt idx="13">
                    <c:v>0.61755467322548496</c:v>
                  </c:pt>
                  <c:pt idx="14">
                    <c:v>1.4170826194915866</c:v>
                  </c:pt>
                  <c:pt idx="15">
                    <c:v>1.2343544359225094</c:v>
                  </c:pt>
                  <c:pt idx="16">
                    <c:v>1.1223390092419261</c:v>
                  </c:pt>
                  <c:pt idx="17">
                    <c:v>0.90946592131242032</c:v>
                  </c:pt>
                  <c:pt idx="18">
                    <c:v>1.2429230595150387</c:v>
                  </c:pt>
                  <c:pt idx="19">
                    <c:v>1.3397058588152171</c:v>
                  </c:pt>
                  <c:pt idx="20">
                    <c:v>0.82060552283117083</c:v>
                  </c:pt>
                  <c:pt idx="21">
                    <c:v>2.3064598868227084</c:v>
                  </c:pt>
                </c:numCache>
              </c:numRef>
            </c:minus>
            <c:spPr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S$4:$BS$25</c:f>
              <c:numCache>
                <c:formatCode>General</c:formatCode>
                <c:ptCount val="22"/>
                <c:pt idx="0">
                  <c:v>99.14849360391689</c:v>
                </c:pt>
                <c:pt idx="1">
                  <c:v>98.251692696313526</c:v>
                </c:pt>
                <c:pt idx="2">
                  <c:v>100</c:v>
                </c:pt>
                <c:pt idx="3">
                  <c:v>155.19994717775199</c:v>
                </c:pt>
                <c:pt idx="4">
                  <c:v>150.87536230342738</c:v>
                </c:pt>
                <c:pt idx="5">
                  <c:v>152.90391790837663</c:v>
                </c:pt>
                <c:pt idx="6">
                  <c:v>156.70556049667479</c:v>
                </c:pt>
                <c:pt idx="7">
                  <c:v>156.29752539812628</c:v>
                </c:pt>
                <c:pt idx="8">
                  <c:v>158.70623773796672</c:v>
                </c:pt>
                <c:pt idx="9">
                  <c:v>166.82682939099658</c:v>
                </c:pt>
                <c:pt idx="10">
                  <c:v>166.52227177845157</c:v>
                </c:pt>
                <c:pt idx="11">
                  <c:v>165.98949924796332</c:v>
                </c:pt>
                <c:pt idx="12">
                  <c:v>175.66119535938373</c:v>
                </c:pt>
                <c:pt idx="13">
                  <c:v>174.20658898239415</c:v>
                </c:pt>
                <c:pt idx="14">
                  <c:v>178.64084838526097</c:v>
                </c:pt>
                <c:pt idx="15">
                  <c:v>179.33929225230432</c:v>
                </c:pt>
                <c:pt idx="16">
                  <c:v>178.67727782470359</c:v>
                </c:pt>
                <c:pt idx="17">
                  <c:v>186.40294460477764</c:v>
                </c:pt>
                <c:pt idx="18">
                  <c:v>185.75872493640938</c:v>
                </c:pt>
                <c:pt idx="19">
                  <c:v>190.48418559395915</c:v>
                </c:pt>
                <c:pt idx="20">
                  <c:v>188.99474122921271</c:v>
                </c:pt>
                <c:pt idx="21">
                  <c:v>191.194241003608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8939-49CE-A12C-24436756E128}"/>
            </c:ext>
          </c:extLst>
        </c:ser>
        <c:ser>
          <c:idx val="3"/>
          <c:order val="3"/>
          <c:tx>
            <c:strRef>
              <c:f>' Calculations'!$BT$3</c:f>
              <c:strCache>
                <c:ptCount val="1"/>
                <c:pt idx="0">
                  <c:v>1 µM Dantrolene Na Salt</c:v>
                </c:pt>
              </c:strCache>
            </c:strRef>
          </c:tx>
          <c:spPr>
            <a:ln w="9525">
              <a:solidFill>
                <a:schemeClr val="accent2">
                  <a:lumMod val="40000"/>
                  <a:lumOff val="60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accent2">
                  <a:lumMod val="40000"/>
                  <a:lumOff val="60000"/>
                </a:schemeClr>
              </a:solidFill>
              <a:ln w="9525">
                <a:solidFill>
                  <a:schemeClr val="accent2">
                    <a:lumMod val="40000"/>
                    <a:lumOff val="6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T$29:$BT$50</c:f>
                <c:numCache>
                  <c:formatCode>General</c:formatCode>
                  <c:ptCount val="22"/>
                  <c:pt idx="0">
                    <c:v>1.7091629301566169</c:v>
                  </c:pt>
                  <c:pt idx="1">
                    <c:v>0.80389204428577987</c:v>
                  </c:pt>
                  <c:pt idx="2">
                    <c:v>1.0036842461816684</c:v>
                  </c:pt>
                  <c:pt idx="3">
                    <c:v>2.1109936064269625</c:v>
                  </c:pt>
                  <c:pt idx="4">
                    <c:v>2.2948329800711291</c:v>
                  </c:pt>
                  <c:pt idx="5">
                    <c:v>1.0949985491610048</c:v>
                  </c:pt>
                  <c:pt idx="6">
                    <c:v>1.2575427458341004</c:v>
                  </c:pt>
                  <c:pt idx="7">
                    <c:v>1.3501024682068703</c:v>
                  </c:pt>
                  <c:pt idx="8">
                    <c:v>1.1189084657972808</c:v>
                  </c:pt>
                  <c:pt idx="9">
                    <c:v>0.78713919667104337</c:v>
                  </c:pt>
                  <c:pt idx="10">
                    <c:v>1.7431626816848007</c:v>
                  </c:pt>
                  <c:pt idx="11">
                    <c:v>0.6824324924324251</c:v>
                  </c:pt>
                  <c:pt idx="12">
                    <c:v>0.65224047173898292</c:v>
                  </c:pt>
                  <c:pt idx="13">
                    <c:v>1.8247885034277904</c:v>
                  </c:pt>
                  <c:pt idx="14">
                    <c:v>1.6662046913149142</c:v>
                  </c:pt>
                  <c:pt idx="15">
                    <c:v>0.97586876732662153</c:v>
                  </c:pt>
                  <c:pt idx="16">
                    <c:v>1.0485047313939715</c:v>
                  </c:pt>
                  <c:pt idx="17">
                    <c:v>0.81155688893029609</c:v>
                  </c:pt>
                  <c:pt idx="18">
                    <c:v>1.4455066431688097</c:v>
                  </c:pt>
                  <c:pt idx="19">
                    <c:v>1.4740707402222351</c:v>
                  </c:pt>
                  <c:pt idx="20">
                    <c:v>1.4426600334184283</c:v>
                  </c:pt>
                  <c:pt idx="21">
                    <c:v>1.379420433737502</c:v>
                  </c:pt>
                </c:numCache>
              </c:numRef>
            </c:plus>
            <c:minus>
              <c:numRef>
                <c:f>' Calculations'!$BT$29:$BT$50</c:f>
                <c:numCache>
                  <c:formatCode>General</c:formatCode>
                  <c:ptCount val="22"/>
                  <c:pt idx="0">
                    <c:v>1.7091629301566169</c:v>
                  </c:pt>
                  <c:pt idx="1">
                    <c:v>0.80389204428577987</c:v>
                  </c:pt>
                  <c:pt idx="2">
                    <c:v>1.0036842461816684</c:v>
                  </c:pt>
                  <c:pt idx="3">
                    <c:v>2.1109936064269625</c:v>
                  </c:pt>
                  <c:pt idx="4">
                    <c:v>2.2948329800711291</c:v>
                  </c:pt>
                  <c:pt idx="5">
                    <c:v>1.0949985491610048</c:v>
                  </c:pt>
                  <c:pt idx="6">
                    <c:v>1.2575427458341004</c:v>
                  </c:pt>
                  <c:pt idx="7">
                    <c:v>1.3501024682068703</c:v>
                  </c:pt>
                  <c:pt idx="8">
                    <c:v>1.1189084657972808</c:v>
                  </c:pt>
                  <c:pt idx="9">
                    <c:v>0.78713919667104337</c:v>
                  </c:pt>
                  <c:pt idx="10">
                    <c:v>1.7431626816848007</c:v>
                  </c:pt>
                  <c:pt idx="11">
                    <c:v>0.6824324924324251</c:v>
                  </c:pt>
                  <c:pt idx="12">
                    <c:v>0.65224047173898292</c:v>
                  </c:pt>
                  <c:pt idx="13">
                    <c:v>1.8247885034277904</c:v>
                  </c:pt>
                  <c:pt idx="14">
                    <c:v>1.6662046913149142</c:v>
                  </c:pt>
                  <c:pt idx="15">
                    <c:v>0.97586876732662153</c:v>
                  </c:pt>
                  <c:pt idx="16">
                    <c:v>1.0485047313939715</c:v>
                  </c:pt>
                  <c:pt idx="17">
                    <c:v>0.81155688893029609</c:v>
                  </c:pt>
                  <c:pt idx="18">
                    <c:v>1.4455066431688097</c:v>
                  </c:pt>
                  <c:pt idx="19">
                    <c:v>1.4740707402222351</c:v>
                  </c:pt>
                  <c:pt idx="20">
                    <c:v>1.4426600334184283</c:v>
                  </c:pt>
                  <c:pt idx="21">
                    <c:v>1.379420433737502</c:v>
                  </c:pt>
                </c:numCache>
              </c:numRef>
            </c:minus>
            <c:spPr>
              <a:ln>
                <a:solidFill>
                  <a:schemeClr val="accent2">
                    <a:lumMod val="40000"/>
                    <a:lumOff val="60000"/>
                  </a:schemeClr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T$4:$BT$25</c:f>
              <c:numCache>
                <c:formatCode>General</c:formatCode>
                <c:ptCount val="22"/>
                <c:pt idx="0">
                  <c:v>95.396123374248916</c:v>
                </c:pt>
                <c:pt idx="1">
                  <c:v>94.336871669549055</c:v>
                </c:pt>
                <c:pt idx="2">
                  <c:v>100</c:v>
                </c:pt>
                <c:pt idx="3">
                  <c:v>116.58898524280312</c:v>
                </c:pt>
                <c:pt idx="4">
                  <c:v>120.21874479612384</c:v>
                </c:pt>
                <c:pt idx="5">
                  <c:v>118.69856647261552</c:v>
                </c:pt>
                <c:pt idx="6">
                  <c:v>120.86023931788685</c:v>
                </c:pt>
                <c:pt idx="7">
                  <c:v>120.22834142930256</c:v>
                </c:pt>
                <c:pt idx="8">
                  <c:v>124.42814861447908</c:v>
                </c:pt>
                <c:pt idx="9">
                  <c:v>123.20052452607761</c:v>
                </c:pt>
                <c:pt idx="10">
                  <c:v>125.15530832670481</c:v>
                </c:pt>
                <c:pt idx="11">
                  <c:v>128.93579738505611</c:v>
                </c:pt>
                <c:pt idx="12">
                  <c:v>132.50611467852244</c:v>
                </c:pt>
                <c:pt idx="13">
                  <c:v>132.97081583929571</c:v>
                </c:pt>
                <c:pt idx="14">
                  <c:v>135.31527237457135</c:v>
                </c:pt>
                <c:pt idx="15">
                  <c:v>137.54784098770281</c:v>
                </c:pt>
                <c:pt idx="16">
                  <c:v>135.83289966472194</c:v>
                </c:pt>
                <c:pt idx="17">
                  <c:v>135.23367002511873</c:v>
                </c:pt>
                <c:pt idx="18">
                  <c:v>138.39711558639888</c:v>
                </c:pt>
                <c:pt idx="19">
                  <c:v>142.01094521596232</c:v>
                </c:pt>
                <c:pt idx="20">
                  <c:v>144.35063625675355</c:v>
                </c:pt>
                <c:pt idx="21">
                  <c:v>144.6293631283378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939-49CE-A12C-24436756E128}"/>
            </c:ext>
          </c:extLst>
        </c:ser>
        <c:ser>
          <c:idx val="4"/>
          <c:order val="4"/>
          <c:tx>
            <c:strRef>
              <c:f>' Calculations'!$BU$3</c:f>
              <c:strCache>
                <c:ptCount val="1"/>
                <c:pt idx="0">
                  <c:v>0.1 µM Dantrolene Na Salt</c:v>
                </c:pt>
              </c:strCache>
            </c:strRef>
          </c:tx>
          <c:spPr>
            <a:ln w="9525">
              <a:solidFill>
                <a:srgbClr val="00B050"/>
              </a:solidFill>
            </a:ln>
          </c:spPr>
          <c:marker>
            <c:symbol val="circle"/>
            <c:size val="4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U$29:$BU$50</c:f>
                <c:numCache>
                  <c:formatCode>General</c:formatCode>
                  <c:ptCount val="22"/>
                  <c:pt idx="0">
                    <c:v>0.63054013029226874</c:v>
                  </c:pt>
                  <c:pt idx="1">
                    <c:v>1.7735743290923978</c:v>
                  </c:pt>
                  <c:pt idx="2">
                    <c:v>1.1260199765136685</c:v>
                  </c:pt>
                  <c:pt idx="3">
                    <c:v>1.370634790670092</c:v>
                  </c:pt>
                  <c:pt idx="4">
                    <c:v>1.1981818764901297</c:v>
                  </c:pt>
                  <c:pt idx="5">
                    <c:v>1.0356060623918781</c:v>
                  </c:pt>
                  <c:pt idx="6">
                    <c:v>1.0566462792217428</c:v>
                  </c:pt>
                  <c:pt idx="7">
                    <c:v>0.73995236057969116</c:v>
                  </c:pt>
                  <c:pt idx="8">
                    <c:v>1.9619385070509234</c:v>
                  </c:pt>
                  <c:pt idx="9">
                    <c:v>0.92205063702436185</c:v>
                  </c:pt>
                  <c:pt idx="10">
                    <c:v>0.68638483294853792</c:v>
                  </c:pt>
                  <c:pt idx="11">
                    <c:v>2.075707725908515</c:v>
                  </c:pt>
                  <c:pt idx="12">
                    <c:v>1.5500493713381973</c:v>
                  </c:pt>
                  <c:pt idx="13">
                    <c:v>0.74282212035613482</c:v>
                  </c:pt>
                  <c:pt idx="14">
                    <c:v>1.3291788122693446</c:v>
                  </c:pt>
                  <c:pt idx="15">
                    <c:v>1.3407829823654589</c:v>
                  </c:pt>
                  <c:pt idx="16">
                    <c:v>1.3049988880056822</c:v>
                  </c:pt>
                  <c:pt idx="17">
                    <c:v>0.53523765602320372</c:v>
                  </c:pt>
                  <c:pt idx="18">
                    <c:v>1.4152271754800343</c:v>
                  </c:pt>
                  <c:pt idx="19">
                    <c:v>1.3367475974414629</c:v>
                  </c:pt>
                  <c:pt idx="20">
                    <c:v>2.2187226111986629</c:v>
                  </c:pt>
                  <c:pt idx="21">
                    <c:v>1.5870046986199431</c:v>
                  </c:pt>
                </c:numCache>
              </c:numRef>
            </c:plus>
            <c:minus>
              <c:numRef>
                <c:f>' Calculations'!$BU$29:$BU$50</c:f>
                <c:numCache>
                  <c:formatCode>General</c:formatCode>
                  <c:ptCount val="22"/>
                  <c:pt idx="0">
                    <c:v>0.63054013029226874</c:v>
                  </c:pt>
                  <c:pt idx="1">
                    <c:v>1.7735743290923978</c:v>
                  </c:pt>
                  <c:pt idx="2">
                    <c:v>1.1260199765136685</c:v>
                  </c:pt>
                  <c:pt idx="3">
                    <c:v>1.370634790670092</c:v>
                  </c:pt>
                  <c:pt idx="4">
                    <c:v>1.1981818764901297</c:v>
                  </c:pt>
                  <c:pt idx="5">
                    <c:v>1.0356060623918781</c:v>
                  </c:pt>
                  <c:pt idx="6">
                    <c:v>1.0566462792217428</c:v>
                  </c:pt>
                  <c:pt idx="7">
                    <c:v>0.73995236057969116</c:v>
                  </c:pt>
                  <c:pt idx="8">
                    <c:v>1.9619385070509234</c:v>
                  </c:pt>
                  <c:pt idx="9">
                    <c:v>0.92205063702436185</c:v>
                  </c:pt>
                  <c:pt idx="10">
                    <c:v>0.68638483294853792</c:v>
                  </c:pt>
                  <c:pt idx="11">
                    <c:v>2.075707725908515</c:v>
                  </c:pt>
                  <c:pt idx="12">
                    <c:v>1.5500493713381973</c:v>
                  </c:pt>
                  <c:pt idx="13">
                    <c:v>0.74282212035613482</c:v>
                  </c:pt>
                  <c:pt idx="14">
                    <c:v>1.3291788122693446</c:v>
                  </c:pt>
                  <c:pt idx="15">
                    <c:v>1.3407829823654589</c:v>
                  </c:pt>
                  <c:pt idx="16">
                    <c:v>1.3049988880056822</c:v>
                  </c:pt>
                  <c:pt idx="17">
                    <c:v>0.53523765602320372</c:v>
                  </c:pt>
                  <c:pt idx="18">
                    <c:v>1.4152271754800343</c:v>
                  </c:pt>
                  <c:pt idx="19">
                    <c:v>1.3367475974414629</c:v>
                  </c:pt>
                  <c:pt idx="20">
                    <c:v>2.2187226111986629</c:v>
                  </c:pt>
                  <c:pt idx="21">
                    <c:v>1.5870046986199431</c:v>
                  </c:pt>
                </c:numCache>
              </c:numRef>
            </c:minus>
            <c:spPr>
              <a:ln>
                <a:solidFill>
                  <a:srgbClr val="00B050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U$4:$BU$25</c:f>
              <c:numCache>
                <c:formatCode>General</c:formatCode>
                <c:ptCount val="22"/>
                <c:pt idx="0">
                  <c:v>99.162685540253023</c:v>
                </c:pt>
                <c:pt idx="1">
                  <c:v>98.584961736571813</c:v>
                </c:pt>
                <c:pt idx="2">
                  <c:v>100</c:v>
                </c:pt>
                <c:pt idx="3">
                  <c:v>105.95353002211839</c:v>
                </c:pt>
                <c:pt idx="4">
                  <c:v>109.46062686997828</c:v>
                </c:pt>
                <c:pt idx="5">
                  <c:v>110.46318259886039</c:v>
                </c:pt>
                <c:pt idx="6">
                  <c:v>112.39566705957782</c:v>
                </c:pt>
                <c:pt idx="7">
                  <c:v>116.48021963184989</c:v>
                </c:pt>
                <c:pt idx="8">
                  <c:v>116.0374243699525</c:v>
                </c:pt>
                <c:pt idx="9">
                  <c:v>119.12689200040163</c:v>
                </c:pt>
                <c:pt idx="10">
                  <c:v>119.13459157757534</c:v>
                </c:pt>
                <c:pt idx="11">
                  <c:v>120.06475169443493</c:v>
                </c:pt>
                <c:pt idx="12">
                  <c:v>121.08982014936514</c:v>
                </c:pt>
                <c:pt idx="13">
                  <c:v>121.79031299735159</c:v>
                </c:pt>
                <c:pt idx="14">
                  <c:v>123.42383146856008</c:v>
                </c:pt>
                <c:pt idx="15">
                  <c:v>125.75872753857897</c:v>
                </c:pt>
                <c:pt idx="16">
                  <c:v>126.92350030916757</c:v>
                </c:pt>
                <c:pt idx="17">
                  <c:v>128.4868403513205</c:v>
                </c:pt>
                <c:pt idx="18">
                  <c:v>128.29441064982021</c:v>
                </c:pt>
                <c:pt idx="19">
                  <c:v>129.6972709199292</c:v>
                </c:pt>
                <c:pt idx="20">
                  <c:v>134.71289668260061</c:v>
                </c:pt>
                <c:pt idx="21">
                  <c:v>132.8898099991318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8939-49CE-A12C-24436756E128}"/>
            </c:ext>
          </c:extLst>
        </c:ser>
        <c:ser>
          <c:idx val="5"/>
          <c:order val="5"/>
          <c:tx>
            <c:strRef>
              <c:f>' Calculations'!$BV$3</c:f>
              <c:strCache>
                <c:ptCount val="1"/>
                <c:pt idx="0">
                  <c:v>0.01 µM Dantrolene Na Salt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star"/>
            <c:size val="4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 Calculations'!$BV$29:$BV$50</c:f>
                <c:numCache>
                  <c:formatCode>General</c:formatCode>
                  <c:ptCount val="22"/>
                  <c:pt idx="0">
                    <c:v>0.83817216336578848</c:v>
                  </c:pt>
                  <c:pt idx="1">
                    <c:v>0.42661009979446829</c:v>
                  </c:pt>
                  <c:pt idx="2">
                    <c:v>0.59535116593434945</c:v>
                  </c:pt>
                  <c:pt idx="3">
                    <c:v>0.94421031106082176</c:v>
                  </c:pt>
                  <c:pt idx="4">
                    <c:v>0.32903642852738996</c:v>
                  </c:pt>
                  <c:pt idx="5">
                    <c:v>1.4932070441234457</c:v>
                  </c:pt>
                  <c:pt idx="6">
                    <c:v>0.67739718581885489</c:v>
                  </c:pt>
                  <c:pt idx="7">
                    <c:v>0.7428771601749028</c:v>
                  </c:pt>
                  <c:pt idx="8">
                    <c:v>0.72802723280340675</c:v>
                  </c:pt>
                  <c:pt idx="9">
                    <c:v>0.6497798932547707</c:v>
                  </c:pt>
                  <c:pt idx="10">
                    <c:v>1.8704672933048676</c:v>
                  </c:pt>
                  <c:pt idx="11">
                    <c:v>0.66027245235457399</c:v>
                  </c:pt>
                  <c:pt idx="12">
                    <c:v>0.49118688802200572</c:v>
                  </c:pt>
                  <c:pt idx="13">
                    <c:v>1.1372939008551304</c:v>
                  </c:pt>
                  <c:pt idx="14">
                    <c:v>0.84813737317543203</c:v>
                  </c:pt>
                  <c:pt idx="15">
                    <c:v>1.2547197296893946</c:v>
                  </c:pt>
                  <c:pt idx="16">
                    <c:v>1.1041299350078346</c:v>
                  </c:pt>
                  <c:pt idx="17">
                    <c:v>1.0186220119696745</c:v>
                  </c:pt>
                  <c:pt idx="18">
                    <c:v>0.56205076331615744</c:v>
                  </c:pt>
                  <c:pt idx="19">
                    <c:v>0.89736868776503831</c:v>
                  </c:pt>
                  <c:pt idx="20">
                    <c:v>0.95407291072250189</c:v>
                  </c:pt>
                  <c:pt idx="21">
                    <c:v>1.1172374740001192</c:v>
                  </c:pt>
                </c:numCache>
              </c:numRef>
            </c:plus>
            <c:minus>
              <c:numRef>
                <c:f>' Calculations'!$BV$29:$BV$50</c:f>
                <c:numCache>
                  <c:formatCode>General</c:formatCode>
                  <c:ptCount val="22"/>
                  <c:pt idx="0">
                    <c:v>0.83817216336578848</c:v>
                  </c:pt>
                  <c:pt idx="1">
                    <c:v>0.42661009979446829</c:v>
                  </c:pt>
                  <c:pt idx="2">
                    <c:v>0.59535116593434945</c:v>
                  </c:pt>
                  <c:pt idx="3">
                    <c:v>0.94421031106082176</c:v>
                  </c:pt>
                  <c:pt idx="4">
                    <c:v>0.32903642852738996</c:v>
                  </c:pt>
                  <c:pt idx="5">
                    <c:v>1.4932070441234457</c:v>
                  </c:pt>
                  <c:pt idx="6">
                    <c:v>0.67739718581885489</c:v>
                  </c:pt>
                  <c:pt idx="7">
                    <c:v>0.7428771601749028</c:v>
                  </c:pt>
                  <c:pt idx="8">
                    <c:v>0.72802723280340675</c:v>
                  </c:pt>
                  <c:pt idx="9">
                    <c:v>0.6497798932547707</c:v>
                  </c:pt>
                  <c:pt idx="10">
                    <c:v>1.8704672933048676</c:v>
                  </c:pt>
                  <c:pt idx="11">
                    <c:v>0.66027245235457399</c:v>
                  </c:pt>
                  <c:pt idx="12">
                    <c:v>0.49118688802200572</c:v>
                  </c:pt>
                  <c:pt idx="13">
                    <c:v>1.1372939008551304</c:v>
                  </c:pt>
                  <c:pt idx="14">
                    <c:v>0.84813737317543203</c:v>
                  </c:pt>
                  <c:pt idx="15">
                    <c:v>1.2547197296893946</c:v>
                  </c:pt>
                  <c:pt idx="16">
                    <c:v>1.1041299350078346</c:v>
                  </c:pt>
                  <c:pt idx="17">
                    <c:v>1.0186220119696745</c:v>
                  </c:pt>
                  <c:pt idx="18">
                    <c:v>0.56205076331615744</c:v>
                  </c:pt>
                  <c:pt idx="19">
                    <c:v>0.89736868776503831</c:v>
                  </c:pt>
                  <c:pt idx="20">
                    <c:v>0.95407291072250189</c:v>
                  </c:pt>
                  <c:pt idx="21">
                    <c:v>1.1172374740001192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xVal>
            <c:numRef>
              <c:f>' Calculations'!$BP$4:$BP$25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8</c:v>
                </c:pt>
                <c:pt idx="10">
                  <c:v>20</c:v>
                </c:pt>
                <c:pt idx="11">
                  <c:v>22</c:v>
                </c:pt>
                <c:pt idx="12">
                  <c:v>24</c:v>
                </c:pt>
                <c:pt idx="13">
                  <c:v>26</c:v>
                </c:pt>
                <c:pt idx="14">
                  <c:v>28</c:v>
                </c:pt>
                <c:pt idx="15">
                  <c:v>30</c:v>
                </c:pt>
                <c:pt idx="16">
                  <c:v>32</c:v>
                </c:pt>
                <c:pt idx="17">
                  <c:v>34</c:v>
                </c:pt>
                <c:pt idx="18">
                  <c:v>36</c:v>
                </c:pt>
                <c:pt idx="19">
                  <c:v>38</c:v>
                </c:pt>
                <c:pt idx="20">
                  <c:v>40</c:v>
                </c:pt>
                <c:pt idx="21">
                  <c:v>42</c:v>
                </c:pt>
              </c:numCache>
            </c:numRef>
          </c:xVal>
          <c:yVal>
            <c:numRef>
              <c:f>' Calculations'!$BV$4:$BV$25</c:f>
              <c:numCache>
                <c:formatCode>General</c:formatCode>
                <c:ptCount val="22"/>
                <c:pt idx="0">
                  <c:v>99.695962078390565</c:v>
                </c:pt>
                <c:pt idx="1">
                  <c:v>100.55072810924557</c:v>
                </c:pt>
                <c:pt idx="2">
                  <c:v>100</c:v>
                </c:pt>
                <c:pt idx="3">
                  <c:v>105.51279634773685</c:v>
                </c:pt>
                <c:pt idx="4">
                  <c:v>107.98394673843185</c:v>
                </c:pt>
                <c:pt idx="5">
                  <c:v>109.34891193693039</c:v>
                </c:pt>
                <c:pt idx="6">
                  <c:v>113.89139932542263</c:v>
                </c:pt>
                <c:pt idx="7">
                  <c:v>113.18042124752368</c:v>
                </c:pt>
                <c:pt idx="8">
                  <c:v>115.28761362786473</c:v>
                </c:pt>
                <c:pt idx="9">
                  <c:v>119.01080123027728</c:v>
                </c:pt>
                <c:pt idx="10">
                  <c:v>117.94819400487154</c:v>
                </c:pt>
                <c:pt idx="11">
                  <c:v>122.50491720566517</c:v>
                </c:pt>
                <c:pt idx="12">
                  <c:v>123.12169606143819</c:v>
                </c:pt>
                <c:pt idx="13">
                  <c:v>123.27727569992079</c:v>
                </c:pt>
                <c:pt idx="14">
                  <c:v>126.47094143464157</c:v>
                </c:pt>
                <c:pt idx="15">
                  <c:v>123.80813056807791</c:v>
                </c:pt>
                <c:pt idx="16">
                  <c:v>126.04697019679404</c:v>
                </c:pt>
                <c:pt idx="17">
                  <c:v>127.53321858499656</c:v>
                </c:pt>
                <c:pt idx="18">
                  <c:v>131.05097816778112</c:v>
                </c:pt>
                <c:pt idx="19">
                  <c:v>132.69892190700571</c:v>
                </c:pt>
                <c:pt idx="20">
                  <c:v>132.65656884328905</c:v>
                </c:pt>
                <c:pt idx="21">
                  <c:v>128.146585931095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8939-49CE-A12C-24436756E1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843948032"/>
        <c:axId val="-850894224"/>
      </c:scatterChart>
      <c:valAx>
        <c:axId val="-843948032"/>
        <c:scaling>
          <c:orientation val="minMax"/>
          <c:max val="5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-850894224"/>
        <c:crosses val="autoZero"/>
        <c:crossBetween val="midCat"/>
        <c:majorUnit val="10"/>
      </c:valAx>
      <c:valAx>
        <c:axId val="-850894224"/>
        <c:scaling>
          <c:orientation val="minMax"/>
          <c:min val="9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BRET (% of basa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-84394803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822551839482856"/>
          <c:y val="0"/>
          <c:w val="0.60162132919974898"/>
          <c:h val="0.36247745602317505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068339" cy="355124"/>
          </a:xfrm>
          <a:prstGeom prst="rect">
            <a:avLst/>
          </a:prstGeom>
        </p:spPr>
        <p:txBody>
          <a:bodyPr vert="horz" lIns="94209" tIns="47105" rIns="94209" bIns="4710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317965" y="0"/>
            <a:ext cx="4068339" cy="355124"/>
          </a:xfrm>
          <a:prstGeom prst="rect">
            <a:avLst/>
          </a:prstGeom>
        </p:spPr>
        <p:txBody>
          <a:bodyPr vert="horz" lIns="94209" tIns="47105" rIns="94209" bIns="47105" rtlCol="0"/>
          <a:lstStyle>
            <a:lvl1pPr algn="r">
              <a:defRPr sz="1200"/>
            </a:lvl1pPr>
          </a:lstStyle>
          <a:p>
            <a:fld id="{DA48BD0B-A2E7-4C55-BB39-2DD18B10FA61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6746119"/>
            <a:ext cx="4068339" cy="355124"/>
          </a:xfrm>
          <a:prstGeom prst="rect">
            <a:avLst/>
          </a:prstGeom>
        </p:spPr>
        <p:txBody>
          <a:bodyPr vert="horz" lIns="94209" tIns="47105" rIns="94209" bIns="4710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317965" y="6746119"/>
            <a:ext cx="4068339" cy="355124"/>
          </a:xfrm>
          <a:prstGeom prst="rect">
            <a:avLst/>
          </a:prstGeom>
        </p:spPr>
        <p:txBody>
          <a:bodyPr vert="horz" lIns="94209" tIns="47105" rIns="94209" bIns="47105" rtlCol="0" anchor="b"/>
          <a:lstStyle>
            <a:lvl1pPr algn="r">
              <a:defRPr sz="1200"/>
            </a:lvl1pPr>
          </a:lstStyle>
          <a:p>
            <a:fld id="{60C34695-552A-4A55-9114-7D527A3E7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51289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068339" cy="355124"/>
          </a:xfrm>
          <a:prstGeom prst="rect">
            <a:avLst/>
          </a:prstGeom>
        </p:spPr>
        <p:txBody>
          <a:bodyPr vert="horz" lIns="94209" tIns="47105" rIns="94209" bIns="4710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317965" y="0"/>
            <a:ext cx="4068339" cy="355124"/>
          </a:xfrm>
          <a:prstGeom prst="rect">
            <a:avLst/>
          </a:prstGeom>
        </p:spPr>
        <p:txBody>
          <a:bodyPr vert="horz" lIns="94209" tIns="47105" rIns="94209" bIns="47105" rtlCol="0"/>
          <a:lstStyle>
            <a:lvl1pPr algn="r">
              <a:defRPr sz="1200"/>
            </a:lvl1pPr>
          </a:lstStyle>
          <a:p>
            <a:fld id="{1C2BD28A-40DF-4C71-B57B-414F38C2D330}" type="datetimeFigureOut">
              <a:rPr lang="en-US" smtClean="0"/>
              <a:t>11/2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695700" y="531813"/>
            <a:ext cx="1997075" cy="26638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09" tIns="47105" rIns="94209" bIns="4710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38848" y="3373676"/>
            <a:ext cx="7510780" cy="3196114"/>
          </a:xfrm>
          <a:prstGeom prst="rect">
            <a:avLst/>
          </a:prstGeom>
        </p:spPr>
        <p:txBody>
          <a:bodyPr vert="horz" lIns="94209" tIns="47105" rIns="94209" bIns="47105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746119"/>
            <a:ext cx="4068339" cy="355124"/>
          </a:xfrm>
          <a:prstGeom prst="rect">
            <a:avLst/>
          </a:prstGeom>
        </p:spPr>
        <p:txBody>
          <a:bodyPr vert="horz" lIns="94209" tIns="47105" rIns="94209" bIns="4710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317965" y="6746119"/>
            <a:ext cx="4068339" cy="355124"/>
          </a:xfrm>
          <a:prstGeom prst="rect">
            <a:avLst/>
          </a:prstGeom>
        </p:spPr>
        <p:txBody>
          <a:bodyPr vert="horz" lIns="94209" tIns="47105" rIns="94209" bIns="47105" rtlCol="0" anchor="b"/>
          <a:lstStyle>
            <a:lvl1pPr algn="r">
              <a:defRPr sz="1200"/>
            </a:lvl1pPr>
          </a:lstStyle>
          <a:p>
            <a:fld id="{87E754F7-8E5A-4B8E-8700-581DA44D22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1238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18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092" algn="l" defTabSz="91418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186" algn="l" defTabSz="91418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279" algn="l" defTabSz="91418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373" algn="l" defTabSz="91418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466" algn="l" defTabSz="91418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558" algn="l" defTabSz="91418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652" algn="l" defTabSz="91418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744" algn="l" defTabSz="914186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0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1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2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3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4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5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6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7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54D0D-EA86-44C1-A668-1B2D3C74DF76}" type="datetime1">
              <a:rPr lang="en-US" smtClean="0"/>
              <a:t>1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2266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C885A4-6C7C-453D-B521-0DAD0AB0E5FD}" type="datetime1">
              <a:rPr lang="en-US" smtClean="0"/>
              <a:t>1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722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4C7C2-7E53-45DE-A304-249BC69647AB}" type="datetime1">
              <a:rPr lang="en-US" smtClean="0"/>
              <a:t>1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855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2ECC95-260B-4DB6-B0E1-B86E688C3388}" type="datetime1">
              <a:rPr lang="en-US" smtClean="0"/>
              <a:t>1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532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09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18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27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37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4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55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65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74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2E73F-D53A-4236-A2DA-A9B41F9FDA26}" type="datetime1">
              <a:rPr lang="en-US" smtClean="0"/>
              <a:t>1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0053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3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3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4A6603-0DEA-4575-99E7-D69C92FAEC0D}" type="datetime1">
              <a:rPr lang="en-US" smtClean="0"/>
              <a:t>11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8119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92" indent="0">
              <a:buNone/>
              <a:defRPr sz="2000" b="1"/>
            </a:lvl2pPr>
            <a:lvl3pPr marL="914186" indent="0">
              <a:buNone/>
              <a:defRPr sz="1800" b="1"/>
            </a:lvl3pPr>
            <a:lvl4pPr marL="1371279" indent="0">
              <a:buNone/>
              <a:defRPr sz="1600" b="1"/>
            </a:lvl4pPr>
            <a:lvl5pPr marL="1828373" indent="0">
              <a:buNone/>
              <a:defRPr sz="1600" b="1"/>
            </a:lvl5pPr>
            <a:lvl6pPr marL="2285466" indent="0">
              <a:buNone/>
              <a:defRPr sz="1600" b="1"/>
            </a:lvl6pPr>
            <a:lvl7pPr marL="2742558" indent="0">
              <a:buNone/>
              <a:defRPr sz="1600" b="1"/>
            </a:lvl7pPr>
            <a:lvl8pPr marL="3199652" indent="0">
              <a:buNone/>
              <a:defRPr sz="1600" b="1"/>
            </a:lvl8pPr>
            <a:lvl9pPr marL="365674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92" indent="0">
              <a:buNone/>
              <a:defRPr sz="2000" b="1"/>
            </a:lvl2pPr>
            <a:lvl3pPr marL="914186" indent="0">
              <a:buNone/>
              <a:defRPr sz="1800" b="1"/>
            </a:lvl3pPr>
            <a:lvl4pPr marL="1371279" indent="0">
              <a:buNone/>
              <a:defRPr sz="1600" b="1"/>
            </a:lvl4pPr>
            <a:lvl5pPr marL="1828373" indent="0">
              <a:buNone/>
              <a:defRPr sz="1600" b="1"/>
            </a:lvl5pPr>
            <a:lvl6pPr marL="2285466" indent="0">
              <a:buNone/>
              <a:defRPr sz="1600" b="1"/>
            </a:lvl6pPr>
            <a:lvl7pPr marL="2742558" indent="0">
              <a:buNone/>
              <a:defRPr sz="1600" b="1"/>
            </a:lvl7pPr>
            <a:lvl8pPr marL="3199652" indent="0">
              <a:buNone/>
              <a:defRPr sz="1600" b="1"/>
            </a:lvl8pPr>
            <a:lvl9pPr marL="365674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76395-8F11-4A4D-AA14-D2755DB1C661}" type="datetime1">
              <a:rPr lang="en-US" smtClean="0"/>
              <a:t>11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768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D63E97-9D3B-4B31-BD7A-E3C03EFD26FD}" type="datetime1">
              <a:rPr lang="en-US" smtClean="0"/>
              <a:t>11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282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40B100-20D1-4120-A5CF-5CFC1D0C4441}" type="datetime1">
              <a:rPr lang="en-US" smtClean="0"/>
              <a:t>11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651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092" indent="0">
              <a:buNone/>
              <a:defRPr sz="1200"/>
            </a:lvl2pPr>
            <a:lvl3pPr marL="914186" indent="0">
              <a:buNone/>
              <a:defRPr sz="1000"/>
            </a:lvl3pPr>
            <a:lvl4pPr marL="1371279" indent="0">
              <a:buNone/>
              <a:defRPr sz="900"/>
            </a:lvl4pPr>
            <a:lvl5pPr marL="1828373" indent="0">
              <a:buNone/>
              <a:defRPr sz="900"/>
            </a:lvl5pPr>
            <a:lvl6pPr marL="2285466" indent="0">
              <a:buNone/>
              <a:defRPr sz="900"/>
            </a:lvl6pPr>
            <a:lvl7pPr marL="2742558" indent="0">
              <a:buNone/>
              <a:defRPr sz="900"/>
            </a:lvl7pPr>
            <a:lvl8pPr marL="3199652" indent="0">
              <a:buNone/>
              <a:defRPr sz="900"/>
            </a:lvl8pPr>
            <a:lvl9pPr marL="3656744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C5354-A562-445C-8EAA-9C754A67F484}" type="datetime1">
              <a:rPr lang="en-US" smtClean="0"/>
              <a:t>11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038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092" indent="0">
              <a:buNone/>
              <a:defRPr sz="2800"/>
            </a:lvl2pPr>
            <a:lvl3pPr marL="914186" indent="0">
              <a:buNone/>
              <a:defRPr sz="2400"/>
            </a:lvl3pPr>
            <a:lvl4pPr marL="1371279" indent="0">
              <a:buNone/>
              <a:defRPr sz="2000"/>
            </a:lvl4pPr>
            <a:lvl5pPr marL="1828373" indent="0">
              <a:buNone/>
              <a:defRPr sz="2000"/>
            </a:lvl5pPr>
            <a:lvl6pPr marL="2285466" indent="0">
              <a:buNone/>
              <a:defRPr sz="2000"/>
            </a:lvl6pPr>
            <a:lvl7pPr marL="2742558" indent="0">
              <a:buNone/>
              <a:defRPr sz="2000"/>
            </a:lvl7pPr>
            <a:lvl8pPr marL="3199652" indent="0">
              <a:buNone/>
              <a:defRPr sz="2000"/>
            </a:lvl8pPr>
            <a:lvl9pPr marL="3656744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092" indent="0">
              <a:buNone/>
              <a:defRPr sz="1200"/>
            </a:lvl2pPr>
            <a:lvl3pPr marL="914186" indent="0">
              <a:buNone/>
              <a:defRPr sz="1000"/>
            </a:lvl3pPr>
            <a:lvl4pPr marL="1371279" indent="0">
              <a:buNone/>
              <a:defRPr sz="900"/>
            </a:lvl4pPr>
            <a:lvl5pPr marL="1828373" indent="0">
              <a:buNone/>
              <a:defRPr sz="900"/>
            </a:lvl5pPr>
            <a:lvl6pPr marL="2285466" indent="0">
              <a:buNone/>
              <a:defRPr sz="900"/>
            </a:lvl6pPr>
            <a:lvl7pPr marL="2742558" indent="0">
              <a:buNone/>
              <a:defRPr sz="900"/>
            </a:lvl7pPr>
            <a:lvl8pPr marL="3199652" indent="0">
              <a:buNone/>
              <a:defRPr sz="900"/>
            </a:lvl8pPr>
            <a:lvl9pPr marL="3656744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4773F6-BC68-4E04-8DAA-712D79CE07B9}" type="datetime1">
              <a:rPr lang="en-US" smtClean="0"/>
              <a:t>11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7844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18" tIns="45709" rIns="91418" bIns="45709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3"/>
            <a:ext cx="6172200" cy="6034617"/>
          </a:xfrm>
          <a:prstGeom prst="rect">
            <a:avLst/>
          </a:prstGeom>
        </p:spPr>
        <p:txBody>
          <a:bodyPr vert="horz" lIns="91418" tIns="45709" rIns="91418" bIns="45709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18" tIns="45709" rIns="91418" bIns="45709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606B1D-7F6E-4833-8199-673510514C5C}" type="datetime1">
              <a:rPr lang="en-US" smtClean="0"/>
              <a:t>1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18" tIns="45709" rIns="91418" bIns="45709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18" tIns="45709" rIns="91418" bIns="45709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816EA-04CD-4309-B6E8-DBA0A084E7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56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186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20" indent="-342820" algn="l" defTabSz="914186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776" indent="-285684" algn="l" defTabSz="914186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733" indent="-228546" algn="l" defTabSz="914186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825" indent="-228546" algn="l" defTabSz="914186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6919" indent="-228546" algn="l" defTabSz="914186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012" indent="-228546" algn="l" defTabSz="91418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106" indent="-228546" algn="l" defTabSz="91418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198" indent="-228546" algn="l" defTabSz="91418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292" indent="-228546" algn="l" defTabSz="914186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18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092" algn="l" defTabSz="91418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186" algn="l" defTabSz="91418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279" algn="l" defTabSz="91418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373" algn="l" defTabSz="91418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466" algn="l" defTabSz="91418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558" algn="l" defTabSz="91418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652" algn="l" defTabSz="91418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744" algn="l" defTabSz="91418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1</a:t>
            </a:fld>
            <a:endParaRPr lang="en-US"/>
          </a:p>
        </p:txBody>
      </p:sp>
      <p:graphicFrame>
        <p:nvGraphicFramePr>
          <p:cNvPr id="4" name="Chart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9530965"/>
              </p:ext>
            </p:extLst>
          </p:nvPr>
        </p:nvGraphicFramePr>
        <p:xfrm>
          <a:off x="277823" y="337388"/>
          <a:ext cx="2973463" cy="2658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57568021"/>
              </p:ext>
            </p:extLst>
          </p:nvPr>
        </p:nvGraphicFramePr>
        <p:xfrm>
          <a:off x="3276755" y="433140"/>
          <a:ext cx="2800636" cy="2524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0" y="0"/>
            <a:ext cx="1847962" cy="307754"/>
          </a:xfrm>
          <a:prstGeom prst="rect">
            <a:avLst/>
          </a:prstGeom>
          <a:noFill/>
        </p:spPr>
        <p:txBody>
          <a:bodyPr wrap="none" lIns="91418" tIns="45709" rIns="91418" bIns="45709" rtlCol="0">
            <a:spAutoFit/>
          </a:bodyPr>
          <a:lstStyle/>
          <a:p>
            <a:r>
              <a:rPr lang="en-US" sz="1400" b="1" dirty="0" smtClean="0">
                <a:cs typeface="Arial" panose="020B0604020202020204" pitchFamily="34" charset="0"/>
              </a:rPr>
              <a:t>Supplemental Figure 1</a:t>
            </a:r>
            <a:endParaRPr lang="en-US" sz="1400" b="1" dirty="0"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491746" y="3811072"/>
            <a:ext cx="5814060" cy="9002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 smtClean="0">
                <a:solidFill>
                  <a:srgbClr val="231F20"/>
                </a:solidFill>
                <a:latin typeface="AdvOT678fd422"/>
              </a:rPr>
              <a:t>Supplemental Figure 1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: PDE inhibitors do not stimulate RESPYR activity or inhibit pyruvate-mediated respiration. </a:t>
            </a:r>
            <a:r>
              <a:rPr lang="en-US" sz="1050" dirty="0">
                <a:solidFill>
                  <a:srgbClr val="231F20"/>
                </a:solidFill>
                <a:latin typeface="AdvOT678fd422"/>
              </a:rPr>
              <a:t>(A) 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BRET </a:t>
            </a:r>
            <a:r>
              <a:rPr lang="en-US" sz="1050" dirty="0">
                <a:solidFill>
                  <a:srgbClr val="231F20"/>
                </a:solidFill>
                <a:latin typeface="AdvOT678fd422"/>
              </a:rPr>
              <a:t>kinetics of HEK-293 cells expressing RLuc8 fused to MPC2 and Venus yellow fluorescent protein fused to MPC1. 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Cells were </a:t>
            </a:r>
            <a:r>
              <a:rPr lang="en-US" sz="1050" dirty="0">
                <a:solidFill>
                  <a:srgbClr val="231F20"/>
                </a:solidFill>
                <a:latin typeface="AdvOT678fd422"/>
              </a:rPr>
              <a:t>stimulated after 5 minutes with vehicle (</a:t>
            </a:r>
            <a:r>
              <a:rPr lang="en-US" sz="1050" dirty="0" err="1" smtClean="0">
                <a:solidFill>
                  <a:srgbClr val="231F20"/>
                </a:solidFill>
                <a:latin typeface="AdvOT678fd422"/>
              </a:rPr>
              <a:t>dimethylsulfoxide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) or the indicated concentrations of PDE inhibitors. (B</a:t>
            </a:r>
            <a:r>
              <a:rPr lang="en-US" sz="1050" dirty="0">
                <a:solidFill>
                  <a:srgbClr val="231F20"/>
                </a:solidFill>
                <a:latin typeface="AdvOT678fd422"/>
              </a:rPr>
              <a:t>) Pyruvate-stimulated mitochondrial respiration with increasing doses of 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the indicated compounds. </a:t>
            </a:r>
            <a:endParaRPr lang="en-US" sz="1050" dirty="0"/>
          </a:p>
        </p:txBody>
      </p:sp>
      <p:sp>
        <p:nvSpPr>
          <p:cNvPr id="7" name="TextBox 6"/>
          <p:cNvSpPr txBox="1"/>
          <p:nvPr/>
        </p:nvSpPr>
        <p:spPr>
          <a:xfrm>
            <a:off x="198120" y="293776"/>
            <a:ext cx="293626" cy="307754"/>
          </a:xfrm>
          <a:prstGeom prst="rect">
            <a:avLst/>
          </a:prstGeom>
          <a:noFill/>
        </p:spPr>
        <p:txBody>
          <a:bodyPr wrap="none" lIns="91418" tIns="45709" rIns="91418" bIns="45709" rtlCol="0">
            <a:spAutoFit/>
          </a:bodyPr>
          <a:lstStyle/>
          <a:p>
            <a:r>
              <a:rPr lang="en-US" sz="1400" b="1" dirty="0" smtClean="0">
                <a:cs typeface="Arial" panose="020B0604020202020204" pitchFamily="34" charset="0"/>
              </a:rPr>
              <a:t>A</a:t>
            </a:r>
            <a:endParaRPr lang="en-US" sz="1400" b="1" dirty="0"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76755" y="328703"/>
            <a:ext cx="293626" cy="307754"/>
          </a:xfrm>
          <a:prstGeom prst="rect">
            <a:avLst/>
          </a:prstGeom>
          <a:noFill/>
        </p:spPr>
        <p:txBody>
          <a:bodyPr wrap="none" lIns="91418" tIns="45709" rIns="91418" bIns="45709" rtlCol="0">
            <a:spAutoFit/>
          </a:bodyPr>
          <a:lstStyle/>
          <a:p>
            <a:r>
              <a:rPr lang="en-US" sz="1400" b="1" dirty="0" smtClean="0">
                <a:cs typeface="Arial" panose="020B0604020202020204" pitchFamily="34" charset="0"/>
              </a:rPr>
              <a:t>B</a:t>
            </a:r>
            <a:endParaRPr lang="en-US" sz="1400" b="1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11449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2</a:t>
            </a:fld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0" y="0"/>
            <a:ext cx="1847962" cy="307754"/>
          </a:xfrm>
          <a:prstGeom prst="rect">
            <a:avLst/>
          </a:prstGeom>
          <a:noFill/>
        </p:spPr>
        <p:txBody>
          <a:bodyPr wrap="none" lIns="91418" tIns="45709" rIns="91418" bIns="45709" rtlCol="0">
            <a:spAutoFit/>
          </a:bodyPr>
          <a:lstStyle/>
          <a:p>
            <a:r>
              <a:rPr lang="en-US" sz="1400" b="1" dirty="0" smtClean="0">
                <a:cs typeface="Arial" panose="020B0604020202020204" pitchFamily="34" charset="0"/>
              </a:rPr>
              <a:t>Supplemental Figure 2</a:t>
            </a:r>
            <a:endParaRPr lang="en-US" sz="1400" b="1" dirty="0">
              <a:cs typeface="Arial" panose="020B0604020202020204" pitchFamily="34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7148461"/>
              </p:ext>
            </p:extLst>
          </p:nvPr>
        </p:nvGraphicFramePr>
        <p:xfrm>
          <a:off x="68263" y="1036638"/>
          <a:ext cx="6661150" cy="5529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9" r:id="rId3" imgW="9053092" imgH="7518216" progId="Prism9.Document">
                  <p:embed/>
                </p:oleObj>
              </mc:Choice>
              <mc:Fallback>
                <p:oleObj name="Prism 9" r:id="rId3" imgW="9053092" imgH="751821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8263" y="1036638"/>
                        <a:ext cx="6661150" cy="5529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8263" y="1036638"/>
            <a:ext cx="293626" cy="307754"/>
          </a:xfrm>
          <a:prstGeom prst="rect">
            <a:avLst/>
          </a:prstGeom>
          <a:noFill/>
        </p:spPr>
        <p:txBody>
          <a:bodyPr wrap="none" lIns="91418" tIns="45709" rIns="91418" bIns="45709" rtlCol="0">
            <a:spAutoFit/>
          </a:bodyPr>
          <a:lstStyle/>
          <a:p>
            <a:r>
              <a:rPr lang="en-US" sz="1400" b="1" dirty="0" smtClean="0">
                <a:cs typeface="Arial" panose="020B0604020202020204" pitchFamily="34" charset="0"/>
              </a:rPr>
              <a:t>A</a:t>
            </a:r>
            <a:endParaRPr lang="en-US" sz="1400" b="1" dirty="0"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8263" y="3422016"/>
            <a:ext cx="293626" cy="307754"/>
          </a:xfrm>
          <a:prstGeom prst="rect">
            <a:avLst/>
          </a:prstGeom>
          <a:noFill/>
        </p:spPr>
        <p:txBody>
          <a:bodyPr wrap="none" lIns="91418" tIns="45709" rIns="91418" bIns="45709" rtlCol="0">
            <a:spAutoFit/>
          </a:bodyPr>
          <a:lstStyle/>
          <a:p>
            <a:r>
              <a:rPr lang="en-US" sz="1400" b="1" dirty="0" smtClean="0">
                <a:cs typeface="Arial" panose="020B0604020202020204" pitchFamily="34" charset="0"/>
              </a:rPr>
              <a:t>B</a:t>
            </a:r>
            <a:endParaRPr lang="en-US" sz="1400" b="1" dirty="0"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194332" y="2001106"/>
            <a:ext cx="289877" cy="307754"/>
          </a:xfrm>
          <a:prstGeom prst="rect">
            <a:avLst/>
          </a:prstGeom>
          <a:noFill/>
        </p:spPr>
        <p:txBody>
          <a:bodyPr wrap="square" lIns="91418" tIns="45709" rIns="91418" bIns="45709" rtlCol="0">
            <a:spAutoFit/>
          </a:bodyPr>
          <a:lstStyle/>
          <a:p>
            <a:r>
              <a:rPr lang="en-US" sz="1400" b="1" dirty="0">
                <a:cs typeface="Arial" panose="020B0604020202020204" pitchFamily="34" charset="0"/>
              </a:rPr>
              <a:t>*</a:t>
            </a:r>
            <a:endParaRPr lang="en-US" sz="1400" b="1" dirty="0"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512365" y="1597246"/>
            <a:ext cx="289877" cy="307754"/>
          </a:xfrm>
          <a:prstGeom prst="rect">
            <a:avLst/>
          </a:prstGeom>
          <a:noFill/>
        </p:spPr>
        <p:txBody>
          <a:bodyPr wrap="square" lIns="91418" tIns="45709" rIns="91418" bIns="45709" rtlCol="0">
            <a:spAutoFit/>
          </a:bodyPr>
          <a:lstStyle/>
          <a:p>
            <a:r>
              <a:rPr lang="en-US" sz="1400" b="1" dirty="0">
                <a:cs typeface="Arial" panose="020B0604020202020204" pitchFamily="34" charset="0"/>
              </a:rPr>
              <a:t>*</a:t>
            </a:r>
            <a:endParaRPr lang="en-US" sz="1400" b="1" dirty="0"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832722" y="1448974"/>
            <a:ext cx="289877" cy="307754"/>
          </a:xfrm>
          <a:prstGeom prst="rect">
            <a:avLst/>
          </a:prstGeom>
          <a:noFill/>
        </p:spPr>
        <p:txBody>
          <a:bodyPr wrap="square" lIns="91418" tIns="45709" rIns="91418" bIns="45709" rtlCol="0">
            <a:spAutoFit/>
          </a:bodyPr>
          <a:lstStyle/>
          <a:p>
            <a:r>
              <a:rPr lang="en-US" sz="1400" b="1" dirty="0">
                <a:cs typeface="Arial" panose="020B0604020202020204" pitchFamily="34" charset="0"/>
              </a:rPr>
              <a:t>*</a:t>
            </a:r>
            <a:endParaRPr lang="en-US" sz="1400" b="1" dirty="0">
              <a:cs typeface="Arial" panose="020B060402020202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361889" y="7073797"/>
            <a:ext cx="5814060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 smtClean="0">
                <a:solidFill>
                  <a:srgbClr val="231F20"/>
                </a:solidFill>
                <a:latin typeface="AdvOT678fd422"/>
              </a:rPr>
              <a:t>Supplemental Figure 2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: MPC inhibitors increase lactate release by hepatocytes but do not affect expression of genes encoding gluconeogenic or lipogenic enzymes in DIO mice. (A)  </a:t>
            </a:r>
            <a:r>
              <a:rPr lang="en-US" sz="1050" dirty="0">
                <a:solidFill>
                  <a:srgbClr val="231F20"/>
                </a:solidFill>
                <a:latin typeface="AdvOT678fd422"/>
              </a:rPr>
              <a:t>Total 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lactate pool size in media of hepatocytes treated with the indicated compounds as </a:t>
            </a:r>
            <a:r>
              <a:rPr lang="en-US" sz="1050" dirty="0">
                <a:solidFill>
                  <a:srgbClr val="231F20"/>
                </a:solidFill>
                <a:latin typeface="AdvOT678fd422"/>
              </a:rPr>
              <a:t>measured by mass spectrometry after three hours. Data presented as mean + standard error of the mean. 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n=3 *p&lt;0.05 versus vehicle control. (B) The expression of the indicated genes in DIO mice treated for 3 days with the indicated drugs is shown. n=5 mice per group.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6608232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9816EA-04CD-4309-B6E8-DBA0A084E7D1}" type="slidenum">
              <a:rPr lang="en-US" smtClean="0"/>
              <a:t>3</a:t>
            </a:fld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0" y="0"/>
            <a:ext cx="1847962" cy="307754"/>
          </a:xfrm>
          <a:prstGeom prst="rect">
            <a:avLst/>
          </a:prstGeom>
          <a:noFill/>
        </p:spPr>
        <p:txBody>
          <a:bodyPr wrap="none" lIns="91418" tIns="45709" rIns="91418" bIns="45709" rtlCol="0">
            <a:spAutoFit/>
          </a:bodyPr>
          <a:lstStyle/>
          <a:p>
            <a:r>
              <a:rPr lang="en-US" sz="1400" b="1" dirty="0" smtClean="0">
                <a:cs typeface="Arial" panose="020B0604020202020204" pitchFamily="34" charset="0"/>
              </a:rPr>
              <a:t>Supplemental Figure 3</a:t>
            </a:r>
            <a:endParaRPr lang="en-US" sz="1400" b="1" dirty="0">
              <a:cs typeface="Arial" panose="020B0604020202020204" pitchFamily="34" charset="0"/>
            </a:endParaRPr>
          </a:p>
        </p:txBody>
      </p:sp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8316684"/>
              </p:ext>
            </p:extLst>
          </p:nvPr>
        </p:nvGraphicFramePr>
        <p:xfrm>
          <a:off x="736601" y="391327"/>
          <a:ext cx="5113866" cy="22069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123789"/>
              </p:ext>
            </p:extLst>
          </p:nvPr>
        </p:nvGraphicFramePr>
        <p:xfrm>
          <a:off x="736601" y="5190069"/>
          <a:ext cx="5113865" cy="22069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366869"/>
              </p:ext>
            </p:extLst>
          </p:nvPr>
        </p:nvGraphicFramePr>
        <p:xfrm>
          <a:off x="736601" y="2667766"/>
          <a:ext cx="5113866" cy="22069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Rectangle 6"/>
          <p:cNvSpPr/>
          <p:nvPr/>
        </p:nvSpPr>
        <p:spPr>
          <a:xfrm>
            <a:off x="386503" y="7818304"/>
            <a:ext cx="581406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 smtClean="0">
                <a:solidFill>
                  <a:srgbClr val="231F20"/>
                </a:solidFill>
                <a:latin typeface="AdvOT678fd422"/>
              </a:rPr>
              <a:t>Supplemental Figure 3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: Validation of high throughput screen hits. BRET </a:t>
            </a:r>
            <a:r>
              <a:rPr lang="en-US" sz="1050" dirty="0">
                <a:solidFill>
                  <a:srgbClr val="231F20"/>
                </a:solidFill>
                <a:latin typeface="AdvOT678fd422"/>
              </a:rPr>
              <a:t>kinetics of HEK-293 cells expressing RLuc8 fused to MPC2 and Venus yellow fluorescent protein fused to MPC1. 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Cells were </a:t>
            </a:r>
            <a:r>
              <a:rPr lang="en-US" sz="1050" dirty="0">
                <a:solidFill>
                  <a:srgbClr val="231F20"/>
                </a:solidFill>
                <a:latin typeface="AdvOT678fd422"/>
              </a:rPr>
              <a:t>stimulated after 5 minutes with vehicle (</a:t>
            </a:r>
            <a:r>
              <a:rPr lang="en-US" sz="1050" dirty="0" err="1" smtClean="0">
                <a:solidFill>
                  <a:srgbClr val="231F20"/>
                </a:solidFill>
                <a:latin typeface="AdvOT678fd422"/>
              </a:rPr>
              <a:t>dimethylsulfoxide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) or the indicated concentrations of the compounds thought to be MPC inhibitors. 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19035614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0" y="0"/>
            <a:ext cx="1847962" cy="307754"/>
          </a:xfrm>
          <a:prstGeom prst="rect">
            <a:avLst/>
          </a:prstGeom>
          <a:noFill/>
        </p:spPr>
        <p:txBody>
          <a:bodyPr wrap="none" lIns="91418" tIns="45709" rIns="91418" bIns="45709" rtlCol="0">
            <a:spAutoFit/>
          </a:bodyPr>
          <a:lstStyle/>
          <a:p>
            <a:r>
              <a:rPr lang="en-US" sz="1400" b="1" dirty="0" smtClean="0">
                <a:cs typeface="Arial" panose="020B0604020202020204" pitchFamily="34" charset="0"/>
              </a:rPr>
              <a:t>Supplemental Figure 4</a:t>
            </a:r>
            <a:endParaRPr lang="en-US" sz="1400" b="1" dirty="0">
              <a:cs typeface="Arial" panose="020B0604020202020204" pitchFamily="34" charset="0"/>
            </a:endParaRPr>
          </a:p>
        </p:txBody>
      </p:sp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9187113"/>
              </p:ext>
            </p:extLst>
          </p:nvPr>
        </p:nvGraphicFramePr>
        <p:xfrm>
          <a:off x="386503" y="604934"/>
          <a:ext cx="3693044" cy="29156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8503719"/>
              </p:ext>
            </p:extLst>
          </p:nvPr>
        </p:nvGraphicFramePr>
        <p:xfrm>
          <a:off x="3359965" y="523050"/>
          <a:ext cx="4221903" cy="29975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5324768"/>
              </p:ext>
            </p:extLst>
          </p:nvPr>
        </p:nvGraphicFramePr>
        <p:xfrm>
          <a:off x="386503" y="3678682"/>
          <a:ext cx="3349474" cy="32669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Rectangle 5"/>
          <p:cNvSpPr/>
          <p:nvPr/>
        </p:nvSpPr>
        <p:spPr>
          <a:xfrm>
            <a:off x="386503" y="7818304"/>
            <a:ext cx="581406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 smtClean="0">
                <a:solidFill>
                  <a:srgbClr val="231F20"/>
                </a:solidFill>
                <a:latin typeface="AdvOT678fd422"/>
              </a:rPr>
              <a:t>Supplemental Figure 4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: Validation of high throughput screen hits. BRET </a:t>
            </a:r>
            <a:r>
              <a:rPr lang="en-US" sz="1050" dirty="0">
                <a:solidFill>
                  <a:srgbClr val="231F20"/>
                </a:solidFill>
                <a:latin typeface="AdvOT678fd422"/>
              </a:rPr>
              <a:t>kinetics of HEK-293 cells expressing RLuc8 fused to MPC2 and Venus yellow fluorescent protein fused to MPC1. 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Cells were </a:t>
            </a:r>
            <a:r>
              <a:rPr lang="en-US" sz="1050" dirty="0">
                <a:solidFill>
                  <a:srgbClr val="231F20"/>
                </a:solidFill>
                <a:latin typeface="AdvOT678fd422"/>
              </a:rPr>
              <a:t>stimulated after 5 minutes with vehicle (</a:t>
            </a:r>
            <a:r>
              <a:rPr lang="en-US" sz="1050" dirty="0" err="1" smtClean="0">
                <a:solidFill>
                  <a:srgbClr val="231F20"/>
                </a:solidFill>
                <a:latin typeface="AdvOT678fd422"/>
              </a:rPr>
              <a:t>dimethylsulfoxide</a:t>
            </a:r>
            <a:r>
              <a:rPr lang="en-US" sz="1050" dirty="0" smtClean="0">
                <a:solidFill>
                  <a:srgbClr val="231F20"/>
                </a:solidFill>
                <a:latin typeface="AdvOT678fd422"/>
              </a:rPr>
              <a:t>) or the indicated concentrations of the compounds thought to be MPC inhibitors. 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442432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86</TotalTime>
  <Words>364</Words>
  <Application>Microsoft Office PowerPoint</Application>
  <PresentationFormat>On-screen Show (4:3)</PresentationFormat>
  <Paragraphs>33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dvOT678fd422</vt:lpstr>
      <vt:lpstr>Arial</vt:lpstr>
      <vt:lpstr>Calibri</vt:lpstr>
      <vt:lpstr>Office Theme</vt:lpstr>
      <vt:lpstr>GraphPad Prism 9 Project</vt:lpstr>
      <vt:lpstr>PowerPoint Presentation</vt:lpstr>
      <vt:lpstr>PowerPoint Presentation</vt:lpstr>
      <vt:lpstr>PowerPoint Presentation</vt:lpstr>
      <vt:lpstr>PowerPoint Presentation</vt:lpstr>
    </vt:vector>
  </TitlesOfParts>
  <Company>Washington University Department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utkewi</dc:creator>
  <cp:lastModifiedBy>Finck, Brian</cp:lastModifiedBy>
  <cp:revision>552</cp:revision>
  <cp:lastPrinted>2021-08-02T22:39:41Z</cp:lastPrinted>
  <dcterms:created xsi:type="dcterms:W3CDTF">2017-06-07T19:47:17Z</dcterms:created>
  <dcterms:modified xsi:type="dcterms:W3CDTF">2021-11-23T19:13:31Z</dcterms:modified>
</cp:coreProperties>
</file>